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</p:sldIdLst>
  <p:sldSz cx="9144000" cy="6858000" type="screen4x3"/>
  <p:notesSz cx="6789738" cy="9929813"/>
  <p:defaultTextStyle>
    <a:defPPr>
      <a:defRPr lang="fr-FR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0" d="100"/>
          <a:sy n="120" d="100"/>
        </p:scale>
        <p:origin x="-112" y="-5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0CC959F-B8D9-40C0-A5EC-4DF3C1E3354E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8405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B23D96-8E4F-4ACB-9840-820B7CBC4C25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1931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FC02E1-DE26-4ACF-AED1-D770250E23C9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659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950568-E74C-40E1-B97C-40CEEA584CBC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9465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2C55B6-9D7A-46CD-94AB-A78BD9C0E2A3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45810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D9BDACF-DBAF-464C-8806-CDDD03859964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9363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9DFA13B-B321-43FC-A4F1-C9A10EBB4C96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11193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4A8555C-4CD5-4C3D-AF97-91193DF519D6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0770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3622B51-1DA2-459A-B832-79E23708DABD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957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DE2971-1F15-44D7-9901-894D0E1D62DB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4404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 smtClean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B8120D-E122-4120-9491-DB6E2CBDA70D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7427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 style du titr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6441B877-F49F-43D1-BD7E-A247F0E4ED9D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AutoShape 4"/>
          <p:cNvSpPr>
            <a:spLocks noChangeAspect="1" noChangeArrowheads="1" noTextEdit="1"/>
          </p:cNvSpPr>
          <p:nvPr/>
        </p:nvSpPr>
        <p:spPr bwMode="auto">
          <a:xfrm>
            <a:off x="2057400" y="2109936"/>
            <a:ext cx="4862513" cy="4251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" name="Rectangle 9"/>
          <p:cNvSpPr>
            <a:spLocks noChangeArrowheads="1"/>
          </p:cNvSpPr>
          <p:nvPr/>
        </p:nvSpPr>
        <p:spPr bwMode="auto">
          <a:xfrm>
            <a:off x="3971925" y="6237892"/>
            <a:ext cx="100778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/[ATP] (µM)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Line 10"/>
          <p:cNvSpPr>
            <a:spLocks noChangeShapeType="1"/>
          </p:cNvSpPr>
          <p:nvPr/>
        </p:nvSpPr>
        <p:spPr bwMode="auto">
          <a:xfrm>
            <a:off x="2160588" y="5789761"/>
            <a:ext cx="4494213" cy="0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3" name="Line 11"/>
          <p:cNvSpPr>
            <a:spLocks noChangeShapeType="1"/>
          </p:cNvSpPr>
          <p:nvPr/>
        </p:nvSpPr>
        <p:spPr bwMode="auto">
          <a:xfrm flipV="1">
            <a:off x="2160588" y="5789761"/>
            <a:ext cx="0" cy="46038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4" name="Line 12"/>
          <p:cNvSpPr>
            <a:spLocks noChangeShapeType="1"/>
          </p:cNvSpPr>
          <p:nvPr/>
        </p:nvSpPr>
        <p:spPr bwMode="auto">
          <a:xfrm flipV="1">
            <a:off x="2851150" y="5789761"/>
            <a:ext cx="0" cy="46038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5" name="Line 13"/>
          <p:cNvSpPr>
            <a:spLocks noChangeShapeType="1"/>
          </p:cNvSpPr>
          <p:nvPr/>
        </p:nvSpPr>
        <p:spPr bwMode="auto">
          <a:xfrm flipV="1">
            <a:off x="3543300" y="5789761"/>
            <a:ext cx="0" cy="46038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6" name="Line 14"/>
          <p:cNvSpPr>
            <a:spLocks noChangeShapeType="1"/>
          </p:cNvSpPr>
          <p:nvPr/>
        </p:nvSpPr>
        <p:spPr bwMode="auto">
          <a:xfrm flipV="1">
            <a:off x="4233863" y="5789761"/>
            <a:ext cx="0" cy="46038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7" name="Line 15"/>
          <p:cNvSpPr>
            <a:spLocks noChangeShapeType="1"/>
          </p:cNvSpPr>
          <p:nvPr/>
        </p:nvSpPr>
        <p:spPr bwMode="auto">
          <a:xfrm flipV="1">
            <a:off x="4926013" y="5789761"/>
            <a:ext cx="0" cy="46038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8" name="Line 16"/>
          <p:cNvSpPr>
            <a:spLocks noChangeShapeType="1"/>
          </p:cNvSpPr>
          <p:nvPr/>
        </p:nvSpPr>
        <p:spPr bwMode="auto">
          <a:xfrm flipV="1">
            <a:off x="5616575" y="5789761"/>
            <a:ext cx="0" cy="46038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9" name="Line 17"/>
          <p:cNvSpPr>
            <a:spLocks noChangeShapeType="1"/>
          </p:cNvSpPr>
          <p:nvPr/>
        </p:nvSpPr>
        <p:spPr bwMode="auto">
          <a:xfrm flipV="1">
            <a:off x="6308725" y="5789761"/>
            <a:ext cx="0" cy="46038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20" name="Rectangle 18"/>
          <p:cNvSpPr>
            <a:spLocks noChangeArrowheads="1"/>
          </p:cNvSpPr>
          <p:nvPr/>
        </p:nvSpPr>
        <p:spPr bwMode="auto">
          <a:xfrm>
            <a:off x="2103438" y="5930482"/>
            <a:ext cx="15963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-2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Rectangle 19"/>
          <p:cNvSpPr>
            <a:spLocks noChangeArrowheads="1"/>
          </p:cNvSpPr>
          <p:nvPr/>
        </p:nvSpPr>
        <p:spPr bwMode="auto">
          <a:xfrm>
            <a:off x="2795588" y="5930482"/>
            <a:ext cx="15963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-1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Rectangle 20"/>
          <p:cNvSpPr>
            <a:spLocks noChangeArrowheads="1"/>
          </p:cNvSpPr>
          <p:nvPr/>
        </p:nvSpPr>
        <p:spPr bwMode="auto">
          <a:xfrm>
            <a:off x="3508375" y="5930482"/>
            <a:ext cx="998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Rectangle 21"/>
          <p:cNvSpPr>
            <a:spLocks noChangeArrowheads="1"/>
          </p:cNvSpPr>
          <p:nvPr/>
        </p:nvSpPr>
        <p:spPr bwMode="auto">
          <a:xfrm>
            <a:off x="4200525" y="5930482"/>
            <a:ext cx="998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Rectangle 22"/>
          <p:cNvSpPr>
            <a:spLocks noChangeArrowheads="1"/>
          </p:cNvSpPr>
          <p:nvPr/>
        </p:nvSpPr>
        <p:spPr bwMode="auto">
          <a:xfrm>
            <a:off x="4891088" y="5930482"/>
            <a:ext cx="998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Rectangle 23"/>
          <p:cNvSpPr>
            <a:spLocks noChangeArrowheads="1"/>
          </p:cNvSpPr>
          <p:nvPr/>
        </p:nvSpPr>
        <p:spPr bwMode="auto">
          <a:xfrm>
            <a:off x="5583238" y="5930482"/>
            <a:ext cx="998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Rectangle 24"/>
          <p:cNvSpPr>
            <a:spLocks noChangeArrowheads="1"/>
          </p:cNvSpPr>
          <p:nvPr/>
        </p:nvSpPr>
        <p:spPr bwMode="auto">
          <a:xfrm>
            <a:off x="6273800" y="5930482"/>
            <a:ext cx="998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Rectangle 25"/>
          <p:cNvSpPr>
            <a:spLocks noChangeArrowheads="1"/>
          </p:cNvSpPr>
          <p:nvPr/>
        </p:nvSpPr>
        <p:spPr bwMode="auto">
          <a:xfrm rot="16200000">
            <a:off x="2326365" y="4356360"/>
            <a:ext cx="77810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/V(UA/s)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Line 26"/>
          <p:cNvSpPr>
            <a:spLocks noChangeShapeType="1"/>
          </p:cNvSpPr>
          <p:nvPr/>
        </p:nvSpPr>
        <p:spPr bwMode="auto">
          <a:xfrm flipV="1">
            <a:off x="3444875" y="2803674"/>
            <a:ext cx="0" cy="3244850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" name="Line 28"/>
          <p:cNvSpPr>
            <a:spLocks noChangeShapeType="1"/>
          </p:cNvSpPr>
          <p:nvPr/>
        </p:nvSpPr>
        <p:spPr bwMode="auto">
          <a:xfrm>
            <a:off x="3400425" y="5100786"/>
            <a:ext cx="44450" cy="0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1" name="Line 29"/>
          <p:cNvSpPr>
            <a:spLocks noChangeShapeType="1"/>
          </p:cNvSpPr>
          <p:nvPr/>
        </p:nvSpPr>
        <p:spPr bwMode="auto">
          <a:xfrm>
            <a:off x="3400425" y="4426099"/>
            <a:ext cx="44450" cy="0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72" name="Line 30"/>
          <p:cNvSpPr>
            <a:spLocks noChangeShapeType="1"/>
          </p:cNvSpPr>
          <p:nvPr/>
        </p:nvSpPr>
        <p:spPr bwMode="auto">
          <a:xfrm>
            <a:off x="3400425" y="3749824"/>
            <a:ext cx="44450" cy="0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73" name="Line 31"/>
          <p:cNvSpPr>
            <a:spLocks noChangeShapeType="1"/>
          </p:cNvSpPr>
          <p:nvPr/>
        </p:nvSpPr>
        <p:spPr bwMode="auto">
          <a:xfrm>
            <a:off x="3400425" y="3073549"/>
            <a:ext cx="44450" cy="0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75" name="Rectangle 32"/>
          <p:cNvSpPr>
            <a:spLocks noChangeArrowheads="1"/>
          </p:cNvSpPr>
          <p:nvPr/>
        </p:nvSpPr>
        <p:spPr bwMode="auto">
          <a:xfrm>
            <a:off x="3007740" y="5763946"/>
            <a:ext cx="3494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,00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76" name="Rectangle 33"/>
          <p:cNvSpPr>
            <a:spLocks noChangeArrowheads="1"/>
          </p:cNvSpPr>
          <p:nvPr/>
        </p:nvSpPr>
        <p:spPr bwMode="auto">
          <a:xfrm>
            <a:off x="3007740" y="4991815"/>
            <a:ext cx="3494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,05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77" name="Rectangle 34"/>
          <p:cNvSpPr>
            <a:spLocks noChangeArrowheads="1"/>
          </p:cNvSpPr>
          <p:nvPr/>
        </p:nvSpPr>
        <p:spPr bwMode="auto">
          <a:xfrm>
            <a:off x="3007740" y="4315540"/>
            <a:ext cx="3494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,10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78" name="Rectangle 35"/>
          <p:cNvSpPr>
            <a:spLocks noChangeArrowheads="1"/>
          </p:cNvSpPr>
          <p:nvPr/>
        </p:nvSpPr>
        <p:spPr bwMode="auto">
          <a:xfrm>
            <a:off x="3007740" y="3639265"/>
            <a:ext cx="3494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,15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79" name="Rectangle 36"/>
          <p:cNvSpPr>
            <a:spLocks noChangeArrowheads="1"/>
          </p:cNvSpPr>
          <p:nvPr/>
        </p:nvSpPr>
        <p:spPr bwMode="auto">
          <a:xfrm>
            <a:off x="3007740" y="2964578"/>
            <a:ext cx="3494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,20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80" name="Oval 37"/>
          <p:cNvSpPr>
            <a:spLocks noChangeArrowheads="1"/>
          </p:cNvSpPr>
          <p:nvPr/>
        </p:nvSpPr>
        <p:spPr bwMode="auto">
          <a:xfrm>
            <a:off x="6278563" y="5073799"/>
            <a:ext cx="60325" cy="60325"/>
          </a:xfrm>
          <a:prstGeom prst="ellipse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81" name="Oval 38"/>
          <p:cNvSpPr>
            <a:spLocks noChangeArrowheads="1"/>
          </p:cNvSpPr>
          <p:nvPr/>
        </p:nvSpPr>
        <p:spPr bwMode="auto">
          <a:xfrm>
            <a:off x="5487988" y="5113486"/>
            <a:ext cx="60325" cy="58738"/>
          </a:xfrm>
          <a:prstGeom prst="ellipse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82" name="Oval 39"/>
          <p:cNvSpPr>
            <a:spLocks noChangeArrowheads="1"/>
          </p:cNvSpPr>
          <p:nvPr/>
        </p:nvSpPr>
        <p:spPr bwMode="auto">
          <a:xfrm>
            <a:off x="4895850" y="5338911"/>
            <a:ext cx="60325" cy="60325"/>
          </a:xfrm>
          <a:prstGeom prst="ellipse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83" name="Oval 40"/>
          <p:cNvSpPr>
            <a:spLocks noChangeArrowheads="1"/>
          </p:cNvSpPr>
          <p:nvPr/>
        </p:nvSpPr>
        <p:spPr bwMode="auto">
          <a:xfrm>
            <a:off x="4433888" y="5375424"/>
            <a:ext cx="60325" cy="58738"/>
          </a:xfrm>
          <a:prstGeom prst="ellipse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84" name="Oval 41"/>
          <p:cNvSpPr>
            <a:spLocks noChangeArrowheads="1"/>
          </p:cNvSpPr>
          <p:nvPr/>
        </p:nvSpPr>
        <p:spPr bwMode="auto">
          <a:xfrm>
            <a:off x="4203700" y="5469086"/>
            <a:ext cx="60325" cy="58738"/>
          </a:xfrm>
          <a:prstGeom prst="ellipse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85" name="Rectangle 42"/>
          <p:cNvSpPr>
            <a:spLocks noChangeArrowheads="1"/>
          </p:cNvSpPr>
          <p:nvPr/>
        </p:nvSpPr>
        <p:spPr bwMode="auto">
          <a:xfrm>
            <a:off x="6283325" y="4910286"/>
            <a:ext cx="50800" cy="52388"/>
          </a:xfrm>
          <a:prstGeom prst="rect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86" name="Rectangle 43"/>
          <p:cNvSpPr>
            <a:spLocks noChangeArrowheads="1"/>
          </p:cNvSpPr>
          <p:nvPr/>
        </p:nvSpPr>
        <p:spPr bwMode="auto">
          <a:xfrm>
            <a:off x="5492750" y="4935686"/>
            <a:ext cx="50800" cy="50800"/>
          </a:xfrm>
          <a:prstGeom prst="rect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87" name="Rectangle 44"/>
          <p:cNvSpPr>
            <a:spLocks noChangeArrowheads="1"/>
          </p:cNvSpPr>
          <p:nvPr/>
        </p:nvSpPr>
        <p:spPr bwMode="auto">
          <a:xfrm>
            <a:off x="4900613" y="5116661"/>
            <a:ext cx="50800" cy="50800"/>
          </a:xfrm>
          <a:prstGeom prst="rect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88" name="Rectangle 45"/>
          <p:cNvSpPr>
            <a:spLocks noChangeArrowheads="1"/>
          </p:cNvSpPr>
          <p:nvPr/>
        </p:nvSpPr>
        <p:spPr bwMode="auto">
          <a:xfrm>
            <a:off x="4438650" y="5356374"/>
            <a:ext cx="50800" cy="50800"/>
          </a:xfrm>
          <a:prstGeom prst="rect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89" name="Rectangle 46"/>
          <p:cNvSpPr>
            <a:spLocks noChangeArrowheads="1"/>
          </p:cNvSpPr>
          <p:nvPr/>
        </p:nvSpPr>
        <p:spPr bwMode="auto">
          <a:xfrm>
            <a:off x="4208463" y="5392886"/>
            <a:ext cx="52388" cy="50800"/>
          </a:xfrm>
          <a:prstGeom prst="rect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90" name="Freeform 47"/>
          <p:cNvSpPr>
            <a:spLocks/>
          </p:cNvSpPr>
          <p:nvPr/>
        </p:nvSpPr>
        <p:spPr bwMode="auto">
          <a:xfrm>
            <a:off x="6278563" y="4246711"/>
            <a:ext cx="60325" cy="53975"/>
          </a:xfrm>
          <a:custGeom>
            <a:avLst/>
            <a:gdLst>
              <a:gd name="T0" fmla="*/ 19 w 38"/>
              <a:gd name="T1" fmla="*/ 0 h 34"/>
              <a:gd name="T2" fmla="*/ 38 w 38"/>
              <a:gd name="T3" fmla="*/ 34 h 34"/>
              <a:gd name="T4" fmla="*/ 0 w 38"/>
              <a:gd name="T5" fmla="*/ 34 h 34"/>
              <a:gd name="T6" fmla="*/ 19 w 38"/>
              <a:gd name="T7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8" h="34">
                <a:moveTo>
                  <a:pt x="19" y="0"/>
                </a:moveTo>
                <a:lnTo>
                  <a:pt x="38" y="34"/>
                </a:lnTo>
                <a:lnTo>
                  <a:pt x="0" y="34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91" name="Freeform 48"/>
          <p:cNvSpPr>
            <a:spLocks/>
          </p:cNvSpPr>
          <p:nvPr/>
        </p:nvSpPr>
        <p:spPr bwMode="auto">
          <a:xfrm>
            <a:off x="5487988" y="4173686"/>
            <a:ext cx="60325" cy="53975"/>
          </a:xfrm>
          <a:custGeom>
            <a:avLst/>
            <a:gdLst>
              <a:gd name="T0" fmla="*/ 19 w 38"/>
              <a:gd name="T1" fmla="*/ 0 h 34"/>
              <a:gd name="T2" fmla="*/ 38 w 38"/>
              <a:gd name="T3" fmla="*/ 34 h 34"/>
              <a:gd name="T4" fmla="*/ 0 w 38"/>
              <a:gd name="T5" fmla="*/ 34 h 34"/>
              <a:gd name="T6" fmla="*/ 19 w 38"/>
              <a:gd name="T7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8" h="34">
                <a:moveTo>
                  <a:pt x="19" y="0"/>
                </a:moveTo>
                <a:lnTo>
                  <a:pt x="38" y="34"/>
                </a:lnTo>
                <a:lnTo>
                  <a:pt x="0" y="34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92" name="Freeform 49"/>
          <p:cNvSpPr>
            <a:spLocks/>
          </p:cNvSpPr>
          <p:nvPr/>
        </p:nvSpPr>
        <p:spPr bwMode="auto">
          <a:xfrm>
            <a:off x="4895850" y="4762649"/>
            <a:ext cx="60325" cy="52388"/>
          </a:xfrm>
          <a:custGeom>
            <a:avLst/>
            <a:gdLst>
              <a:gd name="T0" fmla="*/ 19 w 38"/>
              <a:gd name="T1" fmla="*/ 0 h 33"/>
              <a:gd name="T2" fmla="*/ 38 w 38"/>
              <a:gd name="T3" fmla="*/ 33 h 33"/>
              <a:gd name="T4" fmla="*/ 0 w 38"/>
              <a:gd name="T5" fmla="*/ 33 h 33"/>
              <a:gd name="T6" fmla="*/ 19 w 38"/>
              <a:gd name="T7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8" h="33">
                <a:moveTo>
                  <a:pt x="19" y="0"/>
                </a:moveTo>
                <a:lnTo>
                  <a:pt x="38" y="33"/>
                </a:lnTo>
                <a:lnTo>
                  <a:pt x="0" y="33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93" name="Freeform 50"/>
          <p:cNvSpPr>
            <a:spLocks/>
          </p:cNvSpPr>
          <p:nvPr/>
        </p:nvSpPr>
        <p:spPr bwMode="auto">
          <a:xfrm>
            <a:off x="4433888" y="4908699"/>
            <a:ext cx="60325" cy="53975"/>
          </a:xfrm>
          <a:custGeom>
            <a:avLst/>
            <a:gdLst>
              <a:gd name="T0" fmla="*/ 19 w 38"/>
              <a:gd name="T1" fmla="*/ 0 h 34"/>
              <a:gd name="T2" fmla="*/ 38 w 38"/>
              <a:gd name="T3" fmla="*/ 34 h 34"/>
              <a:gd name="T4" fmla="*/ 0 w 38"/>
              <a:gd name="T5" fmla="*/ 34 h 34"/>
              <a:gd name="T6" fmla="*/ 19 w 38"/>
              <a:gd name="T7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8" h="34">
                <a:moveTo>
                  <a:pt x="19" y="0"/>
                </a:moveTo>
                <a:lnTo>
                  <a:pt x="38" y="34"/>
                </a:lnTo>
                <a:lnTo>
                  <a:pt x="0" y="34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94" name="Freeform 51"/>
          <p:cNvSpPr>
            <a:spLocks/>
          </p:cNvSpPr>
          <p:nvPr/>
        </p:nvSpPr>
        <p:spPr bwMode="auto">
          <a:xfrm>
            <a:off x="4203700" y="5088086"/>
            <a:ext cx="60325" cy="52388"/>
          </a:xfrm>
          <a:custGeom>
            <a:avLst/>
            <a:gdLst>
              <a:gd name="T0" fmla="*/ 19 w 38"/>
              <a:gd name="T1" fmla="*/ 0 h 33"/>
              <a:gd name="T2" fmla="*/ 38 w 38"/>
              <a:gd name="T3" fmla="*/ 33 h 33"/>
              <a:gd name="T4" fmla="*/ 0 w 38"/>
              <a:gd name="T5" fmla="*/ 33 h 33"/>
              <a:gd name="T6" fmla="*/ 19 w 38"/>
              <a:gd name="T7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8" h="33">
                <a:moveTo>
                  <a:pt x="19" y="0"/>
                </a:moveTo>
                <a:lnTo>
                  <a:pt x="38" y="33"/>
                </a:lnTo>
                <a:lnTo>
                  <a:pt x="0" y="33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95" name="Oval 52"/>
          <p:cNvSpPr>
            <a:spLocks noChangeArrowheads="1"/>
          </p:cNvSpPr>
          <p:nvPr/>
        </p:nvSpPr>
        <p:spPr bwMode="auto">
          <a:xfrm>
            <a:off x="6278563" y="3160861"/>
            <a:ext cx="60325" cy="60325"/>
          </a:xfrm>
          <a:prstGeom prst="ellipse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96" name="Oval 53"/>
          <p:cNvSpPr>
            <a:spLocks noChangeArrowheads="1"/>
          </p:cNvSpPr>
          <p:nvPr/>
        </p:nvSpPr>
        <p:spPr bwMode="auto">
          <a:xfrm>
            <a:off x="5487988" y="3302149"/>
            <a:ext cx="60325" cy="58738"/>
          </a:xfrm>
          <a:prstGeom prst="ellipse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97" name="Oval 54"/>
          <p:cNvSpPr>
            <a:spLocks noChangeArrowheads="1"/>
          </p:cNvSpPr>
          <p:nvPr/>
        </p:nvSpPr>
        <p:spPr bwMode="auto">
          <a:xfrm>
            <a:off x="4895850" y="3583136"/>
            <a:ext cx="60325" cy="58738"/>
          </a:xfrm>
          <a:prstGeom prst="ellipse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98" name="Oval 55"/>
          <p:cNvSpPr>
            <a:spLocks noChangeArrowheads="1"/>
          </p:cNvSpPr>
          <p:nvPr/>
        </p:nvSpPr>
        <p:spPr bwMode="auto">
          <a:xfrm>
            <a:off x="4203700" y="4664224"/>
            <a:ext cx="60325" cy="58738"/>
          </a:xfrm>
          <a:prstGeom prst="ellipse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99" name="Oval 56"/>
          <p:cNvSpPr>
            <a:spLocks noChangeArrowheads="1"/>
          </p:cNvSpPr>
          <p:nvPr/>
        </p:nvSpPr>
        <p:spPr bwMode="auto">
          <a:xfrm>
            <a:off x="3857625" y="4862661"/>
            <a:ext cx="60325" cy="60325"/>
          </a:xfrm>
          <a:prstGeom prst="ellipse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100" name="Freeform 57"/>
          <p:cNvSpPr>
            <a:spLocks/>
          </p:cNvSpPr>
          <p:nvPr/>
        </p:nvSpPr>
        <p:spPr bwMode="auto">
          <a:xfrm flipV="1">
            <a:off x="2160588" y="5000774"/>
            <a:ext cx="4479925" cy="879475"/>
          </a:xfrm>
          <a:custGeom>
            <a:avLst/>
            <a:gdLst>
              <a:gd name="T0" fmla="*/ 62 w 4906"/>
              <a:gd name="T1" fmla="*/ 12 h 961"/>
              <a:gd name="T2" fmla="*/ 144 w 4906"/>
              <a:gd name="T3" fmla="*/ 28 h 961"/>
              <a:gd name="T4" fmla="*/ 227 w 4906"/>
              <a:gd name="T5" fmla="*/ 45 h 961"/>
              <a:gd name="T6" fmla="*/ 310 w 4906"/>
              <a:gd name="T7" fmla="*/ 61 h 961"/>
              <a:gd name="T8" fmla="*/ 393 w 4906"/>
              <a:gd name="T9" fmla="*/ 77 h 961"/>
              <a:gd name="T10" fmla="*/ 476 w 4906"/>
              <a:gd name="T11" fmla="*/ 93 h 961"/>
              <a:gd name="T12" fmla="*/ 558 w 4906"/>
              <a:gd name="T13" fmla="*/ 110 h 961"/>
              <a:gd name="T14" fmla="*/ 641 w 4906"/>
              <a:gd name="T15" fmla="*/ 126 h 961"/>
              <a:gd name="T16" fmla="*/ 724 w 4906"/>
              <a:gd name="T17" fmla="*/ 142 h 961"/>
              <a:gd name="T18" fmla="*/ 807 w 4906"/>
              <a:gd name="T19" fmla="*/ 158 h 961"/>
              <a:gd name="T20" fmla="*/ 890 w 4906"/>
              <a:gd name="T21" fmla="*/ 174 h 961"/>
              <a:gd name="T22" fmla="*/ 972 w 4906"/>
              <a:gd name="T23" fmla="*/ 191 h 961"/>
              <a:gd name="T24" fmla="*/ 1055 w 4906"/>
              <a:gd name="T25" fmla="*/ 207 h 961"/>
              <a:gd name="T26" fmla="*/ 1138 w 4906"/>
              <a:gd name="T27" fmla="*/ 223 h 961"/>
              <a:gd name="T28" fmla="*/ 1221 w 4906"/>
              <a:gd name="T29" fmla="*/ 239 h 961"/>
              <a:gd name="T30" fmla="*/ 1304 w 4906"/>
              <a:gd name="T31" fmla="*/ 255 h 961"/>
              <a:gd name="T32" fmla="*/ 1386 w 4906"/>
              <a:gd name="T33" fmla="*/ 272 h 961"/>
              <a:gd name="T34" fmla="*/ 1469 w 4906"/>
              <a:gd name="T35" fmla="*/ 288 h 961"/>
              <a:gd name="T36" fmla="*/ 1552 w 4906"/>
              <a:gd name="T37" fmla="*/ 304 h 961"/>
              <a:gd name="T38" fmla="*/ 1635 w 4906"/>
              <a:gd name="T39" fmla="*/ 320 h 961"/>
              <a:gd name="T40" fmla="*/ 1718 w 4906"/>
              <a:gd name="T41" fmla="*/ 337 h 961"/>
              <a:gd name="T42" fmla="*/ 1801 w 4906"/>
              <a:gd name="T43" fmla="*/ 353 h 961"/>
              <a:gd name="T44" fmla="*/ 1883 w 4906"/>
              <a:gd name="T45" fmla="*/ 369 h 961"/>
              <a:gd name="T46" fmla="*/ 1966 w 4906"/>
              <a:gd name="T47" fmla="*/ 385 h 961"/>
              <a:gd name="T48" fmla="*/ 2049 w 4906"/>
              <a:gd name="T49" fmla="*/ 401 h 961"/>
              <a:gd name="T50" fmla="*/ 2132 w 4906"/>
              <a:gd name="T51" fmla="*/ 418 h 961"/>
              <a:gd name="T52" fmla="*/ 2215 w 4906"/>
              <a:gd name="T53" fmla="*/ 434 h 961"/>
              <a:gd name="T54" fmla="*/ 2297 w 4906"/>
              <a:gd name="T55" fmla="*/ 450 h 961"/>
              <a:gd name="T56" fmla="*/ 2380 w 4906"/>
              <a:gd name="T57" fmla="*/ 466 h 961"/>
              <a:gd name="T58" fmla="*/ 2463 w 4906"/>
              <a:gd name="T59" fmla="*/ 483 h 961"/>
              <a:gd name="T60" fmla="*/ 2546 w 4906"/>
              <a:gd name="T61" fmla="*/ 499 h 961"/>
              <a:gd name="T62" fmla="*/ 2629 w 4906"/>
              <a:gd name="T63" fmla="*/ 515 h 961"/>
              <a:gd name="T64" fmla="*/ 2711 w 4906"/>
              <a:gd name="T65" fmla="*/ 531 h 961"/>
              <a:gd name="T66" fmla="*/ 2794 w 4906"/>
              <a:gd name="T67" fmla="*/ 547 h 961"/>
              <a:gd name="T68" fmla="*/ 2877 w 4906"/>
              <a:gd name="T69" fmla="*/ 564 h 961"/>
              <a:gd name="T70" fmla="*/ 2960 w 4906"/>
              <a:gd name="T71" fmla="*/ 580 h 961"/>
              <a:gd name="T72" fmla="*/ 3043 w 4906"/>
              <a:gd name="T73" fmla="*/ 596 h 961"/>
              <a:gd name="T74" fmla="*/ 3125 w 4906"/>
              <a:gd name="T75" fmla="*/ 612 h 961"/>
              <a:gd name="T76" fmla="*/ 3208 w 4906"/>
              <a:gd name="T77" fmla="*/ 629 h 961"/>
              <a:gd name="T78" fmla="*/ 3291 w 4906"/>
              <a:gd name="T79" fmla="*/ 645 h 961"/>
              <a:gd name="T80" fmla="*/ 3374 w 4906"/>
              <a:gd name="T81" fmla="*/ 661 h 961"/>
              <a:gd name="T82" fmla="*/ 3457 w 4906"/>
              <a:gd name="T83" fmla="*/ 677 h 961"/>
              <a:gd name="T84" fmla="*/ 3539 w 4906"/>
              <a:gd name="T85" fmla="*/ 693 h 961"/>
              <a:gd name="T86" fmla="*/ 3622 w 4906"/>
              <a:gd name="T87" fmla="*/ 710 h 961"/>
              <a:gd name="T88" fmla="*/ 3705 w 4906"/>
              <a:gd name="T89" fmla="*/ 726 h 961"/>
              <a:gd name="T90" fmla="*/ 3788 w 4906"/>
              <a:gd name="T91" fmla="*/ 742 h 961"/>
              <a:gd name="T92" fmla="*/ 3871 w 4906"/>
              <a:gd name="T93" fmla="*/ 758 h 961"/>
              <a:gd name="T94" fmla="*/ 3953 w 4906"/>
              <a:gd name="T95" fmla="*/ 774 h 961"/>
              <a:gd name="T96" fmla="*/ 4036 w 4906"/>
              <a:gd name="T97" fmla="*/ 791 h 961"/>
              <a:gd name="T98" fmla="*/ 4119 w 4906"/>
              <a:gd name="T99" fmla="*/ 807 h 961"/>
              <a:gd name="T100" fmla="*/ 4202 w 4906"/>
              <a:gd name="T101" fmla="*/ 823 h 961"/>
              <a:gd name="T102" fmla="*/ 4285 w 4906"/>
              <a:gd name="T103" fmla="*/ 839 h 961"/>
              <a:gd name="T104" fmla="*/ 4367 w 4906"/>
              <a:gd name="T105" fmla="*/ 856 h 961"/>
              <a:gd name="T106" fmla="*/ 4450 w 4906"/>
              <a:gd name="T107" fmla="*/ 872 h 961"/>
              <a:gd name="T108" fmla="*/ 4533 w 4906"/>
              <a:gd name="T109" fmla="*/ 888 h 961"/>
              <a:gd name="T110" fmla="*/ 4616 w 4906"/>
              <a:gd name="T111" fmla="*/ 904 h 961"/>
              <a:gd name="T112" fmla="*/ 4699 w 4906"/>
              <a:gd name="T113" fmla="*/ 920 h 961"/>
              <a:gd name="T114" fmla="*/ 4782 w 4906"/>
              <a:gd name="T115" fmla="*/ 937 h 961"/>
              <a:gd name="T116" fmla="*/ 4864 w 4906"/>
              <a:gd name="T117" fmla="*/ 953 h 9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4906" h="961">
                <a:moveTo>
                  <a:pt x="0" y="0"/>
                </a:moveTo>
                <a:lnTo>
                  <a:pt x="20" y="4"/>
                </a:lnTo>
                <a:lnTo>
                  <a:pt x="41" y="8"/>
                </a:lnTo>
                <a:lnTo>
                  <a:pt x="62" y="12"/>
                </a:lnTo>
                <a:lnTo>
                  <a:pt x="82" y="16"/>
                </a:lnTo>
                <a:lnTo>
                  <a:pt x="103" y="20"/>
                </a:lnTo>
                <a:lnTo>
                  <a:pt x="124" y="24"/>
                </a:lnTo>
                <a:lnTo>
                  <a:pt x="144" y="28"/>
                </a:lnTo>
                <a:lnTo>
                  <a:pt x="165" y="32"/>
                </a:lnTo>
                <a:lnTo>
                  <a:pt x="186" y="37"/>
                </a:lnTo>
                <a:lnTo>
                  <a:pt x="207" y="41"/>
                </a:lnTo>
                <a:lnTo>
                  <a:pt x="227" y="45"/>
                </a:lnTo>
                <a:lnTo>
                  <a:pt x="248" y="49"/>
                </a:lnTo>
                <a:lnTo>
                  <a:pt x="269" y="53"/>
                </a:lnTo>
                <a:lnTo>
                  <a:pt x="289" y="57"/>
                </a:lnTo>
                <a:lnTo>
                  <a:pt x="310" y="61"/>
                </a:lnTo>
                <a:lnTo>
                  <a:pt x="331" y="65"/>
                </a:lnTo>
                <a:lnTo>
                  <a:pt x="351" y="69"/>
                </a:lnTo>
                <a:lnTo>
                  <a:pt x="372" y="73"/>
                </a:lnTo>
                <a:lnTo>
                  <a:pt x="393" y="77"/>
                </a:lnTo>
                <a:lnTo>
                  <a:pt x="414" y="81"/>
                </a:lnTo>
                <a:lnTo>
                  <a:pt x="434" y="85"/>
                </a:lnTo>
                <a:lnTo>
                  <a:pt x="455" y="89"/>
                </a:lnTo>
                <a:lnTo>
                  <a:pt x="476" y="93"/>
                </a:lnTo>
                <a:lnTo>
                  <a:pt x="496" y="97"/>
                </a:lnTo>
                <a:lnTo>
                  <a:pt x="517" y="101"/>
                </a:lnTo>
                <a:lnTo>
                  <a:pt x="538" y="105"/>
                </a:lnTo>
                <a:lnTo>
                  <a:pt x="558" y="110"/>
                </a:lnTo>
                <a:lnTo>
                  <a:pt x="579" y="114"/>
                </a:lnTo>
                <a:lnTo>
                  <a:pt x="600" y="118"/>
                </a:lnTo>
                <a:lnTo>
                  <a:pt x="621" y="122"/>
                </a:lnTo>
                <a:lnTo>
                  <a:pt x="641" y="126"/>
                </a:lnTo>
                <a:lnTo>
                  <a:pt x="662" y="130"/>
                </a:lnTo>
                <a:lnTo>
                  <a:pt x="683" y="134"/>
                </a:lnTo>
                <a:lnTo>
                  <a:pt x="703" y="138"/>
                </a:lnTo>
                <a:lnTo>
                  <a:pt x="724" y="142"/>
                </a:lnTo>
                <a:lnTo>
                  <a:pt x="745" y="146"/>
                </a:lnTo>
                <a:lnTo>
                  <a:pt x="765" y="150"/>
                </a:lnTo>
                <a:lnTo>
                  <a:pt x="786" y="154"/>
                </a:lnTo>
                <a:lnTo>
                  <a:pt x="807" y="158"/>
                </a:lnTo>
                <a:lnTo>
                  <a:pt x="828" y="162"/>
                </a:lnTo>
                <a:lnTo>
                  <a:pt x="848" y="166"/>
                </a:lnTo>
                <a:lnTo>
                  <a:pt x="869" y="170"/>
                </a:lnTo>
                <a:lnTo>
                  <a:pt x="890" y="174"/>
                </a:lnTo>
                <a:lnTo>
                  <a:pt x="910" y="178"/>
                </a:lnTo>
                <a:lnTo>
                  <a:pt x="931" y="183"/>
                </a:lnTo>
                <a:lnTo>
                  <a:pt x="952" y="187"/>
                </a:lnTo>
                <a:lnTo>
                  <a:pt x="972" y="191"/>
                </a:lnTo>
                <a:lnTo>
                  <a:pt x="993" y="195"/>
                </a:lnTo>
                <a:lnTo>
                  <a:pt x="1014" y="199"/>
                </a:lnTo>
                <a:lnTo>
                  <a:pt x="1035" y="203"/>
                </a:lnTo>
                <a:lnTo>
                  <a:pt x="1055" y="207"/>
                </a:lnTo>
                <a:lnTo>
                  <a:pt x="1076" y="211"/>
                </a:lnTo>
                <a:lnTo>
                  <a:pt x="1097" y="215"/>
                </a:lnTo>
                <a:lnTo>
                  <a:pt x="1117" y="219"/>
                </a:lnTo>
                <a:lnTo>
                  <a:pt x="1138" y="223"/>
                </a:lnTo>
                <a:lnTo>
                  <a:pt x="1159" y="227"/>
                </a:lnTo>
                <a:lnTo>
                  <a:pt x="1179" y="231"/>
                </a:lnTo>
                <a:lnTo>
                  <a:pt x="1200" y="235"/>
                </a:lnTo>
                <a:lnTo>
                  <a:pt x="1221" y="239"/>
                </a:lnTo>
                <a:lnTo>
                  <a:pt x="1242" y="243"/>
                </a:lnTo>
                <a:lnTo>
                  <a:pt x="1262" y="247"/>
                </a:lnTo>
                <a:lnTo>
                  <a:pt x="1283" y="251"/>
                </a:lnTo>
                <a:lnTo>
                  <a:pt x="1304" y="255"/>
                </a:lnTo>
                <a:lnTo>
                  <a:pt x="1324" y="260"/>
                </a:lnTo>
                <a:lnTo>
                  <a:pt x="1345" y="264"/>
                </a:lnTo>
                <a:lnTo>
                  <a:pt x="1366" y="268"/>
                </a:lnTo>
                <a:lnTo>
                  <a:pt x="1386" y="272"/>
                </a:lnTo>
                <a:lnTo>
                  <a:pt x="1407" y="276"/>
                </a:lnTo>
                <a:lnTo>
                  <a:pt x="1428" y="280"/>
                </a:lnTo>
                <a:lnTo>
                  <a:pt x="1449" y="284"/>
                </a:lnTo>
                <a:lnTo>
                  <a:pt x="1469" y="288"/>
                </a:lnTo>
                <a:lnTo>
                  <a:pt x="1490" y="292"/>
                </a:lnTo>
                <a:lnTo>
                  <a:pt x="1511" y="296"/>
                </a:lnTo>
                <a:lnTo>
                  <a:pt x="1531" y="300"/>
                </a:lnTo>
                <a:lnTo>
                  <a:pt x="1552" y="304"/>
                </a:lnTo>
                <a:lnTo>
                  <a:pt x="1573" y="308"/>
                </a:lnTo>
                <a:lnTo>
                  <a:pt x="1594" y="312"/>
                </a:lnTo>
                <a:lnTo>
                  <a:pt x="1614" y="316"/>
                </a:lnTo>
                <a:lnTo>
                  <a:pt x="1635" y="320"/>
                </a:lnTo>
                <a:lnTo>
                  <a:pt x="1656" y="324"/>
                </a:lnTo>
                <a:lnTo>
                  <a:pt x="1676" y="328"/>
                </a:lnTo>
                <a:lnTo>
                  <a:pt x="1697" y="333"/>
                </a:lnTo>
                <a:lnTo>
                  <a:pt x="1718" y="337"/>
                </a:lnTo>
                <a:lnTo>
                  <a:pt x="1738" y="341"/>
                </a:lnTo>
                <a:lnTo>
                  <a:pt x="1759" y="345"/>
                </a:lnTo>
                <a:lnTo>
                  <a:pt x="1780" y="349"/>
                </a:lnTo>
                <a:lnTo>
                  <a:pt x="1801" y="353"/>
                </a:lnTo>
                <a:lnTo>
                  <a:pt x="1821" y="357"/>
                </a:lnTo>
                <a:lnTo>
                  <a:pt x="1842" y="361"/>
                </a:lnTo>
                <a:lnTo>
                  <a:pt x="1863" y="365"/>
                </a:lnTo>
                <a:lnTo>
                  <a:pt x="1883" y="369"/>
                </a:lnTo>
                <a:lnTo>
                  <a:pt x="1904" y="373"/>
                </a:lnTo>
                <a:lnTo>
                  <a:pt x="1925" y="377"/>
                </a:lnTo>
                <a:lnTo>
                  <a:pt x="1945" y="381"/>
                </a:lnTo>
                <a:lnTo>
                  <a:pt x="1966" y="385"/>
                </a:lnTo>
                <a:lnTo>
                  <a:pt x="1987" y="389"/>
                </a:lnTo>
                <a:lnTo>
                  <a:pt x="2008" y="393"/>
                </a:lnTo>
                <a:lnTo>
                  <a:pt x="2028" y="397"/>
                </a:lnTo>
                <a:lnTo>
                  <a:pt x="2049" y="401"/>
                </a:lnTo>
                <a:lnTo>
                  <a:pt x="2070" y="406"/>
                </a:lnTo>
                <a:lnTo>
                  <a:pt x="2090" y="410"/>
                </a:lnTo>
                <a:lnTo>
                  <a:pt x="2111" y="414"/>
                </a:lnTo>
                <a:lnTo>
                  <a:pt x="2132" y="418"/>
                </a:lnTo>
                <a:lnTo>
                  <a:pt x="2152" y="422"/>
                </a:lnTo>
                <a:lnTo>
                  <a:pt x="2173" y="426"/>
                </a:lnTo>
                <a:lnTo>
                  <a:pt x="2194" y="430"/>
                </a:lnTo>
                <a:lnTo>
                  <a:pt x="2215" y="434"/>
                </a:lnTo>
                <a:lnTo>
                  <a:pt x="2235" y="438"/>
                </a:lnTo>
                <a:lnTo>
                  <a:pt x="2256" y="442"/>
                </a:lnTo>
                <a:lnTo>
                  <a:pt x="2277" y="446"/>
                </a:lnTo>
                <a:lnTo>
                  <a:pt x="2297" y="450"/>
                </a:lnTo>
                <a:lnTo>
                  <a:pt x="2318" y="454"/>
                </a:lnTo>
                <a:lnTo>
                  <a:pt x="2339" y="458"/>
                </a:lnTo>
                <a:lnTo>
                  <a:pt x="2359" y="462"/>
                </a:lnTo>
                <a:lnTo>
                  <a:pt x="2380" y="466"/>
                </a:lnTo>
                <a:lnTo>
                  <a:pt x="2401" y="470"/>
                </a:lnTo>
                <a:lnTo>
                  <a:pt x="2422" y="474"/>
                </a:lnTo>
                <a:lnTo>
                  <a:pt x="2442" y="478"/>
                </a:lnTo>
                <a:lnTo>
                  <a:pt x="2463" y="483"/>
                </a:lnTo>
                <a:lnTo>
                  <a:pt x="2484" y="487"/>
                </a:lnTo>
                <a:lnTo>
                  <a:pt x="2504" y="491"/>
                </a:lnTo>
                <a:lnTo>
                  <a:pt x="2525" y="495"/>
                </a:lnTo>
                <a:lnTo>
                  <a:pt x="2546" y="499"/>
                </a:lnTo>
                <a:lnTo>
                  <a:pt x="2566" y="503"/>
                </a:lnTo>
                <a:lnTo>
                  <a:pt x="2587" y="507"/>
                </a:lnTo>
                <a:lnTo>
                  <a:pt x="2608" y="511"/>
                </a:lnTo>
                <a:lnTo>
                  <a:pt x="2629" y="515"/>
                </a:lnTo>
                <a:lnTo>
                  <a:pt x="2649" y="519"/>
                </a:lnTo>
                <a:lnTo>
                  <a:pt x="2670" y="523"/>
                </a:lnTo>
                <a:lnTo>
                  <a:pt x="2691" y="527"/>
                </a:lnTo>
                <a:lnTo>
                  <a:pt x="2711" y="531"/>
                </a:lnTo>
                <a:lnTo>
                  <a:pt x="2732" y="535"/>
                </a:lnTo>
                <a:lnTo>
                  <a:pt x="2753" y="539"/>
                </a:lnTo>
                <a:lnTo>
                  <a:pt x="2773" y="543"/>
                </a:lnTo>
                <a:lnTo>
                  <a:pt x="2794" y="547"/>
                </a:lnTo>
                <a:lnTo>
                  <a:pt x="2815" y="551"/>
                </a:lnTo>
                <a:lnTo>
                  <a:pt x="2836" y="556"/>
                </a:lnTo>
                <a:lnTo>
                  <a:pt x="2856" y="560"/>
                </a:lnTo>
                <a:lnTo>
                  <a:pt x="2877" y="564"/>
                </a:lnTo>
                <a:lnTo>
                  <a:pt x="2898" y="568"/>
                </a:lnTo>
                <a:lnTo>
                  <a:pt x="2918" y="572"/>
                </a:lnTo>
                <a:lnTo>
                  <a:pt x="2939" y="576"/>
                </a:lnTo>
                <a:lnTo>
                  <a:pt x="2960" y="580"/>
                </a:lnTo>
                <a:lnTo>
                  <a:pt x="2980" y="584"/>
                </a:lnTo>
                <a:lnTo>
                  <a:pt x="3001" y="588"/>
                </a:lnTo>
                <a:lnTo>
                  <a:pt x="3022" y="592"/>
                </a:lnTo>
                <a:lnTo>
                  <a:pt x="3043" y="596"/>
                </a:lnTo>
                <a:lnTo>
                  <a:pt x="3063" y="600"/>
                </a:lnTo>
                <a:lnTo>
                  <a:pt x="3084" y="604"/>
                </a:lnTo>
                <a:lnTo>
                  <a:pt x="3105" y="608"/>
                </a:lnTo>
                <a:lnTo>
                  <a:pt x="3125" y="612"/>
                </a:lnTo>
                <a:lnTo>
                  <a:pt x="3146" y="616"/>
                </a:lnTo>
                <a:lnTo>
                  <a:pt x="3167" y="620"/>
                </a:lnTo>
                <a:lnTo>
                  <a:pt x="3188" y="624"/>
                </a:lnTo>
                <a:lnTo>
                  <a:pt x="3208" y="629"/>
                </a:lnTo>
                <a:lnTo>
                  <a:pt x="3229" y="633"/>
                </a:lnTo>
                <a:lnTo>
                  <a:pt x="3250" y="637"/>
                </a:lnTo>
                <a:lnTo>
                  <a:pt x="3270" y="641"/>
                </a:lnTo>
                <a:lnTo>
                  <a:pt x="3291" y="645"/>
                </a:lnTo>
                <a:lnTo>
                  <a:pt x="3312" y="649"/>
                </a:lnTo>
                <a:lnTo>
                  <a:pt x="3332" y="653"/>
                </a:lnTo>
                <a:lnTo>
                  <a:pt x="3353" y="657"/>
                </a:lnTo>
                <a:lnTo>
                  <a:pt x="3374" y="661"/>
                </a:lnTo>
                <a:lnTo>
                  <a:pt x="3395" y="665"/>
                </a:lnTo>
                <a:lnTo>
                  <a:pt x="3415" y="669"/>
                </a:lnTo>
                <a:lnTo>
                  <a:pt x="3436" y="673"/>
                </a:lnTo>
                <a:lnTo>
                  <a:pt x="3457" y="677"/>
                </a:lnTo>
                <a:lnTo>
                  <a:pt x="3477" y="681"/>
                </a:lnTo>
                <a:lnTo>
                  <a:pt x="3498" y="685"/>
                </a:lnTo>
                <a:lnTo>
                  <a:pt x="3519" y="689"/>
                </a:lnTo>
                <a:lnTo>
                  <a:pt x="3539" y="693"/>
                </a:lnTo>
                <a:lnTo>
                  <a:pt x="3560" y="697"/>
                </a:lnTo>
                <a:lnTo>
                  <a:pt x="3581" y="701"/>
                </a:lnTo>
                <a:lnTo>
                  <a:pt x="3602" y="706"/>
                </a:lnTo>
                <a:lnTo>
                  <a:pt x="3622" y="710"/>
                </a:lnTo>
                <a:lnTo>
                  <a:pt x="3643" y="714"/>
                </a:lnTo>
                <a:lnTo>
                  <a:pt x="3664" y="718"/>
                </a:lnTo>
                <a:lnTo>
                  <a:pt x="3684" y="722"/>
                </a:lnTo>
                <a:lnTo>
                  <a:pt x="3705" y="726"/>
                </a:lnTo>
                <a:lnTo>
                  <a:pt x="3726" y="730"/>
                </a:lnTo>
                <a:lnTo>
                  <a:pt x="3746" y="734"/>
                </a:lnTo>
                <a:lnTo>
                  <a:pt x="3767" y="738"/>
                </a:lnTo>
                <a:lnTo>
                  <a:pt x="3788" y="742"/>
                </a:lnTo>
                <a:lnTo>
                  <a:pt x="3809" y="746"/>
                </a:lnTo>
                <a:lnTo>
                  <a:pt x="3829" y="750"/>
                </a:lnTo>
                <a:lnTo>
                  <a:pt x="3850" y="754"/>
                </a:lnTo>
                <a:lnTo>
                  <a:pt x="3871" y="758"/>
                </a:lnTo>
                <a:lnTo>
                  <a:pt x="3891" y="762"/>
                </a:lnTo>
                <a:lnTo>
                  <a:pt x="3912" y="766"/>
                </a:lnTo>
                <a:lnTo>
                  <a:pt x="3933" y="770"/>
                </a:lnTo>
                <a:lnTo>
                  <a:pt x="3953" y="774"/>
                </a:lnTo>
                <a:lnTo>
                  <a:pt x="3974" y="779"/>
                </a:lnTo>
                <a:lnTo>
                  <a:pt x="3995" y="783"/>
                </a:lnTo>
                <a:lnTo>
                  <a:pt x="4016" y="787"/>
                </a:lnTo>
                <a:lnTo>
                  <a:pt x="4036" y="791"/>
                </a:lnTo>
                <a:lnTo>
                  <a:pt x="4057" y="795"/>
                </a:lnTo>
                <a:lnTo>
                  <a:pt x="4078" y="799"/>
                </a:lnTo>
                <a:lnTo>
                  <a:pt x="4098" y="803"/>
                </a:lnTo>
                <a:lnTo>
                  <a:pt x="4119" y="807"/>
                </a:lnTo>
                <a:lnTo>
                  <a:pt x="4140" y="811"/>
                </a:lnTo>
                <a:lnTo>
                  <a:pt x="4160" y="815"/>
                </a:lnTo>
                <a:lnTo>
                  <a:pt x="4181" y="819"/>
                </a:lnTo>
                <a:lnTo>
                  <a:pt x="4202" y="823"/>
                </a:lnTo>
                <a:lnTo>
                  <a:pt x="4223" y="827"/>
                </a:lnTo>
                <a:lnTo>
                  <a:pt x="4243" y="831"/>
                </a:lnTo>
                <a:lnTo>
                  <a:pt x="4264" y="835"/>
                </a:lnTo>
                <a:lnTo>
                  <a:pt x="4285" y="839"/>
                </a:lnTo>
                <a:lnTo>
                  <a:pt x="4305" y="843"/>
                </a:lnTo>
                <a:lnTo>
                  <a:pt x="4326" y="847"/>
                </a:lnTo>
                <a:lnTo>
                  <a:pt x="4347" y="852"/>
                </a:lnTo>
                <a:lnTo>
                  <a:pt x="4367" y="856"/>
                </a:lnTo>
                <a:lnTo>
                  <a:pt x="4388" y="860"/>
                </a:lnTo>
                <a:lnTo>
                  <a:pt x="4409" y="864"/>
                </a:lnTo>
                <a:lnTo>
                  <a:pt x="4430" y="868"/>
                </a:lnTo>
                <a:lnTo>
                  <a:pt x="4450" y="872"/>
                </a:lnTo>
                <a:lnTo>
                  <a:pt x="4471" y="876"/>
                </a:lnTo>
                <a:lnTo>
                  <a:pt x="4492" y="880"/>
                </a:lnTo>
                <a:lnTo>
                  <a:pt x="4512" y="884"/>
                </a:lnTo>
                <a:lnTo>
                  <a:pt x="4533" y="888"/>
                </a:lnTo>
                <a:lnTo>
                  <a:pt x="4554" y="892"/>
                </a:lnTo>
                <a:lnTo>
                  <a:pt x="4574" y="896"/>
                </a:lnTo>
                <a:lnTo>
                  <a:pt x="4595" y="900"/>
                </a:lnTo>
                <a:lnTo>
                  <a:pt x="4616" y="904"/>
                </a:lnTo>
                <a:lnTo>
                  <a:pt x="4637" y="908"/>
                </a:lnTo>
                <a:lnTo>
                  <a:pt x="4657" y="912"/>
                </a:lnTo>
                <a:lnTo>
                  <a:pt x="4678" y="916"/>
                </a:lnTo>
                <a:lnTo>
                  <a:pt x="4699" y="920"/>
                </a:lnTo>
                <a:lnTo>
                  <a:pt x="4719" y="924"/>
                </a:lnTo>
                <a:lnTo>
                  <a:pt x="4740" y="929"/>
                </a:lnTo>
                <a:lnTo>
                  <a:pt x="4761" y="933"/>
                </a:lnTo>
                <a:lnTo>
                  <a:pt x="4782" y="937"/>
                </a:lnTo>
                <a:lnTo>
                  <a:pt x="4802" y="941"/>
                </a:lnTo>
                <a:lnTo>
                  <a:pt x="4823" y="945"/>
                </a:lnTo>
                <a:lnTo>
                  <a:pt x="4844" y="949"/>
                </a:lnTo>
                <a:lnTo>
                  <a:pt x="4864" y="953"/>
                </a:lnTo>
                <a:lnTo>
                  <a:pt x="4885" y="957"/>
                </a:lnTo>
                <a:lnTo>
                  <a:pt x="4906" y="961"/>
                </a:lnTo>
              </a:path>
            </a:pathLst>
          </a:cu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101" name="Line 58"/>
          <p:cNvSpPr>
            <a:spLocks noChangeShapeType="1"/>
          </p:cNvSpPr>
          <p:nvPr/>
        </p:nvSpPr>
        <p:spPr bwMode="auto">
          <a:xfrm flipV="1">
            <a:off x="6640513" y="4997599"/>
            <a:ext cx="14288" cy="3175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102" name="Freeform 59"/>
          <p:cNvSpPr>
            <a:spLocks/>
          </p:cNvSpPr>
          <p:nvPr/>
        </p:nvSpPr>
        <p:spPr bwMode="auto">
          <a:xfrm flipV="1">
            <a:off x="2160588" y="4775349"/>
            <a:ext cx="4479925" cy="1135063"/>
          </a:xfrm>
          <a:custGeom>
            <a:avLst/>
            <a:gdLst>
              <a:gd name="T0" fmla="*/ 62 w 4906"/>
              <a:gd name="T1" fmla="*/ 15 h 1239"/>
              <a:gd name="T2" fmla="*/ 144 w 4906"/>
              <a:gd name="T3" fmla="*/ 36 h 1239"/>
              <a:gd name="T4" fmla="*/ 227 w 4906"/>
              <a:gd name="T5" fmla="*/ 57 h 1239"/>
              <a:gd name="T6" fmla="*/ 310 w 4906"/>
              <a:gd name="T7" fmla="*/ 78 h 1239"/>
              <a:gd name="T8" fmla="*/ 393 w 4906"/>
              <a:gd name="T9" fmla="*/ 99 h 1239"/>
              <a:gd name="T10" fmla="*/ 476 w 4906"/>
              <a:gd name="T11" fmla="*/ 120 h 1239"/>
              <a:gd name="T12" fmla="*/ 558 w 4906"/>
              <a:gd name="T13" fmla="*/ 141 h 1239"/>
              <a:gd name="T14" fmla="*/ 641 w 4906"/>
              <a:gd name="T15" fmla="*/ 162 h 1239"/>
              <a:gd name="T16" fmla="*/ 724 w 4906"/>
              <a:gd name="T17" fmla="*/ 183 h 1239"/>
              <a:gd name="T18" fmla="*/ 807 w 4906"/>
              <a:gd name="T19" fmla="*/ 204 h 1239"/>
              <a:gd name="T20" fmla="*/ 890 w 4906"/>
              <a:gd name="T21" fmla="*/ 225 h 1239"/>
              <a:gd name="T22" fmla="*/ 972 w 4906"/>
              <a:gd name="T23" fmla="*/ 246 h 1239"/>
              <a:gd name="T24" fmla="*/ 1055 w 4906"/>
              <a:gd name="T25" fmla="*/ 266 h 1239"/>
              <a:gd name="T26" fmla="*/ 1138 w 4906"/>
              <a:gd name="T27" fmla="*/ 287 h 1239"/>
              <a:gd name="T28" fmla="*/ 1221 w 4906"/>
              <a:gd name="T29" fmla="*/ 308 h 1239"/>
              <a:gd name="T30" fmla="*/ 1304 w 4906"/>
              <a:gd name="T31" fmla="*/ 329 h 1239"/>
              <a:gd name="T32" fmla="*/ 1386 w 4906"/>
              <a:gd name="T33" fmla="*/ 350 h 1239"/>
              <a:gd name="T34" fmla="*/ 1469 w 4906"/>
              <a:gd name="T35" fmla="*/ 371 h 1239"/>
              <a:gd name="T36" fmla="*/ 1552 w 4906"/>
              <a:gd name="T37" fmla="*/ 392 h 1239"/>
              <a:gd name="T38" fmla="*/ 1635 w 4906"/>
              <a:gd name="T39" fmla="*/ 413 h 1239"/>
              <a:gd name="T40" fmla="*/ 1718 w 4906"/>
              <a:gd name="T41" fmla="*/ 434 h 1239"/>
              <a:gd name="T42" fmla="*/ 1801 w 4906"/>
              <a:gd name="T43" fmla="*/ 455 h 1239"/>
              <a:gd name="T44" fmla="*/ 1883 w 4906"/>
              <a:gd name="T45" fmla="*/ 476 h 1239"/>
              <a:gd name="T46" fmla="*/ 1966 w 4906"/>
              <a:gd name="T47" fmla="*/ 497 h 1239"/>
              <a:gd name="T48" fmla="*/ 2049 w 4906"/>
              <a:gd name="T49" fmla="*/ 518 h 1239"/>
              <a:gd name="T50" fmla="*/ 2132 w 4906"/>
              <a:gd name="T51" fmla="*/ 538 h 1239"/>
              <a:gd name="T52" fmla="*/ 2215 w 4906"/>
              <a:gd name="T53" fmla="*/ 559 h 1239"/>
              <a:gd name="T54" fmla="*/ 2297 w 4906"/>
              <a:gd name="T55" fmla="*/ 580 h 1239"/>
              <a:gd name="T56" fmla="*/ 2380 w 4906"/>
              <a:gd name="T57" fmla="*/ 601 h 1239"/>
              <a:gd name="T58" fmla="*/ 2463 w 4906"/>
              <a:gd name="T59" fmla="*/ 622 h 1239"/>
              <a:gd name="T60" fmla="*/ 2546 w 4906"/>
              <a:gd name="T61" fmla="*/ 643 h 1239"/>
              <a:gd name="T62" fmla="*/ 2629 w 4906"/>
              <a:gd name="T63" fmla="*/ 664 h 1239"/>
              <a:gd name="T64" fmla="*/ 2711 w 4906"/>
              <a:gd name="T65" fmla="*/ 685 h 1239"/>
              <a:gd name="T66" fmla="*/ 2794 w 4906"/>
              <a:gd name="T67" fmla="*/ 706 h 1239"/>
              <a:gd name="T68" fmla="*/ 2877 w 4906"/>
              <a:gd name="T69" fmla="*/ 727 h 1239"/>
              <a:gd name="T70" fmla="*/ 2960 w 4906"/>
              <a:gd name="T71" fmla="*/ 748 h 1239"/>
              <a:gd name="T72" fmla="*/ 3043 w 4906"/>
              <a:gd name="T73" fmla="*/ 769 h 1239"/>
              <a:gd name="T74" fmla="*/ 3125 w 4906"/>
              <a:gd name="T75" fmla="*/ 790 h 1239"/>
              <a:gd name="T76" fmla="*/ 3208 w 4906"/>
              <a:gd name="T77" fmla="*/ 810 h 1239"/>
              <a:gd name="T78" fmla="*/ 3291 w 4906"/>
              <a:gd name="T79" fmla="*/ 831 h 1239"/>
              <a:gd name="T80" fmla="*/ 3374 w 4906"/>
              <a:gd name="T81" fmla="*/ 852 h 1239"/>
              <a:gd name="T82" fmla="*/ 3457 w 4906"/>
              <a:gd name="T83" fmla="*/ 873 h 1239"/>
              <a:gd name="T84" fmla="*/ 3539 w 4906"/>
              <a:gd name="T85" fmla="*/ 894 h 1239"/>
              <a:gd name="T86" fmla="*/ 3622 w 4906"/>
              <a:gd name="T87" fmla="*/ 915 h 1239"/>
              <a:gd name="T88" fmla="*/ 3705 w 4906"/>
              <a:gd name="T89" fmla="*/ 936 h 1239"/>
              <a:gd name="T90" fmla="*/ 3788 w 4906"/>
              <a:gd name="T91" fmla="*/ 957 h 1239"/>
              <a:gd name="T92" fmla="*/ 3871 w 4906"/>
              <a:gd name="T93" fmla="*/ 978 h 1239"/>
              <a:gd name="T94" fmla="*/ 3953 w 4906"/>
              <a:gd name="T95" fmla="*/ 999 h 1239"/>
              <a:gd name="T96" fmla="*/ 4036 w 4906"/>
              <a:gd name="T97" fmla="*/ 1020 h 1239"/>
              <a:gd name="T98" fmla="*/ 4119 w 4906"/>
              <a:gd name="T99" fmla="*/ 1041 h 1239"/>
              <a:gd name="T100" fmla="*/ 4202 w 4906"/>
              <a:gd name="T101" fmla="*/ 1062 h 1239"/>
              <a:gd name="T102" fmla="*/ 4285 w 4906"/>
              <a:gd name="T103" fmla="*/ 1082 h 1239"/>
              <a:gd name="T104" fmla="*/ 4367 w 4906"/>
              <a:gd name="T105" fmla="*/ 1103 h 1239"/>
              <a:gd name="T106" fmla="*/ 4450 w 4906"/>
              <a:gd name="T107" fmla="*/ 1124 h 1239"/>
              <a:gd name="T108" fmla="*/ 4533 w 4906"/>
              <a:gd name="T109" fmla="*/ 1145 h 1239"/>
              <a:gd name="T110" fmla="*/ 4616 w 4906"/>
              <a:gd name="T111" fmla="*/ 1166 h 1239"/>
              <a:gd name="T112" fmla="*/ 4699 w 4906"/>
              <a:gd name="T113" fmla="*/ 1187 h 1239"/>
              <a:gd name="T114" fmla="*/ 4782 w 4906"/>
              <a:gd name="T115" fmla="*/ 1208 h 1239"/>
              <a:gd name="T116" fmla="*/ 4864 w 4906"/>
              <a:gd name="T117" fmla="*/ 1229 h 12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4906" h="1239">
                <a:moveTo>
                  <a:pt x="0" y="0"/>
                </a:moveTo>
                <a:lnTo>
                  <a:pt x="20" y="5"/>
                </a:lnTo>
                <a:lnTo>
                  <a:pt x="41" y="10"/>
                </a:lnTo>
                <a:lnTo>
                  <a:pt x="62" y="15"/>
                </a:lnTo>
                <a:lnTo>
                  <a:pt x="82" y="21"/>
                </a:lnTo>
                <a:lnTo>
                  <a:pt x="103" y="26"/>
                </a:lnTo>
                <a:lnTo>
                  <a:pt x="124" y="31"/>
                </a:lnTo>
                <a:lnTo>
                  <a:pt x="144" y="36"/>
                </a:lnTo>
                <a:lnTo>
                  <a:pt x="165" y="42"/>
                </a:lnTo>
                <a:lnTo>
                  <a:pt x="186" y="47"/>
                </a:lnTo>
                <a:lnTo>
                  <a:pt x="207" y="52"/>
                </a:lnTo>
                <a:lnTo>
                  <a:pt x="227" y="57"/>
                </a:lnTo>
                <a:lnTo>
                  <a:pt x="248" y="62"/>
                </a:lnTo>
                <a:lnTo>
                  <a:pt x="269" y="68"/>
                </a:lnTo>
                <a:lnTo>
                  <a:pt x="289" y="73"/>
                </a:lnTo>
                <a:lnTo>
                  <a:pt x="310" y="78"/>
                </a:lnTo>
                <a:lnTo>
                  <a:pt x="331" y="83"/>
                </a:lnTo>
                <a:lnTo>
                  <a:pt x="351" y="89"/>
                </a:lnTo>
                <a:lnTo>
                  <a:pt x="372" y="94"/>
                </a:lnTo>
                <a:lnTo>
                  <a:pt x="393" y="99"/>
                </a:lnTo>
                <a:lnTo>
                  <a:pt x="414" y="104"/>
                </a:lnTo>
                <a:lnTo>
                  <a:pt x="434" y="110"/>
                </a:lnTo>
                <a:lnTo>
                  <a:pt x="455" y="115"/>
                </a:lnTo>
                <a:lnTo>
                  <a:pt x="476" y="120"/>
                </a:lnTo>
                <a:lnTo>
                  <a:pt x="496" y="125"/>
                </a:lnTo>
                <a:lnTo>
                  <a:pt x="517" y="130"/>
                </a:lnTo>
                <a:lnTo>
                  <a:pt x="538" y="136"/>
                </a:lnTo>
                <a:lnTo>
                  <a:pt x="558" y="141"/>
                </a:lnTo>
                <a:lnTo>
                  <a:pt x="579" y="146"/>
                </a:lnTo>
                <a:lnTo>
                  <a:pt x="600" y="151"/>
                </a:lnTo>
                <a:lnTo>
                  <a:pt x="621" y="157"/>
                </a:lnTo>
                <a:lnTo>
                  <a:pt x="641" y="162"/>
                </a:lnTo>
                <a:lnTo>
                  <a:pt x="662" y="167"/>
                </a:lnTo>
                <a:lnTo>
                  <a:pt x="683" y="172"/>
                </a:lnTo>
                <a:lnTo>
                  <a:pt x="703" y="178"/>
                </a:lnTo>
                <a:lnTo>
                  <a:pt x="724" y="183"/>
                </a:lnTo>
                <a:lnTo>
                  <a:pt x="745" y="188"/>
                </a:lnTo>
                <a:lnTo>
                  <a:pt x="765" y="193"/>
                </a:lnTo>
                <a:lnTo>
                  <a:pt x="786" y="198"/>
                </a:lnTo>
                <a:lnTo>
                  <a:pt x="807" y="204"/>
                </a:lnTo>
                <a:lnTo>
                  <a:pt x="828" y="209"/>
                </a:lnTo>
                <a:lnTo>
                  <a:pt x="848" y="214"/>
                </a:lnTo>
                <a:lnTo>
                  <a:pt x="869" y="219"/>
                </a:lnTo>
                <a:lnTo>
                  <a:pt x="890" y="225"/>
                </a:lnTo>
                <a:lnTo>
                  <a:pt x="910" y="230"/>
                </a:lnTo>
                <a:lnTo>
                  <a:pt x="931" y="235"/>
                </a:lnTo>
                <a:lnTo>
                  <a:pt x="952" y="240"/>
                </a:lnTo>
                <a:lnTo>
                  <a:pt x="972" y="246"/>
                </a:lnTo>
                <a:lnTo>
                  <a:pt x="993" y="251"/>
                </a:lnTo>
                <a:lnTo>
                  <a:pt x="1014" y="256"/>
                </a:lnTo>
                <a:lnTo>
                  <a:pt x="1035" y="261"/>
                </a:lnTo>
                <a:lnTo>
                  <a:pt x="1055" y="266"/>
                </a:lnTo>
                <a:lnTo>
                  <a:pt x="1076" y="272"/>
                </a:lnTo>
                <a:lnTo>
                  <a:pt x="1097" y="277"/>
                </a:lnTo>
                <a:lnTo>
                  <a:pt x="1117" y="282"/>
                </a:lnTo>
                <a:lnTo>
                  <a:pt x="1138" y="287"/>
                </a:lnTo>
                <a:lnTo>
                  <a:pt x="1159" y="293"/>
                </a:lnTo>
                <a:lnTo>
                  <a:pt x="1179" y="298"/>
                </a:lnTo>
                <a:lnTo>
                  <a:pt x="1200" y="303"/>
                </a:lnTo>
                <a:lnTo>
                  <a:pt x="1221" y="308"/>
                </a:lnTo>
                <a:lnTo>
                  <a:pt x="1242" y="314"/>
                </a:lnTo>
                <a:lnTo>
                  <a:pt x="1262" y="319"/>
                </a:lnTo>
                <a:lnTo>
                  <a:pt x="1283" y="324"/>
                </a:lnTo>
                <a:lnTo>
                  <a:pt x="1304" y="329"/>
                </a:lnTo>
                <a:lnTo>
                  <a:pt x="1324" y="334"/>
                </a:lnTo>
                <a:lnTo>
                  <a:pt x="1345" y="340"/>
                </a:lnTo>
                <a:lnTo>
                  <a:pt x="1366" y="345"/>
                </a:lnTo>
                <a:lnTo>
                  <a:pt x="1386" y="350"/>
                </a:lnTo>
                <a:lnTo>
                  <a:pt x="1407" y="355"/>
                </a:lnTo>
                <a:lnTo>
                  <a:pt x="1428" y="361"/>
                </a:lnTo>
                <a:lnTo>
                  <a:pt x="1449" y="366"/>
                </a:lnTo>
                <a:lnTo>
                  <a:pt x="1469" y="371"/>
                </a:lnTo>
                <a:lnTo>
                  <a:pt x="1490" y="376"/>
                </a:lnTo>
                <a:lnTo>
                  <a:pt x="1511" y="382"/>
                </a:lnTo>
                <a:lnTo>
                  <a:pt x="1531" y="387"/>
                </a:lnTo>
                <a:lnTo>
                  <a:pt x="1552" y="392"/>
                </a:lnTo>
                <a:lnTo>
                  <a:pt x="1573" y="397"/>
                </a:lnTo>
                <a:lnTo>
                  <a:pt x="1594" y="402"/>
                </a:lnTo>
                <a:lnTo>
                  <a:pt x="1614" y="408"/>
                </a:lnTo>
                <a:lnTo>
                  <a:pt x="1635" y="413"/>
                </a:lnTo>
                <a:lnTo>
                  <a:pt x="1656" y="418"/>
                </a:lnTo>
                <a:lnTo>
                  <a:pt x="1676" y="423"/>
                </a:lnTo>
                <a:lnTo>
                  <a:pt x="1697" y="429"/>
                </a:lnTo>
                <a:lnTo>
                  <a:pt x="1718" y="434"/>
                </a:lnTo>
                <a:lnTo>
                  <a:pt x="1738" y="439"/>
                </a:lnTo>
                <a:lnTo>
                  <a:pt x="1759" y="444"/>
                </a:lnTo>
                <a:lnTo>
                  <a:pt x="1780" y="450"/>
                </a:lnTo>
                <a:lnTo>
                  <a:pt x="1801" y="455"/>
                </a:lnTo>
                <a:lnTo>
                  <a:pt x="1821" y="460"/>
                </a:lnTo>
                <a:lnTo>
                  <a:pt x="1842" y="465"/>
                </a:lnTo>
                <a:lnTo>
                  <a:pt x="1863" y="470"/>
                </a:lnTo>
                <a:lnTo>
                  <a:pt x="1883" y="476"/>
                </a:lnTo>
                <a:lnTo>
                  <a:pt x="1904" y="481"/>
                </a:lnTo>
                <a:lnTo>
                  <a:pt x="1925" y="486"/>
                </a:lnTo>
                <a:lnTo>
                  <a:pt x="1945" y="491"/>
                </a:lnTo>
                <a:lnTo>
                  <a:pt x="1966" y="497"/>
                </a:lnTo>
                <a:lnTo>
                  <a:pt x="1987" y="502"/>
                </a:lnTo>
                <a:lnTo>
                  <a:pt x="2008" y="507"/>
                </a:lnTo>
                <a:lnTo>
                  <a:pt x="2028" y="512"/>
                </a:lnTo>
                <a:lnTo>
                  <a:pt x="2049" y="518"/>
                </a:lnTo>
                <a:lnTo>
                  <a:pt x="2070" y="523"/>
                </a:lnTo>
                <a:lnTo>
                  <a:pt x="2090" y="528"/>
                </a:lnTo>
                <a:lnTo>
                  <a:pt x="2111" y="533"/>
                </a:lnTo>
                <a:lnTo>
                  <a:pt x="2132" y="538"/>
                </a:lnTo>
                <a:lnTo>
                  <a:pt x="2152" y="544"/>
                </a:lnTo>
                <a:lnTo>
                  <a:pt x="2173" y="549"/>
                </a:lnTo>
                <a:lnTo>
                  <a:pt x="2194" y="554"/>
                </a:lnTo>
                <a:lnTo>
                  <a:pt x="2215" y="559"/>
                </a:lnTo>
                <a:lnTo>
                  <a:pt x="2235" y="565"/>
                </a:lnTo>
                <a:lnTo>
                  <a:pt x="2256" y="570"/>
                </a:lnTo>
                <a:lnTo>
                  <a:pt x="2277" y="575"/>
                </a:lnTo>
                <a:lnTo>
                  <a:pt x="2297" y="580"/>
                </a:lnTo>
                <a:lnTo>
                  <a:pt x="2318" y="586"/>
                </a:lnTo>
                <a:lnTo>
                  <a:pt x="2339" y="591"/>
                </a:lnTo>
                <a:lnTo>
                  <a:pt x="2359" y="596"/>
                </a:lnTo>
                <a:lnTo>
                  <a:pt x="2380" y="601"/>
                </a:lnTo>
                <a:lnTo>
                  <a:pt x="2401" y="606"/>
                </a:lnTo>
                <a:lnTo>
                  <a:pt x="2422" y="612"/>
                </a:lnTo>
                <a:lnTo>
                  <a:pt x="2442" y="617"/>
                </a:lnTo>
                <a:lnTo>
                  <a:pt x="2463" y="622"/>
                </a:lnTo>
                <a:lnTo>
                  <a:pt x="2484" y="627"/>
                </a:lnTo>
                <a:lnTo>
                  <a:pt x="2504" y="633"/>
                </a:lnTo>
                <a:lnTo>
                  <a:pt x="2525" y="638"/>
                </a:lnTo>
                <a:lnTo>
                  <a:pt x="2546" y="643"/>
                </a:lnTo>
                <a:lnTo>
                  <a:pt x="2566" y="648"/>
                </a:lnTo>
                <a:lnTo>
                  <a:pt x="2587" y="654"/>
                </a:lnTo>
                <a:lnTo>
                  <a:pt x="2608" y="659"/>
                </a:lnTo>
                <a:lnTo>
                  <a:pt x="2629" y="664"/>
                </a:lnTo>
                <a:lnTo>
                  <a:pt x="2649" y="669"/>
                </a:lnTo>
                <a:lnTo>
                  <a:pt x="2670" y="674"/>
                </a:lnTo>
                <a:lnTo>
                  <a:pt x="2691" y="680"/>
                </a:lnTo>
                <a:lnTo>
                  <a:pt x="2711" y="685"/>
                </a:lnTo>
                <a:lnTo>
                  <a:pt x="2732" y="690"/>
                </a:lnTo>
                <a:lnTo>
                  <a:pt x="2753" y="695"/>
                </a:lnTo>
                <a:lnTo>
                  <a:pt x="2773" y="701"/>
                </a:lnTo>
                <a:lnTo>
                  <a:pt x="2794" y="706"/>
                </a:lnTo>
                <a:lnTo>
                  <a:pt x="2815" y="711"/>
                </a:lnTo>
                <a:lnTo>
                  <a:pt x="2836" y="716"/>
                </a:lnTo>
                <a:lnTo>
                  <a:pt x="2856" y="722"/>
                </a:lnTo>
                <a:lnTo>
                  <a:pt x="2877" y="727"/>
                </a:lnTo>
                <a:lnTo>
                  <a:pt x="2898" y="732"/>
                </a:lnTo>
                <a:lnTo>
                  <a:pt x="2918" y="737"/>
                </a:lnTo>
                <a:lnTo>
                  <a:pt x="2939" y="742"/>
                </a:lnTo>
                <a:lnTo>
                  <a:pt x="2960" y="748"/>
                </a:lnTo>
                <a:lnTo>
                  <a:pt x="2980" y="753"/>
                </a:lnTo>
                <a:lnTo>
                  <a:pt x="3001" y="758"/>
                </a:lnTo>
                <a:lnTo>
                  <a:pt x="3022" y="763"/>
                </a:lnTo>
                <a:lnTo>
                  <a:pt x="3043" y="769"/>
                </a:lnTo>
                <a:lnTo>
                  <a:pt x="3063" y="774"/>
                </a:lnTo>
                <a:lnTo>
                  <a:pt x="3084" y="779"/>
                </a:lnTo>
                <a:lnTo>
                  <a:pt x="3105" y="784"/>
                </a:lnTo>
                <a:lnTo>
                  <a:pt x="3125" y="790"/>
                </a:lnTo>
                <a:lnTo>
                  <a:pt x="3146" y="795"/>
                </a:lnTo>
                <a:lnTo>
                  <a:pt x="3167" y="800"/>
                </a:lnTo>
                <a:lnTo>
                  <a:pt x="3188" y="805"/>
                </a:lnTo>
                <a:lnTo>
                  <a:pt x="3208" y="810"/>
                </a:lnTo>
                <a:lnTo>
                  <a:pt x="3229" y="816"/>
                </a:lnTo>
                <a:lnTo>
                  <a:pt x="3250" y="821"/>
                </a:lnTo>
                <a:lnTo>
                  <a:pt x="3270" y="826"/>
                </a:lnTo>
                <a:lnTo>
                  <a:pt x="3291" y="831"/>
                </a:lnTo>
                <a:lnTo>
                  <a:pt x="3312" y="837"/>
                </a:lnTo>
                <a:lnTo>
                  <a:pt x="3332" y="842"/>
                </a:lnTo>
                <a:lnTo>
                  <a:pt x="3353" y="847"/>
                </a:lnTo>
                <a:lnTo>
                  <a:pt x="3374" y="852"/>
                </a:lnTo>
                <a:lnTo>
                  <a:pt x="3395" y="858"/>
                </a:lnTo>
                <a:lnTo>
                  <a:pt x="3415" y="863"/>
                </a:lnTo>
                <a:lnTo>
                  <a:pt x="3436" y="868"/>
                </a:lnTo>
                <a:lnTo>
                  <a:pt x="3457" y="873"/>
                </a:lnTo>
                <a:lnTo>
                  <a:pt x="3477" y="878"/>
                </a:lnTo>
                <a:lnTo>
                  <a:pt x="3498" y="884"/>
                </a:lnTo>
                <a:lnTo>
                  <a:pt x="3519" y="889"/>
                </a:lnTo>
                <a:lnTo>
                  <a:pt x="3539" y="894"/>
                </a:lnTo>
                <a:lnTo>
                  <a:pt x="3560" y="899"/>
                </a:lnTo>
                <a:lnTo>
                  <a:pt x="3581" y="905"/>
                </a:lnTo>
                <a:lnTo>
                  <a:pt x="3602" y="910"/>
                </a:lnTo>
                <a:lnTo>
                  <a:pt x="3622" y="915"/>
                </a:lnTo>
                <a:lnTo>
                  <a:pt x="3643" y="920"/>
                </a:lnTo>
                <a:lnTo>
                  <a:pt x="3664" y="926"/>
                </a:lnTo>
                <a:lnTo>
                  <a:pt x="3684" y="931"/>
                </a:lnTo>
                <a:lnTo>
                  <a:pt x="3705" y="936"/>
                </a:lnTo>
                <a:lnTo>
                  <a:pt x="3726" y="941"/>
                </a:lnTo>
                <a:lnTo>
                  <a:pt x="3746" y="946"/>
                </a:lnTo>
                <a:lnTo>
                  <a:pt x="3767" y="952"/>
                </a:lnTo>
                <a:lnTo>
                  <a:pt x="3788" y="957"/>
                </a:lnTo>
                <a:lnTo>
                  <a:pt x="3809" y="962"/>
                </a:lnTo>
                <a:lnTo>
                  <a:pt x="3829" y="967"/>
                </a:lnTo>
                <a:lnTo>
                  <a:pt x="3850" y="973"/>
                </a:lnTo>
                <a:lnTo>
                  <a:pt x="3871" y="978"/>
                </a:lnTo>
                <a:lnTo>
                  <a:pt x="3891" y="983"/>
                </a:lnTo>
                <a:lnTo>
                  <a:pt x="3912" y="988"/>
                </a:lnTo>
                <a:lnTo>
                  <a:pt x="3933" y="994"/>
                </a:lnTo>
                <a:lnTo>
                  <a:pt x="3953" y="999"/>
                </a:lnTo>
                <a:lnTo>
                  <a:pt x="3974" y="1004"/>
                </a:lnTo>
                <a:lnTo>
                  <a:pt x="3995" y="1009"/>
                </a:lnTo>
                <a:lnTo>
                  <a:pt x="4016" y="1014"/>
                </a:lnTo>
                <a:lnTo>
                  <a:pt x="4036" y="1020"/>
                </a:lnTo>
                <a:lnTo>
                  <a:pt x="4057" y="1025"/>
                </a:lnTo>
                <a:lnTo>
                  <a:pt x="4078" y="1030"/>
                </a:lnTo>
                <a:lnTo>
                  <a:pt x="4098" y="1035"/>
                </a:lnTo>
                <a:lnTo>
                  <a:pt x="4119" y="1041"/>
                </a:lnTo>
                <a:lnTo>
                  <a:pt x="4140" y="1046"/>
                </a:lnTo>
                <a:lnTo>
                  <a:pt x="4160" y="1051"/>
                </a:lnTo>
                <a:lnTo>
                  <a:pt x="4181" y="1056"/>
                </a:lnTo>
                <a:lnTo>
                  <a:pt x="4202" y="1062"/>
                </a:lnTo>
                <a:lnTo>
                  <a:pt x="4223" y="1067"/>
                </a:lnTo>
                <a:lnTo>
                  <a:pt x="4243" y="1072"/>
                </a:lnTo>
                <a:lnTo>
                  <a:pt x="4264" y="1077"/>
                </a:lnTo>
                <a:lnTo>
                  <a:pt x="4285" y="1082"/>
                </a:lnTo>
                <a:lnTo>
                  <a:pt x="4305" y="1088"/>
                </a:lnTo>
                <a:lnTo>
                  <a:pt x="4326" y="1093"/>
                </a:lnTo>
                <a:lnTo>
                  <a:pt x="4347" y="1098"/>
                </a:lnTo>
                <a:lnTo>
                  <a:pt x="4367" y="1103"/>
                </a:lnTo>
                <a:lnTo>
                  <a:pt x="4388" y="1109"/>
                </a:lnTo>
                <a:lnTo>
                  <a:pt x="4409" y="1114"/>
                </a:lnTo>
                <a:lnTo>
                  <a:pt x="4430" y="1119"/>
                </a:lnTo>
                <a:lnTo>
                  <a:pt x="4450" y="1124"/>
                </a:lnTo>
                <a:lnTo>
                  <a:pt x="4471" y="1130"/>
                </a:lnTo>
                <a:lnTo>
                  <a:pt x="4492" y="1135"/>
                </a:lnTo>
                <a:lnTo>
                  <a:pt x="4512" y="1140"/>
                </a:lnTo>
                <a:lnTo>
                  <a:pt x="4533" y="1145"/>
                </a:lnTo>
                <a:lnTo>
                  <a:pt x="4554" y="1150"/>
                </a:lnTo>
                <a:lnTo>
                  <a:pt x="4574" y="1156"/>
                </a:lnTo>
                <a:lnTo>
                  <a:pt x="4595" y="1161"/>
                </a:lnTo>
                <a:lnTo>
                  <a:pt x="4616" y="1166"/>
                </a:lnTo>
                <a:lnTo>
                  <a:pt x="4637" y="1171"/>
                </a:lnTo>
                <a:lnTo>
                  <a:pt x="4657" y="1177"/>
                </a:lnTo>
                <a:lnTo>
                  <a:pt x="4678" y="1182"/>
                </a:lnTo>
                <a:lnTo>
                  <a:pt x="4699" y="1187"/>
                </a:lnTo>
                <a:lnTo>
                  <a:pt x="4719" y="1192"/>
                </a:lnTo>
                <a:lnTo>
                  <a:pt x="4740" y="1198"/>
                </a:lnTo>
                <a:lnTo>
                  <a:pt x="4761" y="1203"/>
                </a:lnTo>
                <a:lnTo>
                  <a:pt x="4782" y="1208"/>
                </a:lnTo>
                <a:lnTo>
                  <a:pt x="4802" y="1213"/>
                </a:lnTo>
                <a:lnTo>
                  <a:pt x="4823" y="1218"/>
                </a:lnTo>
                <a:lnTo>
                  <a:pt x="4844" y="1224"/>
                </a:lnTo>
                <a:lnTo>
                  <a:pt x="4864" y="1229"/>
                </a:lnTo>
                <a:lnTo>
                  <a:pt x="4885" y="1234"/>
                </a:lnTo>
                <a:lnTo>
                  <a:pt x="4906" y="1239"/>
                </a:lnTo>
              </a:path>
            </a:pathLst>
          </a:cu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103" name="Line 60"/>
          <p:cNvSpPr>
            <a:spLocks noChangeShapeType="1"/>
          </p:cNvSpPr>
          <p:nvPr/>
        </p:nvSpPr>
        <p:spPr bwMode="auto">
          <a:xfrm flipV="1">
            <a:off x="6640513" y="4772174"/>
            <a:ext cx="14288" cy="3175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104" name="Freeform 61"/>
          <p:cNvSpPr>
            <a:spLocks/>
          </p:cNvSpPr>
          <p:nvPr/>
        </p:nvSpPr>
        <p:spPr bwMode="auto">
          <a:xfrm flipV="1">
            <a:off x="2160588" y="3983186"/>
            <a:ext cx="4479925" cy="1989138"/>
          </a:xfrm>
          <a:custGeom>
            <a:avLst/>
            <a:gdLst>
              <a:gd name="T0" fmla="*/ 62 w 4906"/>
              <a:gd name="T1" fmla="*/ 27 h 2170"/>
              <a:gd name="T2" fmla="*/ 144 w 4906"/>
              <a:gd name="T3" fmla="*/ 64 h 2170"/>
              <a:gd name="T4" fmla="*/ 227 w 4906"/>
              <a:gd name="T5" fmla="*/ 100 h 2170"/>
              <a:gd name="T6" fmla="*/ 310 w 4906"/>
              <a:gd name="T7" fmla="*/ 137 h 2170"/>
              <a:gd name="T8" fmla="*/ 393 w 4906"/>
              <a:gd name="T9" fmla="*/ 174 h 2170"/>
              <a:gd name="T10" fmla="*/ 476 w 4906"/>
              <a:gd name="T11" fmla="*/ 210 h 2170"/>
              <a:gd name="T12" fmla="*/ 558 w 4906"/>
              <a:gd name="T13" fmla="*/ 247 h 2170"/>
              <a:gd name="T14" fmla="*/ 641 w 4906"/>
              <a:gd name="T15" fmla="*/ 283 h 2170"/>
              <a:gd name="T16" fmla="*/ 724 w 4906"/>
              <a:gd name="T17" fmla="*/ 320 h 2170"/>
              <a:gd name="T18" fmla="*/ 807 w 4906"/>
              <a:gd name="T19" fmla="*/ 357 h 2170"/>
              <a:gd name="T20" fmla="*/ 890 w 4906"/>
              <a:gd name="T21" fmla="*/ 393 h 2170"/>
              <a:gd name="T22" fmla="*/ 972 w 4906"/>
              <a:gd name="T23" fmla="*/ 430 h 2170"/>
              <a:gd name="T24" fmla="*/ 1055 w 4906"/>
              <a:gd name="T25" fmla="*/ 467 h 2170"/>
              <a:gd name="T26" fmla="*/ 1138 w 4906"/>
              <a:gd name="T27" fmla="*/ 503 h 2170"/>
              <a:gd name="T28" fmla="*/ 1221 w 4906"/>
              <a:gd name="T29" fmla="*/ 540 h 2170"/>
              <a:gd name="T30" fmla="*/ 1304 w 4906"/>
              <a:gd name="T31" fmla="*/ 576 h 2170"/>
              <a:gd name="T32" fmla="*/ 1386 w 4906"/>
              <a:gd name="T33" fmla="*/ 613 h 2170"/>
              <a:gd name="T34" fmla="*/ 1469 w 4906"/>
              <a:gd name="T35" fmla="*/ 650 h 2170"/>
              <a:gd name="T36" fmla="*/ 1552 w 4906"/>
              <a:gd name="T37" fmla="*/ 686 h 2170"/>
              <a:gd name="T38" fmla="*/ 1635 w 4906"/>
              <a:gd name="T39" fmla="*/ 723 h 2170"/>
              <a:gd name="T40" fmla="*/ 1718 w 4906"/>
              <a:gd name="T41" fmla="*/ 760 h 2170"/>
              <a:gd name="T42" fmla="*/ 1801 w 4906"/>
              <a:gd name="T43" fmla="*/ 796 h 2170"/>
              <a:gd name="T44" fmla="*/ 1883 w 4906"/>
              <a:gd name="T45" fmla="*/ 833 h 2170"/>
              <a:gd name="T46" fmla="*/ 1966 w 4906"/>
              <a:gd name="T47" fmla="*/ 869 h 2170"/>
              <a:gd name="T48" fmla="*/ 2049 w 4906"/>
              <a:gd name="T49" fmla="*/ 906 h 2170"/>
              <a:gd name="T50" fmla="*/ 2132 w 4906"/>
              <a:gd name="T51" fmla="*/ 943 h 2170"/>
              <a:gd name="T52" fmla="*/ 2215 w 4906"/>
              <a:gd name="T53" fmla="*/ 979 h 2170"/>
              <a:gd name="T54" fmla="*/ 2297 w 4906"/>
              <a:gd name="T55" fmla="*/ 1016 h 2170"/>
              <a:gd name="T56" fmla="*/ 2380 w 4906"/>
              <a:gd name="T57" fmla="*/ 1053 h 2170"/>
              <a:gd name="T58" fmla="*/ 2463 w 4906"/>
              <a:gd name="T59" fmla="*/ 1089 h 2170"/>
              <a:gd name="T60" fmla="*/ 2546 w 4906"/>
              <a:gd name="T61" fmla="*/ 1126 h 2170"/>
              <a:gd name="T62" fmla="*/ 2629 w 4906"/>
              <a:gd name="T63" fmla="*/ 1162 h 2170"/>
              <a:gd name="T64" fmla="*/ 2711 w 4906"/>
              <a:gd name="T65" fmla="*/ 1199 h 2170"/>
              <a:gd name="T66" fmla="*/ 2794 w 4906"/>
              <a:gd name="T67" fmla="*/ 1236 h 2170"/>
              <a:gd name="T68" fmla="*/ 2877 w 4906"/>
              <a:gd name="T69" fmla="*/ 1272 h 2170"/>
              <a:gd name="T70" fmla="*/ 2960 w 4906"/>
              <a:gd name="T71" fmla="*/ 1309 h 2170"/>
              <a:gd name="T72" fmla="*/ 3043 w 4906"/>
              <a:gd name="T73" fmla="*/ 1346 h 2170"/>
              <a:gd name="T74" fmla="*/ 3125 w 4906"/>
              <a:gd name="T75" fmla="*/ 1382 h 2170"/>
              <a:gd name="T76" fmla="*/ 3208 w 4906"/>
              <a:gd name="T77" fmla="*/ 1419 h 2170"/>
              <a:gd name="T78" fmla="*/ 3291 w 4906"/>
              <a:gd name="T79" fmla="*/ 1455 h 2170"/>
              <a:gd name="T80" fmla="*/ 3374 w 4906"/>
              <a:gd name="T81" fmla="*/ 1492 h 2170"/>
              <a:gd name="T82" fmla="*/ 3457 w 4906"/>
              <a:gd name="T83" fmla="*/ 1529 h 2170"/>
              <a:gd name="T84" fmla="*/ 3539 w 4906"/>
              <a:gd name="T85" fmla="*/ 1565 h 2170"/>
              <a:gd name="T86" fmla="*/ 3622 w 4906"/>
              <a:gd name="T87" fmla="*/ 1602 h 2170"/>
              <a:gd name="T88" fmla="*/ 3705 w 4906"/>
              <a:gd name="T89" fmla="*/ 1639 h 2170"/>
              <a:gd name="T90" fmla="*/ 3788 w 4906"/>
              <a:gd name="T91" fmla="*/ 1675 h 2170"/>
              <a:gd name="T92" fmla="*/ 3871 w 4906"/>
              <a:gd name="T93" fmla="*/ 1712 h 2170"/>
              <a:gd name="T94" fmla="*/ 3953 w 4906"/>
              <a:gd name="T95" fmla="*/ 1748 h 2170"/>
              <a:gd name="T96" fmla="*/ 4036 w 4906"/>
              <a:gd name="T97" fmla="*/ 1785 h 2170"/>
              <a:gd name="T98" fmla="*/ 4119 w 4906"/>
              <a:gd name="T99" fmla="*/ 1822 h 2170"/>
              <a:gd name="T100" fmla="*/ 4202 w 4906"/>
              <a:gd name="T101" fmla="*/ 1858 h 2170"/>
              <a:gd name="T102" fmla="*/ 4285 w 4906"/>
              <a:gd name="T103" fmla="*/ 1895 h 2170"/>
              <a:gd name="T104" fmla="*/ 4367 w 4906"/>
              <a:gd name="T105" fmla="*/ 1932 h 2170"/>
              <a:gd name="T106" fmla="*/ 4450 w 4906"/>
              <a:gd name="T107" fmla="*/ 1968 h 2170"/>
              <a:gd name="T108" fmla="*/ 4533 w 4906"/>
              <a:gd name="T109" fmla="*/ 2005 h 2170"/>
              <a:gd name="T110" fmla="*/ 4616 w 4906"/>
              <a:gd name="T111" fmla="*/ 2041 h 2170"/>
              <a:gd name="T112" fmla="*/ 4699 w 4906"/>
              <a:gd name="T113" fmla="*/ 2078 h 2170"/>
              <a:gd name="T114" fmla="*/ 4782 w 4906"/>
              <a:gd name="T115" fmla="*/ 2115 h 2170"/>
              <a:gd name="T116" fmla="*/ 4864 w 4906"/>
              <a:gd name="T117" fmla="*/ 2151 h 21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4906" h="2170">
                <a:moveTo>
                  <a:pt x="0" y="0"/>
                </a:moveTo>
                <a:lnTo>
                  <a:pt x="20" y="9"/>
                </a:lnTo>
                <a:lnTo>
                  <a:pt x="41" y="18"/>
                </a:lnTo>
                <a:lnTo>
                  <a:pt x="62" y="27"/>
                </a:lnTo>
                <a:lnTo>
                  <a:pt x="82" y="36"/>
                </a:lnTo>
                <a:lnTo>
                  <a:pt x="103" y="45"/>
                </a:lnTo>
                <a:lnTo>
                  <a:pt x="124" y="55"/>
                </a:lnTo>
                <a:lnTo>
                  <a:pt x="144" y="64"/>
                </a:lnTo>
                <a:lnTo>
                  <a:pt x="165" y="73"/>
                </a:lnTo>
                <a:lnTo>
                  <a:pt x="186" y="82"/>
                </a:lnTo>
                <a:lnTo>
                  <a:pt x="207" y="91"/>
                </a:lnTo>
                <a:lnTo>
                  <a:pt x="227" y="100"/>
                </a:lnTo>
                <a:lnTo>
                  <a:pt x="248" y="109"/>
                </a:lnTo>
                <a:lnTo>
                  <a:pt x="269" y="119"/>
                </a:lnTo>
                <a:lnTo>
                  <a:pt x="289" y="128"/>
                </a:lnTo>
                <a:lnTo>
                  <a:pt x="310" y="137"/>
                </a:lnTo>
                <a:lnTo>
                  <a:pt x="331" y="146"/>
                </a:lnTo>
                <a:lnTo>
                  <a:pt x="351" y="155"/>
                </a:lnTo>
                <a:lnTo>
                  <a:pt x="372" y="164"/>
                </a:lnTo>
                <a:lnTo>
                  <a:pt x="393" y="174"/>
                </a:lnTo>
                <a:lnTo>
                  <a:pt x="414" y="183"/>
                </a:lnTo>
                <a:lnTo>
                  <a:pt x="434" y="192"/>
                </a:lnTo>
                <a:lnTo>
                  <a:pt x="455" y="201"/>
                </a:lnTo>
                <a:lnTo>
                  <a:pt x="476" y="210"/>
                </a:lnTo>
                <a:lnTo>
                  <a:pt x="496" y="219"/>
                </a:lnTo>
                <a:lnTo>
                  <a:pt x="517" y="228"/>
                </a:lnTo>
                <a:lnTo>
                  <a:pt x="538" y="238"/>
                </a:lnTo>
                <a:lnTo>
                  <a:pt x="558" y="247"/>
                </a:lnTo>
                <a:lnTo>
                  <a:pt x="579" y="256"/>
                </a:lnTo>
                <a:lnTo>
                  <a:pt x="600" y="265"/>
                </a:lnTo>
                <a:lnTo>
                  <a:pt x="621" y="274"/>
                </a:lnTo>
                <a:lnTo>
                  <a:pt x="641" y="283"/>
                </a:lnTo>
                <a:lnTo>
                  <a:pt x="662" y="293"/>
                </a:lnTo>
                <a:lnTo>
                  <a:pt x="683" y="302"/>
                </a:lnTo>
                <a:lnTo>
                  <a:pt x="703" y="311"/>
                </a:lnTo>
                <a:lnTo>
                  <a:pt x="724" y="320"/>
                </a:lnTo>
                <a:lnTo>
                  <a:pt x="745" y="329"/>
                </a:lnTo>
                <a:lnTo>
                  <a:pt x="765" y="338"/>
                </a:lnTo>
                <a:lnTo>
                  <a:pt x="786" y="348"/>
                </a:lnTo>
                <a:lnTo>
                  <a:pt x="807" y="357"/>
                </a:lnTo>
                <a:lnTo>
                  <a:pt x="828" y="366"/>
                </a:lnTo>
                <a:lnTo>
                  <a:pt x="848" y="375"/>
                </a:lnTo>
                <a:lnTo>
                  <a:pt x="869" y="384"/>
                </a:lnTo>
                <a:lnTo>
                  <a:pt x="890" y="393"/>
                </a:lnTo>
                <a:lnTo>
                  <a:pt x="910" y="402"/>
                </a:lnTo>
                <a:lnTo>
                  <a:pt x="931" y="412"/>
                </a:lnTo>
                <a:lnTo>
                  <a:pt x="952" y="421"/>
                </a:lnTo>
                <a:lnTo>
                  <a:pt x="972" y="430"/>
                </a:lnTo>
                <a:lnTo>
                  <a:pt x="993" y="439"/>
                </a:lnTo>
                <a:lnTo>
                  <a:pt x="1014" y="448"/>
                </a:lnTo>
                <a:lnTo>
                  <a:pt x="1035" y="457"/>
                </a:lnTo>
                <a:lnTo>
                  <a:pt x="1055" y="467"/>
                </a:lnTo>
                <a:lnTo>
                  <a:pt x="1076" y="476"/>
                </a:lnTo>
                <a:lnTo>
                  <a:pt x="1097" y="485"/>
                </a:lnTo>
                <a:lnTo>
                  <a:pt x="1117" y="494"/>
                </a:lnTo>
                <a:lnTo>
                  <a:pt x="1138" y="503"/>
                </a:lnTo>
                <a:lnTo>
                  <a:pt x="1159" y="512"/>
                </a:lnTo>
                <a:lnTo>
                  <a:pt x="1179" y="521"/>
                </a:lnTo>
                <a:lnTo>
                  <a:pt x="1200" y="531"/>
                </a:lnTo>
                <a:lnTo>
                  <a:pt x="1221" y="540"/>
                </a:lnTo>
                <a:lnTo>
                  <a:pt x="1242" y="549"/>
                </a:lnTo>
                <a:lnTo>
                  <a:pt x="1262" y="558"/>
                </a:lnTo>
                <a:lnTo>
                  <a:pt x="1283" y="567"/>
                </a:lnTo>
                <a:lnTo>
                  <a:pt x="1304" y="576"/>
                </a:lnTo>
                <a:lnTo>
                  <a:pt x="1324" y="586"/>
                </a:lnTo>
                <a:lnTo>
                  <a:pt x="1345" y="595"/>
                </a:lnTo>
                <a:lnTo>
                  <a:pt x="1366" y="604"/>
                </a:lnTo>
                <a:lnTo>
                  <a:pt x="1386" y="613"/>
                </a:lnTo>
                <a:lnTo>
                  <a:pt x="1407" y="622"/>
                </a:lnTo>
                <a:lnTo>
                  <a:pt x="1428" y="631"/>
                </a:lnTo>
                <a:lnTo>
                  <a:pt x="1449" y="641"/>
                </a:lnTo>
                <a:lnTo>
                  <a:pt x="1469" y="650"/>
                </a:lnTo>
                <a:lnTo>
                  <a:pt x="1490" y="659"/>
                </a:lnTo>
                <a:lnTo>
                  <a:pt x="1511" y="668"/>
                </a:lnTo>
                <a:lnTo>
                  <a:pt x="1531" y="677"/>
                </a:lnTo>
                <a:lnTo>
                  <a:pt x="1552" y="686"/>
                </a:lnTo>
                <a:lnTo>
                  <a:pt x="1573" y="695"/>
                </a:lnTo>
                <a:lnTo>
                  <a:pt x="1594" y="705"/>
                </a:lnTo>
                <a:lnTo>
                  <a:pt x="1614" y="714"/>
                </a:lnTo>
                <a:lnTo>
                  <a:pt x="1635" y="723"/>
                </a:lnTo>
                <a:lnTo>
                  <a:pt x="1656" y="732"/>
                </a:lnTo>
                <a:lnTo>
                  <a:pt x="1676" y="741"/>
                </a:lnTo>
                <a:lnTo>
                  <a:pt x="1697" y="750"/>
                </a:lnTo>
                <a:lnTo>
                  <a:pt x="1718" y="760"/>
                </a:lnTo>
                <a:lnTo>
                  <a:pt x="1738" y="769"/>
                </a:lnTo>
                <a:lnTo>
                  <a:pt x="1759" y="778"/>
                </a:lnTo>
                <a:lnTo>
                  <a:pt x="1780" y="787"/>
                </a:lnTo>
                <a:lnTo>
                  <a:pt x="1801" y="796"/>
                </a:lnTo>
                <a:lnTo>
                  <a:pt x="1821" y="805"/>
                </a:lnTo>
                <a:lnTo>
                  <a:pt x="1842" y="815"/>
                </a:lnTo>
                <a:lnTo>
                  <a:pt x="1863" y="824"/>
                </a:lnTo>
                <a:lnTo>
                  <a:pt x="1883" y="833"/>
                </a:lnTo>
                <a:lnTo>
                  <a:pt x="1904" y="842"/>
                </a:lnTo>
                <a:lnTo>
                  <a:pt x="1925" y="851"/>
                </a:lnTo>
                <a:lnTo>
                  <a:pt x="1945" y="860"/>
                </a:lnTo>
                <a:lnTo>
                  <a:pt x="1966" y="869"/>
                </a:lnTo>
                <a:lnTo>
                  <a:pt x="1987" y="879"/>
                </a:lnTo>
                <a:lnTo>
                  <a:pt x="2008" y="888"/>
                </a:lnTo>
                <a:lnTo>
                  <a:pt x="2028" y="897"/>
                </a:lnTo>
                <a:lnTo>
                  <a:pt x="2049" y="906"/>
                </a:lnTo>
                <a:lnTo>
                  <a:pt x="2070" y="915"/>
                </a:lnTo>
                <a:lnTo>
                  <a:pt x="2090" y="924"/>
                </a:lnTo>
                <a:lnTo>
                  <a:pt x="2111" y="934"/>
                </a:lnTo>
                <a:lnTo>
                  <a:pt x="2132" y="943"/>
                </a:lnTo>
                <a:lnTo>
                  <a:pt x="2152" y="952"/>
                </a:lnTo>
                <a:lnTo>
                  <a:pt x="2173" y="961"/>
                </a:lnTo>
                <a:lnTo>
                  <a:pt x="2194" y="970"/>
                </a:lnTo>
                <a:lnTo>
                  <a:pt x="2215" y="979"/>
                </a:lnTo>
                <a:lnTo>
                  <a:pt x="2235" y="988"/>
                </a:lnTo>
                <a:lnTo>
                  <a:pt x="2256" y="998"/>
                </a:lnTo>
                <a:lnTo>
                  <a:pt x="2277" y="1007"/>
                </a:lnTo>
                <a:lnTo>
                  <a:pt x="2297" y="1016"/>
                </a:lnTo>
                <a:lnTo>
                  <a:pt x="2318" y="1025"/>
                </a:lnTo>
                <a:lnTo>
                  <a:pt x="2339" y="1034"/>
                </a:lnTo>
                <a:lnTo>
                  <a:pt x="2359" y="1043"/>
                </a:lnTo>
                <a:lnTo>
                  <a:pt x="2380" y="1053"/>
                </a:lnTo>
                <a:lnTo>
                  <a:pt x="2401" y="1062"/>
                </a:lnTo>
                <a:lnTo>
                  <a:pt x="2422" y="1071"/>
                </a:lnTo>
                <a:lnTo>
                  <a:pt x="2442" y="1080"/>
                </a:lnTo>
                <a:lnTo>
                  <a:pt x="2463" y="1089"/>
                </a:lnTo>
                <a:lnTo>
                  <a:pt x="2484" y="1098"/>
                </a:lnTo>
                <a:lnTo>
                  <a:pt x="2504" y="1108"/>
                </a:lnTo>
                <a:lnTo>
                  <a:pt x="2525" y="1117"/>
                </a:lnTo>
                <a:lnTo>
                  <a:pt x="2546" y="1126"/>
                </a:lnTo>
                <a:lnTo>
                  <a:pt x="2566" y="1135"/>
                </a:lnTo>
                <a:lnTo>
                  <a:pt x="2587" y="1144"/>
                </a:lnTo>
                <a:lnTo>
                  <a:pt x="2608" y="1153"/>
                </a:lnTo>
                <a:lnTo>
                  <a:pt x="2629" y="1162"/>
                </a:lnTo>
                <a:lnTo>
                  <a:pt x="2649" y="1172"/>
                </a:lnTo>
                <a:lnTo>
                  <a:pt x="2670" y="1181"/>
                </a:lnTo>
                <a:lnTo>
                  <a:pt x="2691" y="1190"/>
                </a:lnTo>
                <a:lnTo>
                  <a:pt x="2711" y="1199"/>
                </a:lnTo>
                <a:lnTo>
                  <a:pt x="2732" y="1208"/>
                </a:lnTo>
                <a:lnTo>
                  <a:pt x="2753" y="1217"/>
                </a:lnTo>
                <a:lnTo>
                  <a:pt x="2773" y="1227"/>
                </a:lnTo>
                <a:lnTo>
                  <a:pt x="2794" y="1236"/>
                </a:lnTo>
                <a:lnTo>
                  <a:pt x="2815" y="1245"/>
                </a:lnTo>
                <a:lnTo>
                  <a:pt x="2836" y="1254"/>
                </a:lnTo>
                <a:lnTo>
                  <a:pt x="2856" y="1263"/>
                </a:lnTo>
                <a:lnTo>
                  <a:pt x="2877" y="1272"/>
                </a:lnTo>
                <a:lnTo>
                  <a:pt x="2898" y="1281"/>
                </a:lnTo>
                <a:lnTo>
                  <a:pt x="2918" y="1291"/>
                </a:lnTo>
                <a:lnTo>
                  <a:pt x="2939" y="1300"/>
                </a:lnTo>
                <a:lnTo>
                  <a:pt x="2960" y="1309"/>
                </a:lnTo>
                <a:lnTo>
                  <a:pt x="2980" y="1318"/>
                </a:lnTo>
                <a:lnTo>
                  <a:pt x="3001" y="1327"/>
                </a:lnTo>
                <a:lnTo>
                  <a:pt x="3022" y="1336"/>
                </a:lnTo>
                <a:lnTo>
                  <a:pt x="3043" y="1346"/>
                </a:lnTo>
                <a:lnTo>
                  <a:pt x="3063" y="1355"/>
                </a:lnTo>
                <a:lnTo>
                  <a:pt x="3084" y="1364"/>
                </a:lnTo>
                <a:lnTo>
                  <a:pt x="3105" y="1373"/>
                </a:lnTo>
                <a:lnTo>
                  <a:pt x="3125" y="1382"/>
                </a:lnTo>
                <a:lnTo>
                  <a:pt x="3146" y="1391"/>
                </a:lnTo>
                <a:lnTo>
                  <a:pt x="3167" y="1401"/>
                </a:lnTo>
                <a:lnTo>
                  <a:pt x="3188" y="1410"/>
                </a:lnTo>
                <a:lnTo>
                  <a:pt x="3208" y="1419"/>
                </a:lnTo>
                <a:lnTo>
                  <a:pt x="3229" y="1428"/>
                </a:lnTo>
                <a:lnTo>
                  <a:pt x="3250" y="1437"/>
                </a:lnTo>
                <a:lnTo>
                  <a:pt x="3270" y="1446"/>
                </a:lnTo>
                <a:lnTo>
                  <a:pt x="3291" y="1455"/>
                </a:lnTo>
                <a:lnTo>
                  <a:pt x="3312" y="1465"/>
                </a:lnTo>
                <a:lnTo>
                  <a:pt x="3332" y="1474"/>
                </a:lnTo>
                <a:lnTo>
                  <a:pt x="3353" y="1483"/>
                </a:lnTo>
                <a:lnTo>
                  <a:pt x="3374" y="1492"/>
                </a:lnTo>
                <a:lnTo>
                  <a:pt x="3395" y="1501"/>
                </a:lnTo>
                <a:lnTo>
                  <a:pt x="3415" y="1510"/>
                </a:lnTo>
                <a:lnTo>
                  <a:pt x="3436" y="1520"/>
                </a:lnTo>
                <a:lnTo>
                  <a:pt x="3457" y="1529"/>
                </a:lnTo>
                <a:lnTo>
                  <a:pt x="3477" y="1538"/>
                </a:lnTo>
                <a:lnTo>
                  <a:pt x="3498" y="1547"/>
                </a:lnTo>
                <a:lnTo>
                  <a:pt x="3519" y="1556"/>
                </a:lnTo>
                <a:lnTo>
                  <a:pt x="3539" y="1565"/>
                </a:lnTo>
                <a:lnTo>
                  <a:pt x="3560" y="1575"/>
                </a:lnTo>
                <a:lnTo>
                  <a:pt x="3581" y="1584"/>
                </a:lnTo>
                <a:lnTo>
                  <a:pt x="3602" y="1593"/>
                </a:lnTo>
                <a:lnTo>
                  <a:pt x="3622" y="1602"/>
                </a:lnTo>
                <a:lnTo>
                  <a:pt x="3643" y="1611"/>
                </a:lnTo>
                <a:lnTo>
                  <a:pt x="3664" y="1620"/>
                </a:lnTo>
                <a:lnTo>
                  <a:pt x="3684" y="1629"/>
                </a:lnTo>
                <a:lnTo>
                  <a:pt x="3705" y="1639"/>
                </a:lnTo>
                <a:lnTo>
                  <a:pt x="3726" y="1648"/>
                </a:lnTo>
                <a:lnTo>
                  <a:pt x="3746" y="1657"/>
                </a:lnTo>
                <a:lnTo>
                  <a:pt x="3767" y="1666"/>
                </a:lnTo>
                <a:lnTo>
                  <a:pt x="3788" y="1675"/>
                </a:lnTo>
                <a:lnTo>
                  <a:pt x="3809" y="1684"/>
                </a:lnTo>
                <a:lnTo>
                  <a:pt x="3829" y="1694"/>
                </a:lnTo>
                <a:lnTo>
                  <a:pt x="3850" y="1703"/>
                </a:lnTo>
                <a:lnTo>
                  <a:pt x="3871" y="1712"/>
                </a:lnTo>
                <a:lnTo>
                  <a:pt x="3891" y="1721"/>
                </a:lnTo>
                <a:lnTo>
                  <a:pt x="3912" y="1730"/>
                </a:lnTo>
                <a:lnTo>
                  <a:pt x="3933" y="1739"/>
                </a:lnTo>
                <a:lnTo>
                  <a:pt x="3953" y="1748"/>
                </a:lnTo>
                <a:lnTo>
                  <a:pt x="3974" y="1758"/>
                </a:lnTo>
                <a:lnTo>
                  <a:pt x="3995" y="1767"/>
                </a:lnTo>
                <a:lnTo>
                  <a:pt x="4016" y="1776"/>
                </a:lnTo>
                <a:lnTo>
                  <a:pt x="4036" y="1785"/>
                </a:lnTo>
                <a:lnTo>
                  <a:pt x="4057" y="1794"/>
                </a:lnTo>
                <a:lnTo>
                  <a:pt x="4078" y="1803"/>
                </a:lnTo>
                <a:lnTo>
                  <a:pt x="4098" y="1813"/>
                </a:lnTo>
                <a:lnTo>
                  <a:pt x="4119" y="1822"/>
                </a:lnTo>
                <a:lnTo>
                  <a:pt x="4140" y="1831"/>
                </a:lnTo>
                <a:lnTo>
                  <a:pt x="4160" y="1840"/>
                </a:lnTo>
                <a:lnTo>
                  <a:pt x="4181" y="1849"/>
                </a:lnTo>
                <a:lnTo>
                  <a:pt x="4202" y="1858"/>
                </a:lnTo>
                <a:lnTo>
                  <a:pt x="4223" y="1868"/>
                </a:lnTo>
                <a:lnTo>
                  <a:pt x="4243" y="1877"/>
                </a:lnTo>
                <a:lnTo>
                  <a:pt x="4264" y="1886"/>
                </a:lnTo>
                <a:lnTo>
                  <a:pt x="4285" y="1895"/>
                </a:lnTo>
                <a:lnTo>
                  <a:pt x="4305" y="1904"/>
                </a:lnTo>
                <a:lnTo>
                  <a:pt x="4326" y="1913"/>
                </a:lnTo>
                <a:lnTo>
                  <a:pt x="4347" y="1922"/>
                </a:lnTo>
                <a:lnTo>
                  <a:pt x="4367" y="1932"/>
                </a:lnTo>
                <a:lnTo>
                  <a:pt x="4388" y="1941"/>
                </a:lnTo>
                <a:lnTo>
                  <a:pt x="4409" y="1950"/>
                </a:lnTo>
                <a:lnTo>
                  <a:pt x="4430" y="1959"/>
                </a:lnTo>
                <a:lnTo>
                  <a:pt x="4450" y="1968"/>
                </a:lnTo>
                <a:lnTo>
                  <a:pt x="4471" y="1977"/>
                </a:lnTo>
                <a:lnTo>
                  <a:pt x="4492" y="1987"/>
                </a:lnTo>
                <a:lnTo>
                  <a:pt x="4512" y="1996"/>
                </a:lnTo>
                <a:lnTo>
                  <a:pt x="4533" y="2005"/>
                </a:lnTo>
                <a:lnTo>
                  <a:pt x="4554" y="2014"/>
                </a:lnTo>
                <a:lnTo>
                  <a:pt x="4574" y="2023"/>
                </a:lnTo>
                <a:lnTo>
                  <a:pt x="4595" y="2032"/>
                </a:lnTo>
                <a:lnTo>
                  <a:pt x="4616" y="2041"/>
                </a:lnTo>
                <a:lnTo>
                  <a:pt x="4637" y="2051"/>
                </a:lnTo>
                <a:lnTo>
                  <a:pt x="4657" y="2060"/>
                </a:lnTo>
                <a:lnTo>
                  <a:pt x="4678" y="2069"/>
                </a:lnTo>
                <a:lnTo>
                  <a:pt x="4699" y="2078"/>
                </a:lnTo>
                <a:lnTo>
                  <a:pt x="4719" y="2087"/>
                </a:lnTo>
                <a:lnTo>
                  <a:pt x="4740" y="2096"/>
                </a:lnTo>
                <a:lnTo>
                  <a:pt x="4761" y="2106"/>
                </a:lnTo>
                <a:lnTo>
                  <a:pt x="4782" y="2115"/>
                </a:lnTo>
                <a:lnTo>
                  <a:pt x="4802" y="2124"/>
                </a:lnTo>
                <a:lnTo>
                  <a:pt x="4823" y="2133"/>
                </a:lnTo>
                <a:lnTo>
                  <a:pt x="4844" y="2142"/>
                </a:lnTo>
                <a:lnTo>
                  <a:pt x="4864" y="2151"/>
                </a:lnTo>
                <a:lnTo>
                  <a:pt x="4885" y="2161"/>
                </a:lnTo>
                <a:lnTo>
                  <a:pt x="4906" y="2170"/>
                </a:lnTo>
              </a:path>
            </a:pathLst>
          </a:cu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105" name="Line 62"/>
          <p:cNvSpPr>
            <a:spLocks noChangeShapeType="1"/>
          </p:cNvSpPr>
          <p:nvPr/>
        </p:nvSpPr>
        <p:spPr bwMode="auto">
          <a:xfrm flipV="1">
            <a:off x="6640513" y="3978424"/>
            <a:ext cx="14288" cy="4763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106" name="Line 63"/>
          <p:cNvSpPr>
            <a:spLocks noChangeShapeType="1"/>
          </p:cNvSpPr>
          <p:nvPr/>
        </p:nvSpPr>
        <p:spPr bwMode="auto">
          <a:xfrm flipV="1">
            <a:off x="2205038" y="6074945"/>
            <a:ext cx="12700" cy="9525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107" name="Freeform 64"/>
          <p:cNvSpPr>
            <a:spLocks/>
          </p:cNvSpPr>
          <p:nvPr/>
        </p:nvSpPr>
        <p:spPr bwMode="auto">
          <a:xfrm flipV="1">
            <a:off x="2217738" y="2808436"/>
            <a:ext cx="4233863" cy="3230563"/>
          </a:xfrm>
          <a:custGeom>
            <a:avLst/>
            <a:gdLst>
              <a:gd name="T0" fmla="*/ 62 w 4637"/>
              <a:gd name="T1" fmla="*/ 47 h 3528"/>
              <a:gd name="T2" fmla="*/ 145 w 4637"/>
              <a:gd name="T3" fmla="*/ 110 h 3528"/>
              <a:gd name="T4" fmla="*/ 227 w 4637"/>
              <a:gd name="T5" fmla="*/ 173 h 3528"/>
              <a:gd name="T6" fmla="*/ 310 w 4637"/>
              <a:gd name="T7" fmla="*/ 236 h 3528"/>
              <a:gd name="T8" fmla="*/ 393 w 4637"/>
              <a:gd name="T9" fmla="*/ 299 h 3528"/>
              <a:gd name="T10" fmla="*/ 476 w 4637"/>
              <a:gd name="T11" fmla="*/ 362 h 3528"/>
              <a:gd name="T12" fmla="*/ 559 w 4637"/>
              <a:gd name="T13" fmla="*/ 425 h 3528"/>
              <a:gd name="T14" fmla="*/ 641 w 4637"/>
              <a:gd name="T15" fmla="*/ 488 h 3528"/>
              <a:gd name="T16" fmla="*/ 724 w 4637"/>
              <a:gd name="T17" fmla="*/ 551 h 3528"/>
              <a:gd name="T18" fmla="*/ 807 w 4637"/>
              <a:gd name="T19" fmla="*/ 614 h 3528"/>
              <a:gd name="T20" fmla="*/ 890 w 4637"/>
              <a:gd name="T21" fmla="*/ 677 h 3528"/>
              <a:gd name="T22" fmla="*/ 973 w 4637"/>
              <a:gd name="T23" fmla="*/ 740 h 3528"/>
              <a:gd name="T24" fmla="*/ 1055 w 4637"/>
              <a:gd name="T25" fmla="*/ 803 h 3528"/>
              <a:gd name="T26" fmla="*/ 1138 w 4637"/>
              <a:gd name="T27" fmla="*/ 866 h 3528"/>
              <a:gd name="T28" fmla="*/ 1221 w 4637"/>
              <a:gd name="T29" fmla="*/ 929 h 3528"/>
              <a:gd name="T30" fmla="*/ 1304 w 4637"/>
              <a:gd name="T31" fmla="*/ 992 h 3528"/>
              <a:gd name="T32" fmla="*/ 1387 w 4637"/>
              <a:gd name="T33" fmla="*/ 1055 h 3528"/>
              <a:gd name="T34" fmla="*/ 1469 w 4637"/>
              <a:gd name="T35" fmla="*/ 1118 h 3528"/>
              <a:gd name="T36" fmla="*/ 1552 w 4637"/>
              <a:gd name="T37" fmla="*/ 1181 h 3528"/>
              <a:gd name="T38" fmla="*/ 1635 w 4637"/>
              <a:gd name="T39" fmla="*/ 1244 h 3528"/>
              <a:gd name="T40" fmla="*/ 1718 w 4637"/>
              <a:gd name="T41" fmla="*/ 1307 h 3528"/>
              <a:gd name="T42" fmla="*/ 1801 w 4637"/>
              <a:gd name="T43" fmla="*/ 1370 h 3528"/>
              <a:gd name="T44" fmla="*/ 1883 w 4637"/>
              <a:gd name="T45" fmla="*/ 1433 h 3528"/>
              <a:gd name="T46" fmla="*/ 1966 w 4637"/>
              <a:gd name="T47" fmla="*/ 1496 h 3528"/>
              <a:gd name="T48" fmla="*/ 2049 w 4637"/>
              <a:gd name="T49" fmla="*/ 1559 h 3528"/>
              <a:gd name="T50" fmla="*/ 2132 w 4637"/>
              <a:gd name="T51" fmla="*/ 1622 h 3528"/>
              <a:gd name="T52" fmla="*/ 2215 w 4637"/>
              <a:gd name="T53" fmla="*/ 1685 h 3528"/>
              <a:gd name="T54" fmla="*/ 2297 w 4637"/>
              <a:gd name="T55" fmla="*/ 1748 h 3528"/>
              <a:gd name="T56" fmla="*/ 2380 w 4637"/>
              <a:gd name="T57" fmla="*/ 1811 h 3528"/>
              <a:gd name="T58" fmla="*/ 2463 w 4637"/>
              <a:gd name="T59" fmla="*/ 1874 h 3528"/>
              <a:gd name="T60" fmla="*/ 2546 w 4637"/>
              <a:gd name="T61" fmla="*/ 1937 h 3528"/>
              <a:gd name="T62" fmla="*/ 2629 w 4637"/>
              <a:gd name="T63" fmla="*/ 2000 h 3528"/>
              <a:gd name="T64" fmla="*/ 2711 w 4637"/>
              <a:gd name="T65" fmla="*/ 2063 h 3528"/>
              <a:gd name="T66" fmla="*/ 2794 w 4637"/>
              <a:gd name="T67" fmla="*/ 2126 h 3528"/>
              <a:gd name="T68" fmla="*/ 2877 w 4637"/>
              <a:gd name="T69" fmla="*/ 2189 h 3528"/>
              <a:gd name="T70" fmla="*/ 2960 w 4637"/>
              <a:gd name="T71" fmla="*/ 2253 h 3528"/>
              <a:gd name="T72" fmla="*/ 3043 w 4637"/>
              <a:gd name="T73" fmla="*/ 2316 h 3528"/>
              <a:gd name="T74" fmla="*/ 3126 w 4637"/>
              <a:gd name="T75" fmla="*/ 2379 h 3528"/>
              <a:gd name="T76" fmla="*/ 3208 w 4637"/>
              <a:gd name="T77" fmla="*/ 2442 h 3528"/>
              <a:gd name="T78" fmla="*/ 3291 w 4637"/>
              <a:gd name="T79" fmla="*/ 2505 h 3528"/>
              <a:gd name="T80" fmla="*/ 3374 w 4637"/>
              <a:gd name="T81" fmla="*/ 2568 h 3528"/>
              <a:gd name="T82" fmla="*/ 3457 w 4637"/>
              <a:gd name="T83" fmla="*/ 2631 h 3528"/>
              <a:gd name="T84" fmla="*/ 3540 w 4637"/>
              <a:gd name="T85" fmla="*/ 2694 h 3528"/>
              <a:gd name="T86" fmla="*/ 3622 w 4637"/>
              <a:gd name="T87" fmla="*/ 2757 h 3528"/>
              <a:gd name="T88" fmla="*/ 3705 w 4637"/>
              <a:gd name="T89" fmla="*/ 2820 h 3528"/>
              <a:gd name="T90" fmla="*/ 3788 w 4637"/>
              <a:gd name="T91" fmla="*/ 2883 h 3528"/>
              <a:gd name="T92" fmla="*/ 3871 w 4637"/>
              <a:gd name="T93" fmla="*/ 2946 h 3528"/>
              <a:gd name="T94" fmla="*/ 3954 w 4637"/>
              <a:gd name="T95" fmla="*/ 3009 h 3528"/>
              <a:gd name="T96" fmla="*/ 4036 w 4637"/>
              <a:gd name="T97" fmla="*/ 3072 h 3528"/>
              <a:gd name="T98" fmla="*/ 4119 w 4637"/>
              <a:gd name="T99" fmla="*/ 3135 h 3528"/>
              <a:gd name="T100" fmla="*/ 4202 w 4637"/>
              <a:gd name="T101" fmla="*/ 3198 h 3528"/>
              <a:gd name="T102" fmla="*/ 4285 w 4637"/>
              <a:gd name="T103" fmla="*/ 3261 h 3528"/>
              <a:gd name="T104" fmla="*/ 4368 w 4637"/>
              <a:gd name="T105" fmla="*/ 3324 h 3528"/>
              <a:gd name="T106" fmla="*/ 4450 w 4637"/>
              <a:gd name="T107" fmla="*/ 3387 h 3528"/>
              <a:gd name="T108" fmla="*/ 4533 w 4637"/>
              <a:gd name="T109" fmla="*/ 3450 h 3528"/>
              <a:gd name="T110" fmla="*/ 4616 w 4637"/>
              <a:gd name="T111" fmla="*/ 3513 h 35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4637" h="3528">
                <a:moveTo>
                  <a:pt x="0" y="0"/>
                </a:moveTo>
                <a:lnTo>
                  <a:pt x="20" y="16"/>
                </a:lnTo>
                <a:lnTo>
                  <a:pt x="41" y="31"/>
                </a:lnTo>
                <a:lnTo>
                  <a:pt x="62" y="47"/>
                </a:lnTo>
                <a:lnTo>
                  <a:pt x="82" y="63"/>
                </a:lnTo>
                <a:lnTo>
                  <a:pt x="103" y="79"/>
                </a:lnTo>
                <a:lnTo>
                  <a:pt x="124" y="94"/>
                </a:lnTo>
                <a:lnTo>
                  <a:pt x="145" y="110"/>
                </a:lnTo>
                <a:lnTo>
                  <a:pt x="165" y="126"/>
                </a:lnTo>
                <a:lnTo>
                  <a:pt x="186" y="142"/>
                </a:lnTo>
                <a:lnTo>
                  <a:pt x="207" y="157"/>
                </a:lnTo>
                <a:lnTo>
                  <a:pt x="227" y="173"/>
                </a:lnTo>
                <a:lnTo>
                  <a:pt x="248" y="189"/>
                </a:lnTo>
                <a:lnTo>
                  <a:pt x="269" y="205"/>
                </a:lnTo>
                <a:lnTo>
                  <a:pt x="289" y="220"/>
                </a:lnTo>
                <a:lnTo>
                  <a:pt x="310" y="236"/>
                </a:lnTo>
                <a:lnTo>
                  <a:pt x="331" y="252"/>
                </a:lnTo>
                <a:lnTo>
                  <a:pt x="352" y="268"/>
                </a:lnTo>
                <a:lnTo>
                  <a:pt x="372" y="283"/>
                </a:lnTo>
                <a:lnTo>
                  <a:pt x="393" y="299"/>
                </a:lnTo>
                <a:lnTo>
                  <a:pt x="414" y="315"/>
                </a:lnTo>
                <a:lnTo>
                  <a:pt x="434" y="331"/>
                </a:lnTo>
                <a:lnTo>
                  <a:pt x="455" y="347"/>
                </a:lnTo>
                <a:lnTo>
                  <a:pt x="476" y="362"/>
                </a:lnTo>
                <a:lnTo>
                  <a:pt x="496" y="378"/>
                </a:lnTo>
                <a:lnTo>
                  <a:pt x="517" y="394"/>
                </a:lnTo>
                <a:lnTo>
                  <a:pt x="538" y="410"/>
                </a:lnTo>
                <a:lnTo>
                  <a:pt x="559" y="425"/>
                </a:lnTo>
                <a:lnTo>
                  <a:pt x="579" y="441"/>
                </a:lnTo>
                <a:lnTo>
                  <a:pt x="600" y="457"/>
                </a:lnTo>
                <a:lnTo>
                  <a:pt x="621" y="473"/>
                </a:lnTo>
                <a:lnTo>
                  <a:pt x="641" y="488"/>
                </a:lnTo>
                <a:lnTo>
                  <a:pt x="662" y="504"/>
                </a:lnTo>
                <a:lnTo>
                  <a:pt x="683" y="520"/>
                </a:lnTo>
                <a:lnTo>
                  <a:pt x="703" y="536"/>
                </a:lnTo>
                <a:lnTo>
                  <a:pt x="724" y="551"/>
                </a:lnTo>
                <a:lnTo>
                  <a:pt x="745" y="567"/>
                </a:lnTo>
                <a:lnTo>
                  <a:pt x="766" y="583"/>
                </a:lnTo>
                <a:lnTo>
                  <a:pt x="786" y="599"/>
                </a:lnTo>
                <a:lnTo>
                  <a:pt x="807" y="614"/>
                </a:lnTo>
                <a:lnTo>
                  <a:pt x="828" y="630"/>
                </a:lnTo>
                <a:lnTo>
                  <a:pt x="848" y="646"/>
                </a:lnTo>
                <a:lnTo>
                  <a:pt x="869" y="662"/>
                </a:lnTo>
                <a:lnTo>
                  <a:pt x="890" y="677"/>
                </a:lnTo>
                <a:lnTo>
                  <a:pt x="910" y="693"/>
                </a:lnTo>
                <a:lnTo>
                  <a:pt x="931" y="709"/>
                </a:lnTo>
                <a:lnTo>
                  <a:pt x="952" y="725"/>
                </a:lnTo>
                <a:lnTo>
                  <a:pt x="973" y="740"/>
                </a:lnTo>
                <a:lnTo>
                  <a:pt x="993" y="756"/>
                </a:lnTo>
                <a:lnTo>
                  <a:pt x="1014" y="772"/>
                </a:lnTo>
                <a:lnTo>
                  <a:pt x="1035" y="788"/>
                </a:lnTo>
                <a:lnTo>
                  <a:pt x="1055" y="803"/>
                </a:lnTo>
                <a:lnTo>
                  <a:pt x="1076" y="819"/>
                </a:lnTo>
                <a:lnTo>
                  <a:pt x="1097" y="835"/>
                </a:lnTo>
                <a:lnTo>
                  <a:pt x="1117" y="851"/>
                </a:lnTo>
                <a:lnTo>
                  <a:pt x="1138" y="866"/>
                </a:lnTo>
                <a:lnTo>
                  <a:pt x="1159" y="882"/>
                </a:lnTo>
                <a:lnTo>
                  <a:pt x="1180" y="898"/>
                </a:lnTo>
                <a:lnTo>
                  <a:pt x="1200" y="914"/>
                </a:lnTo>
                <a:lnTo>
                  <a:pt x="1221" y="929"/>
                </a:lnTo>
                <a:lnTo>
                  <a:pt x="1242" y="945"/>
                </a:lnTo>
                <a:lnTo>
                  <a:pt x="1262" y="961"/>
                </a:lnTo>
                <a:lnTo>
                  <a:pt x="1283" y="977"/>
                </a:lnTo>
                <a:lnTo>
                  <a:pt x="1304" y="992"/>
                </a:lnTo>
                <a:lnTo>
                  <a:pt x="1324" y="1008"/>
                </a:lnTo>
                <a:lnTo>
                  <a:pt x="1345" y="1024"/>
                </a:lnTo>
                <a:lnTo>
                  <a:pt x="1366" y="1040"/>
                </a:lnTo>
                <a:lnTo>
                  <a:pt x="1387" y="1055"/>
                </a:lnTo>
                <a:lnTo>
                  <a:pt x="1407" y="1071"/>
                </a:lnTo>
                <a:lnTo>
                  <a:pt x="1428" y="1087"/>
                </a:lnTo>
                <a:lnTo>
                  <a:pt x="1449" y="1103"/>
                </a:lnTo>
                <a:lnTo>
                  <a:pt x="1469" y="1118"/>
                </a:lnTo>
                <a:lnTo>
                  <a:pt x="1490" y="1134"/>
                </a:lnTo>
                <a:lnTo>
                  <a:pt x="1511" y="1150"/>
                </a:lnTo>
                <a:lnTo>
                  <a:pt x="1532" y="1166"/>
                </a:lnTo>
                <a:lnTo>
                  <a:pt x="1552" y="1181"/>
                </a:lnTo>
                <a:lnTo>
                  <a:pt x="1573" y="1197"/>
                </a:lnTo>
                <a:lnTo>
                  <a:pt x="1594" y="1213"/>
                </a:lnTo>
                <a:lnTo>
                  <a:pt x="1614" y="1229"/>
                </a:lnTo>
                <a:lnTo>
                  <a:pt x="1635" y="1244"/>
                </a:lnTo>
                <a:lnTo>
                  <a:pt x="1656" y="1260"/>
                </a:lnTo>
                <a:lnTo>
                  <a:pt x="1676" y="1276"/>
                </a:lnTo>
                <a:lnTo>
                  <a:pt x="1697" y="1292"/>
                </a:lnTo>
                <a:lnTo>
                  <a:pt x="1718" y="1307"/>
                </a:lnTo>
                <a:lnTo>
                  <a:pt x="1739" y="1323"/>
                </a:lnTo>
                <a:lnTo>
                  <a:pt x="1759" y="1339"/>
                </a:lnTo>
                <a:lnTo>
                  <a:pt x="1780" y="1355"/>
                </a:lnTo>
                <a:lnTo>
                  <a:pt x="1801" y="1370"/>
                </a:lnTo>
                <a:lnTo>
                  <a:pt x="1821" y="1386"/>
                </a:lnTo>
                <a:lnTo>
                  <a:pt x="1842" y="1402"/>
                </a:lnTo>
                <a:lnTo>
                  <a:pt x="1863" y="1418"/>
                </a:lnTo>
                <a:lnTo>
                  <a:pt x="1883" y="1433"/>
                </a:lnTo>
                <a:lnTo>
                  <a:pt x="1904" y="1449"/>
                </a:lnTo>
                <a:lnTo>
                  <a:pt x="1925" y="1465"/>
                </a:lnTo>
                <a:lnTo>
                  <a:pt x="1946" y="1481"/>
                </a:lnTo>
                <a:lnTo>
                  <a:pt x="1966" y="1496"/>
                </a:lnTo>
                <a:lnTo>
                  <a:pt x="1987" y="1512"/>
                </a:lnTo>
                <a:lnTo>
                  <a:pt x="2008" y="1528"/>
                </a:lnTo>
                <a:lnTo>
                  <a:pt x="2028" y="1544"/>
                </a:lnTo>
                <a:lnTo>
                  <a:pt x="2049" y="1559"/>
                </a:lnTo>
                <a:lnTo>
                  <a:pt x="2070" y="1575"/>
                </a:lnTo>
                <a:lnTo>
                  <a:pt x="2090" y="1591"/>
                </a:lnTo>
                <a:lnTo>
                  <a:pt x="2111" y="1607"/>
                </a:lnTo>
                <a:lnTo>
                  <a:pt x="2132" y="1622"/>
                </a:lnTo>
                <a:lnTo>
                  <a:pt x="2153" y="1638"/>
                </a:lnTo>
                <a:lnTo>
                  <a:pt x="2173" y="1654"/>
                </a:lnTo>
                <a:lnTo>
                  <a:pt x="2194" y="1670"/>
                </a:lnTo>
                <a:lnTo>
                  <a:pt x="2215" y="1685"/>
                </a:lnTo>
                <a:lnTo>
                  <a:pt x="2235" y="1701"/>
                </a:lnTo>
                <a:lnTo>
                  <a:pt x="2256" y="1717"/>
                </a:lnTo>
                <a:lnTo>
                  <a:pt x="2277" y="1733"/>
                </a:lnTo>
                <a:lnTo>
                  <a:pt x="2297" y="1748"/>
                </a:lnTo>
                <a:lnTo>
                  <a:pt x="2318" y="1764"/>
                </a:lnTo>
                <a:lnTo>
                  <a:pt x="2339" y="1780"/>
                </a:lnTo>
                <a:lnTo>
                  <a:pt x="2360" y="1796"/>
                </a:lnTo>
                <a:lnTo>
                  <a:pt x="2380" y="1811"/>
                </a:lnTo>
                <a:lnTo>
                  <a:pt x="2401" y="1827"/>
                </a:lnTo>
                <a:lnTo>
                  <a:pt x="2422" y="1843"/>
                </a:lnTo>
                <a:lnTo>
                  <a:pt x="2442" y="1859"/>
                </a:lnTo>
                <a:lnTo>
                  <a:pt x="2463" y="1874"/>
                </a:lnTo>
                <a:lnTo>
                  <a:pt x="2484" y="1890"/>
                </a:lnTo>
                <a:lnTo>
                  <a:pt x="2504" y="1906"/>
                </a:lnTo>
                <a:lnTo>
                  <a:pt x="2525" y="1922"/>
                </a:lnTo>
                <a:lnTo>
                  <a:pt x="2546" y="1937"/>
                </a:lnTo>
                <a:lnTo>
                  <a:pt x="2567" y="1953"/>
                </a:lnTo>
                <a:lnTo>
                  <a:pt x="2587" y="1969"/>
                </a:lnTo>
                <a:lnTo>
                  <a:pt x="2608" y="1985"/>
                </a:lnTo>
                <a:lnTo>
                  <a:pt x="2629" y="2000"/>
                </a:lnTo>
                <a:lnTo>
                  <a:pt x="2649" y="2016"/>
                </a:lnTo>
                <a:lnTo>
                  <a:pt x="2670" y="2032"/>
                </a:lnTo>
                <a:lnTo>
                  <a:pt x="2691" y="2048"/>
                </a:lnTo>
                <a:lnTo>
                  <a:pt x="2711" y="2063"/>
                </a:lnTo>
                <a:lnTo>
                  <a:pt x="2732" y="2079"/>
                </a:lnTo>
                <a:lnTo>
                  <a:pt x="2753" y="2095"/>
                </a:lnTo>
                <a:lnTo>
                  <a:pt x="2774" y="2111"/>
                </a:lnTo>
                <a:lnTo>
                  <a:pt x="2794" y="2126"/>
                </a:lnTo>
                <a:lnTo>
                  <a:pt x="2815" y="2142"/>
                </a:lnTo>
                <a:lnTo>
                  <a:pt x="2836" y="2158"/>
                </a:lnTo>
                <a:lnTo>
                  <a:pt x="2856" y="2174"/>
                </a:lnTo>
                <a:lnTo>
                  <a:pt x="2877" y="2189"/>
                </a:lnTo>
                <a:lnTo>
                  <a:pt x="2898" y="2205"/>
                </a:lnTo>
                <a:lnTo>
                  <a:pt x="2918" y="2221"/>
                </a:lnTo>
                <a:lnTo>
                  <a:pt x="2939" y="2237"/>
                </a:lnTo>
                <a:lnTo>
                  <a:pt x="2960" y="2253"/>
                </a:lnTo>
                <a:lnTo>
                  <a:pt x="2981" y="2268"/>
                </a:lnTo>
                <a:lnTo>
                  <a:pt x="3001" y="2284"/>
                </a:lnTo>
                <a:lnTo>
                  <a:pt x="3022" y="2300"/>
                </a:lnTo>
                <a:lnTo>
                  <a:pt x="3043" y="2316"/>
                </a:lnTo>
                <a:lnTo>
                  <a:pt x="3063" y="2331"/>
                </a:lnTo>
                <a:lnTo>
                  <a:pt x="3084" y="2347"/>
                </a:lnTo>
                <a:lnTo>
                  <a:pt x="3105" y="2363"/>
                </a:lnTo>
                <a:lnTo>
                  <a:pt x="3126" y="2379"/>
                </a:lnTo>
                <a:lnTo>
                  <a:pt x="3146" y="2394"/>
                </a:lnTo>
                <a:lnTo>
                  <a:pt x="3167" y="2410"/>
                </a:lnTo>
                <a:lnTo>
                  <a:pt x="3188" y="2426"/>
                </a:lnTo>
                <a:lnTo>
                  <a:pt x="3208" y="2442"/>
                </a:lnTo>
                <a:lnTo>
                  <a:pt x="3229" y="2457"/>
                </a:lnTo>
                <a:lnTo>
                  <a:pt x="3250" y="2473"/>
                </a:lnTo>
                <a:lnTo>
                  <a:pt x="3270" y="2489"/>
                </a:lnTo>
                <a:lnTo>
                  <a:pt x="3291" y="2505"/>
                </a:lnTo>
                <a:lnTo>
                  <a:pt x="3312" y="2520"/>
                </a:lnTo>
                <a:lnTo>
                  <a:pt x="3333" y="2536"/>
                </a:lnTo>
                <a:lnTo>
                  <a:pt x="3353" y="2552"/>
                </a:lnTo>
                <a:lnTo>
                  <a:pt x="3374" y="2568"/>
                </a:lnTo>
                <a:lnTo>
                  <a:pt x="3395" y="2583"/>
                </a:lnTo>
                <a:lnTo>
                  <a:pt x="3415" y="2599"/>
                </a:lnTo>
                <a:lnTo>
                  <a:pt x="3436" y="2615"/>
                </a:lnTo>
                <a:lnTo>
                  <a:pt x="3457" y="2631"/>
                </a:lnTo>
                <a:lnTo>
                  <a:pt x="3477" y="2646"/>
                </a:lnTo>
                <a:lnTo>
                  <a:pt x="3498" y="2662"/>
                </a:lnTo>
                <a:lnTo>
                  <a:pt x="3519" y="2678"/>
                </a:lnTo>
                <a:lnTo>
                  <a:pt x="3540" y="2694"/>
                </a:lnTo>
                <a:lnTo>
                  <a:pt x="3560" y="2709"/>
                </a:lnTo>
                <a:lnTo>
                  <a:pt x="3581" y="2725"/>
                </a:lnTo>
                <a:lnTo>
                  <a:pt x="3602" y="2741"/>
                </a:lnTo>
                <a:lnTo>
                  <a:pt x="3622" y="2757"/>
                </a:lnTo>
                <a:lnTo>
                  <a:pt x="3643" y="2772"/>
                </a:lnTo>
                <a:lnTo>
                  <a:pt x="3664" y="2788"/>
                </a:lnTo>
                <a:lnTo>
                  <a:pt x="3684" y="2804"/>
                </a:lnTo>
                <a:lnTo>
                  <a:pt x="3705" y="2820"/>
                </a:lnTo>
                <a:lnTo>
                  <a:pt x="3726" y="2835"/>
                </a:lnTo>
                <a:lnTo>
                  <a:pt x="3747" y="2851"/>
                </a:lnTo>
                <a:lnTo>
                  <a:pt x="3767" y="2867"/>
                </a:lnTo>
                <a:lnTo>
                  <a:pt x="3788" y="2883"/>
                </a:lnTo>
                <a:lnTo>
                  <a:pt x="3809" y="2898"/>
                </a:lnTo>
                <a:lnTo>
                  <a:pt x="3829" y="2914"/>
                </a:lnTo>
                <a:lnTo>
                  <a:pt x="3850" y="2930"/>
                </a:lnTo>
                <a:lnTo>
                  <a:pt x="3871" y="2946"/>
                </a:lnTo>
                <a:lnTo>
                  <a:pt x="3891" y="2961"/>
                </a:lnTo>
                <a:lnTo>
                  <a:pt x="3912" y="2977"/>
                </a:lnTo>
                <a:lnTo>
                  <a:pt x="3933" y="2993"/>
                </a:lnTo>
                <a:lnTo>
                  <a:pt x="3954" y="3009"/>
                </a:lnTo>
                <a:lnTo>
                  <a:pt x="3974" y="3024"/>
                </a:lnTo>
                <a:lnTo>
                  <a:pt x="3995" y="3040"/>
                </a:lnTo>
                <a:lnTo>
                  <a:pt x="4016" y="3056"/>
                </a:lnTo>
                <a:lnTo>
                  <a:pt x="4036" y="3072"/>
                </a:lnTo>
                <a:lnTo>
                  <a:pt x="4057" y="3087"/>
                </a:lnTo>
                <a:lnTo>
                  <a:pt x="4078" y="3103"/>
                </a:lnTo>
                <a:lnTo>
                  <a:pt x="4098" y="3119"/>
                </a:lnTo>
                <a:lnTo>
                  <a:pt x="4119" y="3135"/>
                </a:lnTo>
                <a:lnTo>
                  <a:pt x="4140" y="3150"/>
                </a:lnTo>
                <a:lnTo>
                  <a:pt x="4161" y="3166"/>
                </a:lnTo>
                <a:lnTo>
                  <a:pt x="4181" y="3182"/>
                </a:lnTo>
                <a:lnTo>
                  <a:pt x="4202" y="3198"/>
                </a:lnTo>
                <a:lnTo>
                  <a:pt x="4223" y="3213"/>
                </a:lnTo>
                <a:lnTo>
                  <a:pt x="4243" y="3229"/>
                </a:lnTo>
                <a:lnTo>
                  <a:pt x="4264" y="3245"/>
                </a:lnTo>
                <a:lnTo>
                  <a:pt x="4285" y="3261"/>
                </a:lnTo>
                <a:lnTo>
                  <a:pt x="4305" y="3276"/>
                </a:lnTo>
                <a:lnTo>
                  <a:pt x="4326" y="3292"/>
                </a:lnTo>
                <a:lnTo>
                  <a:pt x="4347" y="3308"/>
                </a:lnTo>
                <a:lnTo>
                  <a:pt x="4368" y="3324"/>
                </a:lnTo>
                <a:lnTo>
                  <a:pt x="4388" y="3339"/>
                </a:lnTo>
                <a:lnTo>
                  <a:pt x="4409" y="3355"/>
                </a:lnTo>
                <a:lnTo>
                  <a:pt x="4430" y="3371"/>
                </a:lnTo>
                <a:lnTo>
                  <a:pt x="4450" y="3387"/>
                </a:lnTo>
                <a:lnTo>
                  <a:pt x="4471" y="3402"/>
                </a:lnTo>
                <a:lnTo>
                  <a:pt x="4492" y="3418"/>
                </a:lnTo>
                <a:lnTo>
                  <a:pt x="4512" y="3434"/>
                </a:lnTo>
                <a:lnTo>
                  <a:pt x="4533" y="3450"/>
                </a:lnTo>
                <a:lnTo>
                  <a:pt x="4554" y="3465"/>
                </a:lnTo>
                <a:lnTo>
                  <a:pt x="4575" y="3481"/>
                </a:lnTo>
                <a:lnTo>
                  <a:pt x="4595" y="3497"/>
                </a:lnTo>
                <a:lnTo>
                  <a:pt x="4616" y="3513"/>
                </a:lnTo>
                <a:lnTo>
                  <a:pt x="4637" y="3528"/>
                </a:lnTo>
              </a:path>
            </a:pathLst>
          </a:cu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108" name="Line 65"/>
          <p:cNvSpPr>
            <a:spLocks noChangeShapeType="1"/>
          </p:cNvSpPr>
          <p:nvPr/>
        </p:nvSpPr>
        <p:spPr bwMode="auto">
          <a:xfrm flipV="1">
            <a:off x="6451600" y="2803674"/>
            <a:ext cx="6350" cy="4763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110" name="Rectangle 67"/>
          <p:cNvSpPr>
            <a:spLocks noChangeArrowheads="1"/>
          </p:cNvSpPr>
          <p:nvPr/>
        </p:nvSpPr>
        <p:spPr bwMode="auto">
          <a:xfrm>
            <a:off x="1616075" y="3557736"/>
            <a:ext cx="40272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 µM 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111" name="Oval 68"/>
          <p:cNvSpPr>
            <a:spLocks noChangeArrowheads="1"/>
          </p:cNvSpPr>
          <p:nvPr/>
        </p:nvSpPr>
        <p:spPr bwMode="auto">
          <a:xfrm>
            <a:off x="1372393" y="3635296"/>
            <a:ext cx="58738" cy="60325"/>
          </a:xfrm>
          <a:prstGeom prst="ellipse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112" name="Rectangle 69"/>
          <p:cNvSpPr>
            <a:spLocks noChangeArrowheads="1"/>
          </p:cNvSpPr>
          <p:nvPr/>
        </p:nvSpPr>
        <p:spPr bwMode="auto">
          <a:xfrm>
            <a:off x="1616075" y="3788379"/>
            <a:ext cx="50257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 µM 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113" name="Rectangle 70"/>
          <p:cNvSpPr>
            <a:spLocks noChangeArrowheads="1"/>
          </p:cNvSpPr>
          <p:nvPr/>
        </p:nvSpPr>
        <p:spPr bwMode="auto">
          <a:xfrm>
            <a:off x="1376362" y="3869907"/>
            <a:ext cx="50800" cy="52388"/>
          </a:xfrm>
          <a:prstGeom prst="rect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114" name="Rectangle 71"/>
          <p:cNvSpPr>
            <a:spLocks noChangeArrowheads="1"/>
          </p:cNvSpPr>
          <p:nvPr/>
        </p:nvSpPr>
        <p:spPr bwMode="auto">
          <a:xfrm>
            <a:off x="1616075" y="4028092"/>
            <a:ext cx="50257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 µM 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115" name="Freeform 72"/>
          <p:cNvSpPr>
            <a:spLocks/>
          </p:cNvSpPr>
          <p:nvPr/>
        </p:nvSpPr>
        <p:spPr bwMode="auto">
          <a:xfrm>
            <a:off x="1371600" y="4109620"/>
            <a:ext cx="60325" cy="52388"/>
          </a:xfrm>
          <a:custGeom>
            <a:avLst/>
            <a:gdLst>
              <a:gd name="T0" fmla="*/ 19 w 38"/>
              <a:gd name="T1" fmla="*/ 0 h 33"/>
              <a:gd name="T2" fmla="*/ 38 w 38"/>
              <a:gd name="T3" fmla="*/ 33 h 33"/>
              <a:gd name="T4" fmla="*/ 0 w 38"/>
              <a:gd name="T5" fmla="*/ 33 h 33"/>
              <a:gd name="T6" fmla="*/ 19 w 38"/>
              <a:gd name="T7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8" h="33">
                <a:moveTo>
                  <a:pt x="19" y="0"/>
                </a:moveTo>
                <a:lnTo>
                  <a:pt x="38" y="33"/>
                </a:lnTo>
                <a:lnTo>
                  <a:pt x="0" y="33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116" name="Rectangle 73"/>
          <p:cNvSpPr>
            <a:spLocks noChangeArrowheads="1"/>
          </p:cNvSpPr>
          <p:nvPr/>
        </p:nvSpPr>
        <p:spPr bwMode="auto">
          <a:xfrm>
            <a:off x="1616075" y="4256692"/>
            <a:ext cx="50257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0 µM 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117" name="Oval 74"/>
          <p:cNvSpPr>
            <a:spLocks noChangeArrowheads="1"/>
          </p:cNvSpPr>
          <p:nvPr/>
        </p:nvSpPr>
        <p:spPr bwMode="auto">
          <a:xfrm>
            <a:off x="1372393" y="4335045"/>
            <a:ext cx="58738" cy="58738"/>
          </a:xfrm>
          <a:prstGeom prst="ellipse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2" name="Rectangle 1"/>
          <p:cNvSpPr/>
          <p:nvPr/>
        </p:nvSpPr>
        <p:spPr>
          <a:xfrm>
            <a:off x="323528" y="378529"/>
            <a:ext cx="8640960" cy="17543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/>
              <a:t>Supplementary</a:t>
            </a:r>
            <a:r>
              <a:rPr lang="fr-FR" b="1" dirty="0"/>
              <a:t> Figure </a:t>
            </a:r>
            <a:r>
              <a:rPr lang="fr-FR" b="1" dirty="0" smtClean="0"/>
              <a:t>1A. </a:t>
            </a:r>
            <a:r>
              <a:rPr lang="en-US" dirty="0" smtClean="0"/>
              <a:t>Double </a:t>
            </a:r>
            <a:r>
              <a:rPr lang="en-US" dirty="0"/>
              <a:t>reciprocal plot of the initial reaction velocities measured at different concentrations of </a:t>
            </a:r>
            <a:r>
              <a:rPr lang="en-US" dirty="0" smtClean="0"/>
              <a:t>ATP </a:t>
            </a:r>
            <a:r>
              <a:rPr lang="en-US" dirty="0"/>
              <a:t>in the presence of 0, 5, 10, 20 and 30 µM of </a:t>
            </a:r>
            <a:r>
              <a:rPr lang="en-US" dirty="0" err="1"/>
              <a:t>quercetagetin</a:t>
            </a:r>
            <a:r>
              <a:rPr lang="en-US" dirty="0"/>
              <a:t> and a fixed concentration of </a:t>
            </a:r>
            <a:r>
              <a:rPr lang="en-US" dirty="0" smtClean="0"/>
              <a:t>poly</a:t>
            </a:r>
            <a:r>
              <a:rPr lang="en-US" dirty="0"/>
              <a:t>(</a:t>
            </a:r>
            <a:r>
              <a:rPr lang="en-US" dirty="0" smtClean="0"/>
              <a:t>U) RNA template. </a:t>
            </a:r>
            <a:r>
              <a:rPr lang="en-US" dirty="0"/>
              <a:t>Crossing of the lines with the X-axis indicates non-competitive inhibition. The graphical </a:t>
            </a:r>
            <a:r>
              <a:rPr lang="en-US" dirty="0" smtClean="0"/>
              <a:t>representation shows one </a:t>
            </a:r>
            <a:r>
              <a:rPr lang="en-US" dirty="0"/>
              <a:t>experiment performed in quadruplicate. The data are presented as </a:t>
            </a:r>
            <a:r>
              <a:rPr lang="en-US" dirty="0" err="1"/>
              <a:t>mean±SD</a:t>
            </a:r>
            <a:r>
              <a:rPr lang="en-US" dirty="0"/>
              <a:t>.</a:t>
            </a:r>
            <a:r>
              <a:rPr lang="fr-FR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0598840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AutoShape 4"/>
          <p:cNvSpPr>
            <a:spLocks noChangeAspect="1" noChangeArrowheads="1" noTextEdit="1"/>
          </p:cNvSpPr>
          <p:nvPr/>
        </p:nvSpPr>
        <p:spPr bwMode="auto">
          <a:xfrm>
            <a:off x="2284413" y="1219200"/>
            <a:ext cx="4878387" cy="4198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1" name="Rectangle 9"/>
          <p:cNvSpPr>
            <a:spLocks noChangeArrowheads="1"/>
          </p:cNvSpPr>
          <p:nvPr/>
        </p:nvSpPr>
        <p:spPr bwMode="auto">
          <a:xfrm>
            <a:off x="4755123" y="5716538"/>
            <a:ext cx="104101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/[GTP] (µM)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Line 10"/>
          <p:cNvSpPr>
            <a:spLocks noChangeShapeType="1"/>
          </p:cNvSpPr>
          <p:nvPr/>
        </p:nvSpPr>
        <p:spPr bwMode="auto">
          <a:xfrm>
            <a:off x="2403475" y="5354588"/>
            <a:ext cx="4494212" cy="0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3" name="Line 11"/>
          <p:cNvSpPr>
            <a:spLocks noChangeShapeType="1"/>
          </p:cNvSpPr>
          <p:nvPr/>
        </p:nvSpPr>
        <p:spPr bwMode="auto">
          <a:xfrm flipV="1">
            <a:off x="2778125" y="5354588"/>
            <a:ext cx="0" cy="46037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4" name="Line 12"/>
          <p:cNvSpPr>
            <a:spLocks noChangeShapeType="1"/>
          </p:cNvSpPr>
          <p:nvPr/>
        </p:nvSpPr>
        <p:spPr bwMode="auto">
          <a:xfrm flipV="1">
            <a:off x="4275138" y="5354588"/>
            <a:ext cx="0" cy="46037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5" name="Line 13"/>
          <p:cNvSpPr>
            <a:spLocks noChangeShapeType="1"/>
          </p:cNvSpPr>
          <p:nvPr/>
        </p:nvSpPr>
        <p:spPr bwMode="auto">
          <a:xfrm flipV="1">
            <a:off x="5024438" y="5354588"/>
            <a:ext cx="0" cy="46037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6" name="Line 14"/>
          <p:cNvSpPr>
            <a:spLocks noChangeShapeType="1"/>
          </p:cNvSpPr>
          <p:nvPr/>
        </p:nvSpPr>
        <p:spPr bwMode="auto">
          <a:xfrm flipV="1">
            <a:off x="5773738" y="5354588"/>
            <a:ext cx="0" cy="46037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7" name="Line 15"/>
          <p:cNvSpPr>
            <a:spLocks noChangeShapeType="1"/>
          </p:cNvSpPr>
          <p:nvPr/>
        </p:nvSpPr>
        <p:spPr bwMode="auto">
          <a:xfrm flipV="1">
            <a:off x="6521450" y="5354588"/>
            <a:ext cx="0" cy="46037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8" name="Rectangle 16"/>
          <p:cNvSpPr>
            <a:spLocks noChangeArrowheads="1"/>
          </p:cNvSpPr>
          <p:nvPr/>
        </p:nvSpPr>
        <p:spPr bwMode="auto">
          <a:xfrm>
            <a:off x="2697015" y="5459363"/>
            <a:ext cx="15963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-1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Rectangle 17"/>
          <p:cNvSpPr>
            <a:spLocks noChangeArrowheads="1"/>
          </p:cNvSpPr>
          <p:nvPr/>
        </p:nvSpPr>
        <p:spPr bwMode="auto">
          <a:xfrm>
            <a:off x="3557750" y="5459363"/>
            <a:ext cx="998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Rectangle 18"/>
          <p:cNvSpPr>
            <a:spLocks noChangeArrowheads="1"/>
          </p:cNvSpPr>
          <p:nvPr/>
        </p:nvSpPr>
        <p:spPr bwMode="auto">
          <a:xfrm>
            <a:off x="4229820" y="5459363"/>
            <a:ext cx="998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Rectangle 19"/>
          <p:cNvSpPr>
            <a:spLocks noChangeArrowheads="1"/>
          </p:cNvSpPr>
          <p:nvPr/>
        </p:nvSpPr>
        <p:spPr bwMode="auto">
          <a:xfrm>
            <a:off x="4977533" y="5459363"/>
            <a:ext cx="998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Rectangle 20"/>
          <p:cNvSpPr>
            <a:spLocks noChangeArrowheads="1"/>
          </p:cNvSpPr>
          <p:nvPr/>
        </p:nvSpPr>
        <p:spPr bwMode="auto">
          <a:xfrm>
            <a:off x="5726833" y="5459363"/>
            <a:ext cx="998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Rectangle 21"/>
          <p:cNvSpPr>
            <a:spLocks noChangeArrowheads="1"/>
          </p:cNvSpPr>
          <p:nvPr/>
        </p:nvSpPr>
        <p:spPr bwMode="auto">
          <a:xfrm>
            <a:off x="6476133" y="5459363"/>
            <a:ext cx="998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Line 23"/>
          <p:cNvSpPr>
            <a:spLocks noChangeShapeType="1"/>
          </p:cNvSpPr>
          <p:nvPr/>
        </p:nvSpPr>
        <p:spPr bwMode="auto">
          <a:xfrm flipV="1">
            <a:off x="3527425" y="2420888"/>
            <a:ext cx="0" cy="3244850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26" name="Line 24"/>
          <p:cNvSpPr>
            <a:spLocks noChangeShapeType="1"/>
          </p:cNvSpPr>
          <p:nvPr/>
        </p:nvSpPr>
        <p:spPr bwMode="auto">
          <a:xfrm>
            <a:off x="3481388" y="5340301"/>
            <a:ext cx="46037" cy="0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27" name="Line 25"/>
          <p:cNvSpPr>
            <a:spLocks noChangeShapeType="1"/>
          </p:cNvSpPr>
          <p:nvPr/>
        </p:nvSpPr>
        <p:spPr bwMode="auto">
          <a:xfrm>
            <a:off x="3481388" y="4529088"/>
            <a:ext cx="46037" cy="0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28" name="Line 26"/>
          <p:cNvSpPr>
            <a:spLocks noChangeShapeType="1"/>
          </p:cNvSpPr>
          <p:nvPr/>
        </p:nvSpPr>
        <p:spPr bwMode="auto">
          <a:xfrm>
            <a:off x="3481388" y="3717876"/>
            <a:ext cx="46037" cy="0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29" name="Line 27"/>
          <p:cNvSpPr>
            <a:spLocks noChangeShapeType="1"/>
          </p:cNvSpPr>
          <p:nvPr/>
        </p:nvSpPr>
        <p:spPr bwMode="auto">
          <a:xfrm>
            <a:off x="3481388" y="2906663"/>
            <a:ext cx="46037" cy="0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30" name="Rectangle 28"/>
          <p:cNvSpPr>
            <a:spLocks noChangeArrowheads="1"/>
          </p:cNvSpPr>
          <p:nvPr/>
        </p:nvSpPr>
        <p:spPr bwMode="auto">
          <a:xfrm>
            <a:off x="3124200" y="5337430"/>
            <a:ext cx="3494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00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Rectangle 29"/>
          <p:cNvSpPr>
            <a:spLocks noChangeArrowheads="1"/>
          </p:cNvSpPr>
          <p:nvPr/>
        </p:nvSpPr>
        <p:spPr bwMode="auto">
          <a:xfrm>
            <a:off x="3124200" y="4418530"/>
            <a:ext cx="3494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.00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096" name="Rectangle 30"/>
          <p:cNvSpPr>
            <a:spLocks noChangeArrowheads="1"/>
          </p:cNvSpPr>
          <p:nvPr/>
        </p:nvSpPr>
        <p:spPr bwMode="auto">
          <a:xfrm>
            <a:off x="3124200" y="3608905"/>
            <a:ext cx="3494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.00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097" name="Rectangle 31"/>
          <p:cNvSpPr>
            <a:spLocks noChangeArrowheads="1"/>
          </p:cNvSpPr>
          <p:nvPr/>
        </p:nvSpPr>
        <p:spPr bwMode="auto">
          <a:xfrm>
            <a:off x="3124200" y="2797692"/>
            <a:ext cx="3494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.00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099" name="Oval 32"/>
          <p:cNvSpPr>
            <a:spLocks noChangeArrowheads="1"/>
          </p:cNvSpPr>
          <p:nvPr/>
        </p:nvSpPr>
        <p:spPr bwMode="auto">
          <a:xfrm>
            <a:off x="6491288" y="4460826"/>
            <a:ext cx="60325" cy="60325"/>
          </a:xfrm>
          <a:prstGeom prst="ellipse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00" name="Oval 33"/>
          <p:cNvSpPr>
            <a:spLocks noChangeArrowheads="1"/>
          </p:cNvSpPr>
          <p:nvPr/>
        </p:nvSpPr>
        <p:spPr bwMode="auto">
          <a:xfrm>
            <a:off x="5635625" y="4824363"/>
            <a:ext cx="60325" cy="60325"/>
          </a:xfrm>
          <a:prstGeom prst="ellipse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01" name="Oval 34"/>
          <p:cNvSpPr>
            <a:spLocks noChangeArrowheads="1"/>
          </p:cNvSpPr>
          <p:nvPr/>
        </p:nvSpPr>
        <p:spPr bwMode="auto">
          <a:xfrm>
            <a:off x="4994275" y="4906913"/>
            <a:ext cx="58737" cy="60325"/>
          </a:xfrm>
          <a:prstGeom prst="ellipse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02" name="Oval 35"/>
          <p:cNvSpPr>
            <a:spLocks noChangeArrowheads="1"/>
          </p:cNvSpPr>
          <p:nvPr/>
        </p:nvSpPr>
        <p:spPr bwMode="auto">
          <a:xfrm>
            <a:off x="4244975" y="5076776"/>
            <a:ext cx="60325" cy="58737"/>
          </a:xfrm>
          <a:prstGeom prst="ellipse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03" name="Oval 36"/>
          <p:cNvSpPr>
            <a:spLocks noChangeArrowheads="1"/>
          </p:cNvSpPr>
          <p:nvPr/>
        </p:nvSpPr>
        <p:spPr bwMode="auto">
          <a:xfrm>
            <a:off x="3871913" y="5092651"/>
            <a:ext cx="58737" cy="60325"/>
          </a:xfrm>
          <a:prstGeom prst="ellipse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04" name="Freeform 37"/>
          <p:cNvSpPr>
            <a:spLocks/>
          </p:cNvSpPr>
          <p:nvPr/>
        </p:nvSpPr>
        <p:spPr bwMode="auto">
          <a:xfrm flipV="1">
            <a:off x="2403475" y="4478288"/>
            <a:ext cx="4487862" cy="1054100"/>
          </a:xfrm>
          <a:custGeom>
            <a:avLst/>
            <a:gdLst>
              <a:gd name="T0" fmla="*/ 62 w 4914"/>
              <a:gd name="T1" fmla="*/ 15 h 1150"/>
              <a:gd name="T2" fmla="*/ 145 w 4914"/>
              <a:gd name="T3" fmla="*/ 34 h 1150"/>
              <a:gd name="T4" fmla="*/ 229 w 4914"/>
              <a:gd name="T5" fmla="*/ 54 h 1150"/>
              <a:gd name="T6" fmla="*/ 312 w 4914"/>
              <a:gd name="T7" fmla="*/ 73 h 1150"/>
              <a:gd name="T8" fmla="*/ 395 w 4914"/>
              <a:gd name="T9" fmla="*/ 93 h 1150"/>
              <a:gd name="T10" fmla="*/ 478 w 4914"/>
              <a:gd name="T11" fmla="*/ 112 h 1150"/>
              <a:gd name="T12" fmla="*/ 562 w 4914"/>
              <a:gd name="T13" fmla="*/ 132 h 1150"/>
              <a:gd name="T14" fmla="*/ 645 w 4914"/>
              <a:gd name="T15" fmla="*/ 151 h 1150"/>
              <a:gd name="T16" fmla="*/ 728 w 4914"/>
              <a:gd name="T17" fmla="*/ 171 h 1150"/>
              <a:gd name="T18" fmla="*/ 812 w 4914"/>
              <a:gd name="T19" fmla="*/ 190 h 1150"/>
              <a:gd name="T20" fmla="*/ 895 w 4914"/>
              <a:gd name="T21" fmla="*/ 210 h 1150"/>
              <a:gd name="T22" fmla="*/ 978 w 4914"/>
              <a:gd name="T23" fmla="*/ 229 h 1150"/>
              <a:gd name="T24" fmla="*/ 1062 w 4914"/>
              <a:gd name="T25" fmla="*/ 249 h 1150"/>
              <a:gd name="T26" fmla="*/ 1145 w 4914"/>
              <a:gd name="T27" fmla="*/ 268 h 1150"/>
              <a:gd name="T28" fmla="*/ 1228 w 4914"/>
              <a:gd name="T29" fmla="*/ 288 h 1150"/>
              <a:gd name="T30" fmla="*/ 1311 w 4914"/>
              <a:gd name="T31" fmla="*/ 307 h 1150"/>
              <a:gd name="T32" fmla="*/ 1395 w 4914"/>
              <a:gd name="T33" fmla="*/ 327 h 1150"/>
              <a:gd name="T34" fmla="*/ 1478 w 4914"/>
              <a:gd name="T35" fmla="*/ 346 h 1150"/>
              <a:gd name="T36" fmla="*/ 1561 w 4914"/>
              <a:gd name="T37" fmla="*/ 366 h 1150"/>
              <a:gd name="T38" fmla="*/ 1645 w 4914"/>
              <a:gd name="T39" fmla="*/ 385 h 1150"/>
              <a:gd name="T40" fmla="*/ 1728 w 4914"/>
              <a:gd name="T41" fmla="*/ 405 h 1150"/>
              <a:gd name="T42" fmla="*/ 1811 w 4914"/>
              <a:gd name="T43" fmla="*/ 424 h 1150"/>
              <a:gd name="T44" fmla="*/ 1895 w 4914"/>
              <a:gd name="T45" fmla="*/ 444 h 1150"/>
              <a:gd name="T46" fmla="*/ 1978 w 4914"/>
              <a:gd name="T47" fmla="*/ 463 h 1150"/>
              <a:gd name="T48" fmla="*/ 2061 w 4914"/>
              <a:gd name="T49" fmla="*/ 483 h 1150"/>
              <a:gd name="T50" fmla="*/ 2144 w 4914"/>
              <a:gd name="T51" fmla="*/ 502 h 1150"/>
              <a:gd name="T52" fmla="*/ 2228 w 4914"/>
              <a:gd name="T53" fmla="*/ 522 h 1150"/>
              <a:gd name="T54" fmla="*/ 2311 w 4914"/>
              <a:gd name="T55" fmla="*/ 541 h 1150"/>
              <a:gd name="T56" fmla="*/ 2394 w 4914"/>
              <a:gd name="T57" fmla="*/ 561 h 1150"/>
              <a:gd name="T58" fmla="*/ 2478 w 4914"/>
              <a:gd name="T59" fmla="*/ 580 h 1150"/>
              <a:gd name="T60" fmla="*/ 2561 w 4914"/>
              <a:gd name="T61" fmla="*/ 600 h 1150"/>
              <a:gd name="T62" fmla="*/ 2644 w 4914"/>
              <a:gd name="T63" fmla="*/ 619 h 1150"/>
              <a:gd name="T64" fmla="*/ 2728 w 4914"/>
              <a:gd name="T65" fmla="*/ 639 h 1150"/>
              <a:gd name="T66" fmla="*/ 2811 w 4914"/>
              <a:gd name="T67" fmla="*/ 658 h 1150"/>
              <a:gd name="T68" fmla="*/ 2894 w 4914"/>
              <a:gd name="T69" fmla="*/ 678 h 1150"/>
              <a:gd name="T70" fmla="*/ 2977 w 4914"/>
              <a:gd name="T71" fmla="*/ 697 h 1150"/>
              <a:gd name="T72" fmla="*/ 3061 w 4914"/>
              <a:gd name="T73" fmla="*/ 717 h 1150"/>
              <a:gd name="T74" fmla="*/ 3144 w 4914"/>
              <a:gd name="T75" fmla="*/ 736 h 1150"/>
              <a:gd name="T76" fmla="*/ 3227 w 4914"/>
              <a:gd name="T77" fmla="*/ 756 h 1150"/>
              <a:gd name="T78" fmla="*/ 3311 w 4914"/>
              <a:gd name="T79" fmla="*/ 775 h 1150"/>
              <a:gd name="T80" fmla="*/ 3394 w 4914"/>
              <a:gd name="T81" fmla="*/ 795 h 1150"/>
              <a:gd name="T82" fmla="*/ 3477 w 4914"/>
              <a:gd name="T83" fmla="*/ 814 h 1150"/>
              <a:gd name="T84" fmla="*/ 3560 w 4914"/>
              <a:gd name="T85" fmla="*/ 834 h 1150"/>
              <a:gd name="T86" fmla="*/ 3644 w 4914"/>
              <a:gd name="T87" fmla="*/ 853 h 1150"/>
              <a:gd name="T88" fmla="*/ 3727 w 4914"/>
              <a:gd name="T89" fmla="*/ 873 h 1150"/>
              <a:gd name="T90" fmla="*/ 3810 w 4914"/>
              <a:gd name="T91" fmla="*/ 892 h 1150"/>
              <a:gd name="T92" fmla="*/ 3894 w 4914"/>
              <a:gd name="T93" fmla="*/ 912 h 1150"/>
              <a:gd name="T94" fmla="*/ 3977 w 4914"/>
              <a:gd name="T95" fmla="*/ 931 h 1150"/>
              <a:gd name="T96" fmla="*/ 4060 w 4914"/>
              <a:gd name="T97" fmla="*/ 951 h 1150"/>
              <a:gd name="T98" fmla="*/ 4144 w 4914"/>
              <a:gd name="T99" fmla="*/ 970 h 1150"/>
              <a:gd name="T100" fmla="*/ 4227 w 4914"/>
              <a:gd name="T101" fmla="*/ 990 h 1150"/>
              <a:gd name="T102" fmla="*/ 4310 w 4914"/>
              <a:gd name="T103" fmla="*/ 1009 h 1150"/>
              <a:gd name="T104" fmla="*/ 4393 w 4914"/>
              <a:gd name="T105" fmla="*/ 1029 h 1150"/>
              <a:gd name="T106" fmla="*/ 4477 w 4914"/>
              <a:gd name="T107" fmla="*/ 1048 h 1150"/>
              <a:gd name="T108" fmla="*/ 4560 w 4914"/>
              <a:gd name="T109" fmla="*/ 1068 h 1150"/>
              <a:gd name="T110" fmla="*/ 4643 w 4914"/>
              <a:gd name="T111" fmla="*/ 1087 h 1150"/>
              <a:gd name="T112" fmla="*/ 4727 w 4914"/>
              <a:gd name="T113" fmla="*/ 1107 h 1150"/>
              <a:gd name="T114" fmla="*/ 4810 w 4914"/>
              <a:gd name="T115" fmla="*/ 1126 h 1150"/>
              <a:gd name="T116" fmla="*/ 4893 w 4914"/>
              <a:gd name="T117" fmla="*/ 1146 h 11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4914" h="1150">
                <a:moveTo>
                  <a:pt x="0" y="0"/>
                </a:moveTo>
                <a:lnTo>
                  <a:pt x="20" y="5"/>
                </a:lnTo>
                <a:lnTo>
                  <a:pt x="41" y="10"/>
                </a:lnTo>
                <a:lnTo>
                  <a:pt x="62" y="15"/>
                </a:lnTo>
                <a:lnTo>
                  <a:pt x="83" y="20"/>
                </a:lnTo>
                <a:lnTo>
                  <a:pt x="104" y="25"/>
                </a:lnTo>
                <a:lnTo>
                  <a:pt x="124" y="30"/>
                </a:lnTo>
                <a:lnTo>
                  <a:pt x="145" y="34"/>
                </a:lnTo>
                <a:lnTo>
                  <a:pt x="166" y="39"/>
                </a:lnTo>
                <a:lnTo>
                  <a:pt x="187" y="44"/>
                </a:lnTo>
                <a:lnTo>
                  <a:pt x="208" y="49"/>
                </a:lnTo>
                <a:lnTo>
                  <a:pt x="229" y="54"/>
                </a:lnTo>
                <a:lnTo>
                  <a:pt x="249" y="59"/>
                </a:lnTo>
                <a:lnTo>
                  <a:pt x="270" y="64"/>
                </a:lnTo>
                <a:lnTo>
                  <a:pt x="291" y="69"/>
                </a:lnTo>
                <a:lnTo>
                  <a:pt x="312" y="73"/>
                </a:lnTo>
                <a:lnTo>
                  <a:pt x="333" y="78"/>
                </a:lnTo>
                <a:lnTo>
                  <a:pt x="354" y="83"/>
                </a:lnTo>
                <a:lnTo>
                  <a:pt x="374" y="88"/>
                </a:lnTo>
                <a:lnTo>
                  <a:pt x="395" y="93"/>
                </a:lnTo>
                <a:lnTo>
                  <a:pt x="416" y="98"/>
                </a:lnTo>
                <a:lnTo>
                  <a:pt x="437" y="103"/>
                </a:lnTo>
                <a:lnTo>
                  <a:pt x="458" y="108"/>
                </a:lnTo>
                <a:lnTo>
                  <a:pt x="478" y="112"/>
                </a:lnTo>
                <a:lnTo>
                  <a:pt x="499" y="117"/>
                </a:lnTo>
                <a:lnTo>
                  <a:pt x="520" y="122"/>
                </a:lnTo>
                <a:lnTo>
                  <a:pt x="541" y="127"/>
                </a:lnTo>
                <a:lnTo>
                  <a:pt x="562" y="132"/>
                </a:lnTo>
                <a:lnTo>
                  <a:pt x="583" y="137"/>
                </a:lnTo>
                <a:lnTo>
                  <a:pt x="603" y="142"/>
                </a:lnTo>
                <a:lnTo>
                  <a:pt x="624" y="147"/>
                </a:lnTo>
                <a:lnTo>
                  <a:pt x="645" y="151"/>
                </a:lnTo>
                <a:lnTo>
                  <a:pt x="666" y="156"/>
                </a:lnTo>
                <a:lnTo>
                  <a:pt x="687" y="161"/>
                </a:lnTo>
                <a:lnTo>
                  <a:pt x="708" y="166"/>
                </a:lnTo>
                <a:lnTo>
                  <a:pt x="728" y="171"/>
                </a:lnTo>
                <a:lnTo>
                  <a:pt x="749" y="176"/>
                </a:lnTo>
                <a:lnTo>
                  <a:pt x="770" y="181"/>
                </a:lnTo>
                <a:lnTo>
                  <a:pt x="791" y="186"/>
                </a:lnTo>
                <a:lnTo>
                  <a:pt x="812" y="190"/>
                </a:lnTo>
                <a:lnTo>
                  <a:pt x="832" y="195"/>
                </a:lnTo>
                <a:lnTo>
                  <a:pt x="853" y="200"/>
                </a:lnTo>
                <a:lnTo>
                  <a:pt x="874" y="205"/>
                </a:lnTo>
                <a:lnTo>
                  <a:pt x="895" y="210"/>
                </a:lnTo>
                <a:lnTo>
                  <a:pt x="916" y="215"/>
                </a:lnTo>
                <a:lnTo>
                  <a:pt x="937" y="220"/>
                </a:lnTo>
                <a:lnTo>
                  <a:pt x="957" y="225"/>
                </a:lnTo>
                <a:lnTo>
                  <a:pt x="978" y="229"/>
                </a:lnTo>
                <a:lnTo>
                  <a:pt x="999" y="234"/>
                </a:lnTo>
                <a:lnTo>
                  <a:pt x="1020" y="239"/>
                </a:lnTo>
                <a:lnTo>
                  <a:pt x="1041" y="244"/>
                </a:lnTo>
                <a:lnTo>
                  <a:pt x="1062" y="249"/>
                </a:lnTo>
                <a:lnTo>
                  <a:pt x="1082" y="254"/>
                </a:lnTo>
                <a:lnTo>
                  <a:pt x="1103" y="259"/>
                </a:lnTo>
                <a:lnTo>
                  <a:pt x="1124" y="263"/>
                </a:lnTo>
                <a:lnTo>
                  <a:pt x="1145" y="268"/>
                </a:lnTo>
                <a:lnTo>
                  <a:pt x="1166" y="273"/>
                </a:lnTo>
                <a:lnTo>
                  <a:pt x="1186" y="278"/>
                </a:lnTo>
                <a:lnTo>
                  <a:pt x="1207" y="283"/>
                </a:lnTo>
                <a:lnTo>
                  <a:pt x="1228" y="288"/>
                </a:lnTo>
                <a:lnTo>
                  <a:pt x="1249" y="293"/>
                </a:lnTo>
                <a:lnTo>
                  <a:pt x="1270" y="298"/>
                </a:lnTo>
                <a:lnTo>
                  <a:pt x="1291" y="302"/>
                </a:lnTo>
                <a:lnTo>
                  <a:pt x="1311" y="307"/>
                </a:lnTo>
                <a:lnTo>
                  <a:pt x="1332" y="312"/>
                </a:lnTo>
                <a:lnTo>
                  <a:pt x="1353" y="317"/>
                </a:lnTo>
                <a:lnTo>
                  <a:pt x="1374" y="322"/>
                </a:lnTo>
                <a:lnTo>
                  <a:pt x="1395" y="327"/>
                </a:lnTo>
                <a:lnTo>
                  <a:pt x="1416" y="332"/>
                </a:lnTo>
                <a:lnTo>
                  <a:pt x="1436" y="337"/>
                </a:lnTo>
                <a:lnTo>
                  <a:pt x="1457" y="341"/>
                </a:lnTo>
                <a:lnTo>
                  <a:pt x="1478" y="346"/>
                </a:lnTo>
                <a:lnTo>
                  <a:pt x="1499" y="351"/>
                </a:lnTo>
                <a:lnTo>
                  <a:pt x="1520" y="356"/>
                </a:lnTo>
                <a:lnTo>
                  <a:pt x="1541" y="361"/>
                </a:lnTo>
                <a:lnTo>
                  <a:pt x="1561" y="366"/>
                </a:lnTo>
                <a:lnTo>
                  <a:pt x="1582" y="371"/>
                </a:lnTo>
                <a:lnTo>
                  <a:pt x="1603" y="376"/>
                </a:lnTo>
                <a:lnTo>
                  <a:pt x="1624" y="380"/>
                </a:lnTo>
                <a:lnTo>
                  <a:pt x="1645" y="385"/>
                </a:lnTo>
                <a:lnTo>
                  <a:pt x="1665" y="390"/>
                </a:lnTo>
                <a:lnTo>
                  <a:pt x="1686" y="395"/>
                </a:lnTo>
                <a:lnTo>
                  <a:pt x="1707" y="400"/>
                </a:lnTo>
                <a:lnTo>
                  <a:pt x="1728" y="405"/>
                </a:lnTo>
                <a:lnTo>
                  <a:pt x="1749" y="410"/>
                </a:lnTo>
                <a:lnTo>
                  <a:pt x="1770" y="415"/>
                </a:lnTo>
                <a:lnTo>
                  <a:pt x="1790" y="419"/>
                </a:lnTo>
                <a:lnTo>
                  <a:pt x="1811" y="424"/>
                </a:lnTo>
                <a:lnTo>
                  <a:pt x="1832" y="429"/>
                </a:lnTo>
                <a:lnTo>
                  <a:pt x="1853" y="434"/>
                </a:lnTo>
                <a:lnTo>
                  <a:pt x="1874" y="439"/>
                </a:lnTo>
                <a:lnTo>
                  <a:pt x="1895" y="444"/>
                </a:lnTo>
                <a:lnTo>
                  <a:pt x="1915" y="449"/>
                </a:lnTo>
                <a:lnTo>
                  <a:pt x="1936" y="454"/>
                </a:lnTo>
                <a:lnTo>
                  <a:pt x="1957" y="458"/>
                </a:lnTo>
                <a:lnTo>
                  <a:pt x="1978" y="463"/>
                </a:lnTo>
                <a:lnTo>
                  <a:pt x="1999" y="468"/>
                </a:lnTo>
                <a:lnTo>
                  <a:pt x="2019" y="473"/>
                </a:lnTo>
                <a:lnTo>
                  <a:pt x="2040" y="478"/>
                </a:lnTo>
                <a:lnTo>
                  <a:pt x="2061" y="483"/>
                </a:lnTo>
                <a:lnTo>
                  <a:pt x="2082" y="488"/>
                </a:lnTo>
                <a:lnTo>
                  <a:pt x="2103" y="493"/>
                </a:lnTo>
                <a:lnTo>
                  <a:pt x="2124" y="497"/>
                </a:lnTo>
                <a:lnTo>
                  <a:pt x="2144" y="502"/>
                </a:lnTo>
                <a:lnTo>
                  <a:pt x="2165" y="507"/>
                </a:lnTo>
                <a:lnTo>
                  <a:pt x="2186" y="512"/>
                </a:lnTo>
                <a:lnTo>
                  <a:pt x="2207" y="517"/>
                </a:lnTo>
                <a:lnTo>
                  <a:pt x="2228" y="522"/>
                </a:lnTo>
                <a:lnTo>
                  <a:pt x="2249" y="527"/>
                </a:lnTo>
                <a:lnTo>
                  <a:pt x="2269" y="532"/>
                </a:lnTo>
                <a:lnTo>
                  <a:pt x="2290" y="536"/>
                </a:lnTo>
                <a:lnTo>
                  <a:pt x="2311" y="541"/>
                </a:lnTo>
                <a:lnTo>
                  <a:pt x="2332" y="546"/>
                </a:lnTo>
                <a:lnTo>
                  <a:pt x="2353" y="551"/>
                </a:lnTo>
                <a:lnTo>
                  <a:pt x="2373" y="556"/>
                </a:lnTo>
                <a:lnTo>
                  <a:pt x="2394" y="561"/>
                </a:lnTo>
                <a:lnTo>
                  <a:pt x="2415" y="566"/>
                </a:lnTo>
                <a:lnTo>
                  <a:pt x="2436" y="570"/>
                </a:lnTo>
                <a:lnTo>
                  <a:pt x="2457" y="575"/>
                </a:lnTo>
                <a:lnTo>
                  <a:pt x="2478" y="580"/>
                </a:lnTo>
                <a:lnTo>
                  <a:pt x="2498" y="585"/>
                </a:lnTo>
                <a:lnTo>
                  <a:pt x="2519" y="590"/>
                </a:lnTo>
                <a:lnTo>
                  <a:pt x="2540" y="595"/>
                </a:lnTo>
                <a:lnTo>
                  <a:pt x="2561" y="600"/>
                </a:lnTo>
                <a:lnTo>
                  <a:pt x="2582" y="605"/>
                </a:lnTo>
                <a:lnTo>
                  <a:pt x="2603" y="609"/>
                </a:lnTo>
                <a:lnTo>
                  <a:pt x="2623" y="614"/>
                </a:lnTo>
                <a:lnTo>
                  <a:pt x="2644" y="619"/>
                </a:lnTo>
                <a:lnTo>
                  <a:pt x="2665" y="624"/>
                </a:lnTo>
                <a:lnTo>
                  <a:pt x="2686" y="629"/>
                </a:lnTo>
                <a:lnTo>
                  <a:pt x="2707" y="634"/>
                </a:lnTo>
                <a:lnTo>
                  <a:pt x="2728" y="639"/>
                </a:lnTo>
                <a:lnTo>
                  <a:pt x="2748" y="644"/>
                </a:lnTo>
                <a:lnTo>
                  <a:pt x="2769" y="648"/>
                </a:lnTo>
                <a:lnTo>
                  <a:pt x="2790" y="653"/>
                </a:lnTo>
                <a:lnTo>
                  <a:pt x="2811" y="658"/>
                </a:lnTo>
                <a:lnTo>
                  <a:pt x="2832" y="663"/>
                </a:lnTo>
                <a:lnTo>
                  <a:pt x="2852" y="668"/>
                </a:lnTo>
                <a:lnTo>
                  <a:pt x="2873" y="673"/>
                </a:lnTo>
                <a:lnTo>
                  <a:pt x="2894" y="678"/>
                </a:lnTo>
                <a:lnTo>
                  <a:pt x="2915" y="683"/>
                </a:lnTo>
                <a:lnTo>
                  <a:pt x="2936" y="687"/>
                </a:lnTo>
                <a:lnTo>
                  <a:pt x="2957" y="692"/>
                </a:lnTo>
                <a:lnTo>
                  <a:pt x="2977" y="697"/>
                </a:lnTo>
                <a:lnTo>
                  <a:pt x="2998" y="702"/>
                </a:lnTo>
                <a:lnTo>
                  <a:pt x="3019" y="707"/>
                </a:lnTo>
                <a:lnTo>
                  <a:pt x="3040" y="712"/>
                </a:lnTo>
                <a:lnTo>
                  <a:pt x="3061" y="717"/>
                </a:lnTo>
                <a:lnTo>
                  <a:pt x="3082" y="722"/>
                </a:lnTo>
                <a:lnTo>
                  <a:pt x="3102" y="726"/>
                </a:lnTo>
                <a:lnTo>
                  <a:pt x="3123" y="731"/>
                </a:lnTo>
                <a:lnTo>
                  <a:pt x="3144" y="736"/>
                </a:lnTo>
                <a:lnTo>
                  <a:pt x="3165" y="741"/>
                </a:lnTo>
                <a:lnTo>
                  <a:pt x="3186" y="746"/>
                </a:lnTo>
                <a:lnTo>
                  <a:pt x="3206" y="751"/>
                </a:lnTo>
                <a:lnTo>
                  <a:pt x="3227" y="756"/>
                </a:lnTo>
                <a:lnTo>
                  <a:pt x="3248" y="761"/>
                </a:lnTo>
                <a:lnTo>
                  <a:pt x="3269" y="765"/>
                </a:lnTo>
                <a:lnTo>
                  <a:pt x="3290" y="770"/>
                </a:lnTo>
                <a:lnTo>
                  <a:pt x="3311" y="775"/>
                </a:lnTo>
                <a:lnTo>
                  <a:pt x="3331" y="780"/>
                </a:lnTo>
                <a:lnTo>
                  <a:pt x="3352" y="785"/>
                </a:lnTo>
                <a:lnTo>
                  <a:pt x="3373" y="790"/>
                </a:lnTo>
                <a:lnTo>
                  <a:pt x="3394" y="795"/>
                </a:lnTo>
                <a:lnTo>
                  <a:pt x="3415" y="800"/>
                </a:lnTo>
                <a:lnTo>
                  <a:pt x="3436" y="804"/>
                </a:lnTo>
                <a:lnTo>
                  <a:pt x="3456" y="809"/>
                </a:lnTo>
                <a:lnTo>
                  <a:pt x="3477" y="814"/>
                </a:lnTo>
                <a:lnTo>
                  <a:pt x="3498" y="819"/>
                </a:lnTo>
                <a:lnTo>
                  <a:pt x="3519" y="824"/>
                </a:lnTo>
                <a:lnTo>
                  <a:pt x="3540" y="829"/>
                </a:lnTo>
                <a:lnTo>
                  <a:pt x="3560" y="834"/>
                </a:lnTo>
                <a:lnTo>
                  <a:pt x="3581" y="839"/>
                </a:lnTo>
                <a:lnTo>
                  <a:pt x="3602" y="843"/>
                </a:lnTo>
                <a:lnTo>
                  <a:pt x="3623" y="848"/>
                </a:lnTo>
                <a:lnTo>
                  <a:pt x="3644" y="853"/>
                </a:lnTo>
                <a:lnTo>
                  <a:pt x="3665" y="858"/>
                </a:lnTo>
                <a:lnTo>
                  <a:pt x="3685" y="863"/>
                </a:lnTo>
                <a:lnTo>
                  <a:pt x="3706" y="868"/>
                </a:lnTo>
                <a:lnTo>
                  <a:pt x="3727" y="873"/>
                </a:lnTo>
                <a:lnTo>
                  <a:pt x="3748" y="877"/>
                </a:lnTo>
                <a:lnTo>
                  <a:pt x="3769" y="882"/>
                </a:lnTo>
                <a:lnTo>
                  <a:pt x="3790" y="887"/>
                </a:lnTo>
                <a:lnTo>
                  <a:pt x="3810" y="892"/>
                </a:lnTo>
                <a:lnTo>
                  <a:pt x="3831" y="897"/>
                </a:lnTo>
                <a:lnTo>
                  <a:pt x="3852" y="902"/>
                </a:lnTo>
                <a:lnTo>
                  <a:pt x="3873" y="907"/>
                </a:lnTo>
                <a:lnTo>
                  <a:pt x="3894" y="912"/>
                </a:lnTo>
                <a:lnTo>
                  <a:pt x="3915" y="916"/>
                </a:lnTo>
                <a:lnTo>
                  <a:pt x="3935" y="921"/>
                </a:lnTo>
                <a:lnTo>
                  <a:pt x="3956" y="926"/>
                </a:lnTo>
                <a:lnTo>
                  <a:pt x="3977" y="931"/>
                </a:lnTo>
                <a:lnTo>
                  <a:pt x="3998" y="936"/>
                </a:lnTo>
                <a:lnTo>
                  <a:pt x="4019" y="941"/>
                </a:lnTo>
                <a:lnTo>
                  <a:pt x="4039" y="946"/>
                </a:lnTo>
                <a:lnTo>
                  <a:pt x="4060" y="951"/>
                </a:lnTo>
                <a:lnTo>
                  <a:pt x="4081" y="955"/>
                </a:lnTo>
                <a:lnTo>
                  <a:pt x="4102" y="960"/>
                </a:lnTo>
                <a:lnTo>
                  <a:pt x="4123" y="965"/>
                </a:lnTo>
                <a:lnTo>
                  <a:pt x="4144" y="970"/>
                </a:lnTo>
                <a:lnTo>
                  <a:pt x="4164" y="975"/>
                </a:lnTo>
                <a:lnTo>
                  <a:pt x="4185" y="980"/>
                </a:lnTo>
                <a:lnTo>
                  <a:pt x="4206" y="985"/>
                </a:lnTo>
                <a:lnTo>
                  <a:pt x="4227" y="990"/>
                </a:lnTo>
                <a:lnTo>
                  <a:pt x="4248" y="994"/>
                </a:lnTo>
                <a:lnTo>
                  <a:pt x="4269" y="999"/>
                </a:lnTo>
                <a:lnTo>
                  <a:pt x="4289" y="1004"/>
                </a:lnTo>
                <a:lnTo>
                  <a:pt x="4310" y="1009"/>
                </a:lnTo>
                <a:lnTo>
                  <a:pt x="4331" y="1014"/>
                </a:lnTo>
                <a:lnTo>
                  <a:pt x="4352" y="1019"/>
                </a:lnTo>
                <a:lnTo>
                  <a:pt x="4373" y="1024"/>
                </a:lnTo>
                <a:lnTo>
                  <a:pt x="4393" y="1029"/>
                </a:lnTo>
                <a:lnTo>
                  <a:pt x="4414" y="1033"/>
                </a:lnTo>
                <a:lnTo>
                  <a:pt x="4435" y="1038"/>
                </a:lnTo>
                <a:lnTo>
                  <a:pt x="4456" y="1043"/>
                </a:lnTo>
                <a:lnTo>
                  <a:pt x="4477" y="1048"/>
                </a:lnTo>
                <a:lnTo>
                  <a:pt x="4498" y="1053"/>
                </a:lnTo>
                <a:lnTo>
                  <a:pt x="4518" y="1058"/>
                </a:lnTo>
                <a:lnTo>
                  <a:pt x="4539" y="1063"/>
                </a:lnTo>
                <a:lnTo>
                  <a:pt x="4560" y="1068"/>
                </a:lnTo>
                <a:lnTo>
                  <a:pt x="4581" y="1072"/>
                </a:lnTo>
                <a:lnTo>
                  <a:pt x="4602" y="1077"/>
                </a:lnTo>
                <a:lnTo>
                  <a:pt x="4623" y="1082"/>
                </a:lnTo>
                <a:lnTo>
                  <a:pt x="4643" y="1087"/>
                </a:lnTo>
                <a:lnTo>
                  <a:pt x="4664" y="1092"/>
                </a:lnTo>
                <a:lnTo>
                  <a:pt x="4685" y="1097"/>
                </a:lnTo>
                <a:lnTo>
                  <a:pt x="4706" y="1102"/>
                </a:lnTo>
                <a:lnTo>
                  <a:pt x="4727" y="1107"/>
                </a:lnTo>
                <a:lnTo>
                  <a:pt x="4747" y="1111"/>
                </a:lnTo>
                <a:lnTo>
                  <a:pt x="4768" y="1116"/>
                </a:lnTo>
                <a:lnTo>
                  <a:pt x="4789" y="1121"/>
                </a:lnTo>
                <a:lnTo>
                  <a:pt x="4810" y="1126"/>
                </a:lnTo>
                <a:lnTo>
                  <a:pt x="4831" y="1131"/>
                </a:lnTo>
                <a:lnTo>
                  <a:pt x="4852" y="1136"/>
                </a:lnTo>
                <a:lnTo>
                  <a:pt x="4872" y="1141"/>
                </a:lnTo>
                <a:lnTo>
                  <a:pt x="4893" y="1146"/>
                </a:lnTo>
                <a:lnTo>
                  <a:pt x="4914" y="1150"/>
                </a:lnTo>
              </a:path>
            </a:pathLst>
          </a:cu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05" name="Line 38"/>
          <p:cNvSpPr>
            <a:spLocks noChangeShapeType="1"/>
          </p:cNvSpPr>
          <p:nvPr/>
        </p:nvSpPr>
        <p:spPr bwMode="auto">
          <a:xfrm flipV="1">
            <a:off x="6891338" y="4476701"/>
            <a:ext cx="6350" cy="1587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06" name="Rectangle 39"/>
          <p:cNvSpPr>
            <a:spLocks noChangeArrowheads="1"/>
          </p:cNvSpPr>
          <p:nvPr/>
        </p:nvSpPr>
        <p:spPr bwMode="auto">
          <a:xfrm>
            <a:off x="6496050" y="4467176"/>
            <a:ext cx="50800" cy="52387"/>
          </a:xfrm>
          <a:prstGeom prst="rect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07" name="Rectangle 40"/>
          <p:cNvSpPr>
            <a:spLocks noChangeArrowheads="1"/>
          </p:cNvSpPr>
          <p:nvPr/>
        </p:nvSpPr>
        <p:spPr bwMode="auto">
          <a:xfrm>
            <a:off x="5640388" y="4705301"/>
            <a:ext cx="52387" cy="50800"/>
          </a:xfrm>
          <a:prstGeom prst="rect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08" name="Rectangle 41"/>
          <p:cNvSpPr>
            <a:spLocks noChangeArrowheads="1"/>
          </p:cNvSpPr>
          <p:nvPr/>
        </p:nvSpPr>
        <p:spPr bwMode="auto">
          <a:xfrm>
            <a:off x="4999038" y="4876751"/>
            <a:ext cx="50800" cy="50800"/>
          </a:xfrm>
          <a:prstGeom prst="rect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09" name="Rectangle 42"/>
          <p:cNvSpPr>
            <a:spLocks noChangeArrowheads="1"/>
          </p:cNvSpPr>
          <p:nvPr/>
        </p:nvSpPr>
        <p:spPr bwMode="auto">
          <a:xfrm>
            <a:off x="4249738" y="5110113"/>
            <a:ext cx="52387" cy="50800"/>
          </a:xfrm>
          <a:prstGeom prst="rect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10" name="Rectangle 43"/>
          <p:cNvSpPr>
            <a:spLocks noChangeArrowheads="1"/>
          </p:cNvSpPr>
          <p:nvPr/>
        </p:nvSpPr>
        <p:spPr bwMode="auto">
          <a:xfrm>
            <a:off x="3875088" y="5079951"/>
            <a:ext cx="52387" cy="50800"/>
          </a:xfrm>
          <a:prstGeom prst="rect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11" name="Freeform 44"/>
          <p:cNvSpPr>
            <a:spLocks/>
          </p:cNvSpPr>
          <p:nvPr/>
        </p:nvSpPr>
        <p:spPr bwMode="auto">
          <a:xfrm flipV="1">
            <a:off x="2403475" y="4419551"/>
            <a:ext cx="4487862" cy="1123950"/>
          </a:xfrm>
          <a:custGeom>
            <a:avLst/>
            <a:gdLst>
              <a:gd name="T0" fmla="*/ 62 w 4914"/>
              <a:gd name="T1" fmla="*/ 16 h 1227"/>
              <a:gd name="T2" fmla="*/ 145 w 4914"/>
              <a:gd name="T3" fmla="*/ 36 h 1227"/>
              <a:gd name="T4" fmla="*/ 229 w 4914"/>
              <a:gd name="T5" fmla="*/ 57 h 1227"/>
              <a:gd name="T6" fmla="*/ 312 w 4914"/>
              <a:gd name="T7" fmla="*/ 78 h 1227"/>
              <a:gd name="T8" fmla="*/ 395 w 4914"/>
              <a:gd name="T9" fmla="*/ 99 h 1227"/>
              <a:gd name="T10" fmla="*/ 478 w 4914"/>
              <a:gd name="T11" fmla="*/ 120 h 1227"/>
              <a:gd name="T12" fmla="*/ 562 w 4914"/>
              <a:gd name="T13" fmla="*/ 140 h 1227"/>
              <a:gd name="T14" fmla="*/ 645 w 4914"/>
              <a:gd name="T15" fmla="*/ 161 h 1227"/>
              <a:gd name="T16" fmla="*/ 728 w 4914"/>
              <a:gd name="T17" fmla="*/ 182 h 1227"/>
              <a:gd name="T18" fmla="*/ 812 w 4914"/>
              <a:gd name="T19" fmla="*/ 203 h 1227"/>
              <a:gd name="T20" fmla="*/ 895 w 4914"/>
              <a:gd name="T21" fmla="*/ 224 h 1227"/>
              <a:gd name="T22" fmla="*/ 978 w 4914"/>
              <a:gd name="T23" fmla="*/ 244 h 1227"/>
              <a:gd name="T24" fmla="*/ 1062 w 4914"/>
              <a:gd name="T25" fmla="*/ 265 h 1227"/>
              <a:gd name="T26" fmla="*/ 1145 w 4914"/>
              <a:gd name="T27" fmla="*/ 286 h 1227"/>
              <a:gd name="T28" fmla="*/ 1228 w 4914"/>
              <a:gd name="T29" fmla="*/ 307 h 1227"/>
              <a:gd name="T30" fmla="*/ 1311 w 4914"/>
              <a:gd name="T31" fmla="*/ 328 h 1227"/>
              <a:gd name="T32" fmla="*/ 1395 w 4914"/>
              <a:gd name="T33" fmla="*/ 348 h 1227"/>
              <a:gd name="T34" fmla="*/ 1478 w 4914"/>
              <a:gd name="T35" fmla="*/ 369 h 1227"/>
              <a:gd name="T36" fmla="*/ 1561 w 4914"/>
              <a:gd name="T37" fmla="*/ 390 h 1227"/>
              <a:gd name="T38" fmla="*/ 1645 w 4914"/>
              <a:gd name="T39" fmla="*/ 411 h 1227"/>
              <a:gd name="T40" fmla="*/ 1728 w 4914"/>
              <a:gd name="T41" fmla="*/ 431 h 1227"/>
              <a:gd name="T42" fmla="*/ 1811 w 4914"/>
              <a:gd name="T43" fmla="*/ 452 h 1227"/>
              <a:gd name="T44" fmla="*/ 1895 w 4914"/>
              <a:gd name="T45" fmla="*/ 473 h 1227"/>
              <a:gd name="T46" fmla="*/ 1978 w 4914"/>
              <a:gd name="T47" fmla="*/ 494 h 1227"/>
              <a:gd name="T48" fmla="*/ 2061 w 4914"/>
              <a:gd name="T49" fmla="*/ 515 h 1227"/>
              <a:gd name="T50" fmla="*/ 2144 w 4914"/>
              <a:gd name="T51" fmla="*/ 535 h 1227"/>
              <a:gd name="T52" fmla="*/ 2228 w 4914"/>
              <a:gd name="T53" fmla="*/ 556 h 1227"/>
              <a:gd name="T54" fmla="*/ 2311 w 4914"/>
              <a:gd name="T55" fmla="*/ 577 h 1227"/>
              <a:gd name="T56" fmla="*/ 2394 w 4914"/>
              <a:gd name="T57" fmla="*/ 598 h 1227"/>
              <a:gd name="T58" fmla="*/ 2478 w 4914"/>
              <a:gd name="T59" fmla="*/ 619 h 1227"/>
              <a:gd name="T60" fmla="*/ 2561 w 4914"/>
              <a:gd name="T61" fmla="*/ 639 h 1227"/>
              <a:gd name="T62" fmla="*/ 2644 w 4914"/>
              <a:gd name="T63" fmla="*/ 660 h 1227"/>
              <a:gd name="T64" fmla="*/ 2728 w 4914"/>
              <a:gd name="T65" fmla="*/ 681 h 1227"/>
              <a:gd name="T66" fmla="*/ 2811 w 4914"/>
              <a:gd name="T67" fmla="*/ 702 h 1227"/>
              <a:gd name="T68" fmla="*/ 2894 w 4914"/>
              <a:gd name="T69" fmla="*/ 723 h 1227"/>
              <a:gd name="T70" fmla="*/ 2977 w 4914"/>
              <a:gd name="T71" fmla="*/ 743 h 1227"/>
              <a:gd name="T72" fmla="*/ 3061 w 4914"/>
              <a:gd name="T73" fmla="*/ 764 h 1227"/>
              <a:gd name="T74" fmla="*/ 3144 w 4914"/>
              <a:gd name="T75" fmla="*/ 785 h 1227"/>
              <a:gd name="T76" fmla="*/ 3227 w 4914"/>
              <a:gd name="T77" fmla="*/ 806 h 1227"/>
              <a:gd name="T78" fmla="*/ 3311 w 4914"/>
              <a:gd name="T79" fmla="*/ 827 h 1227"/>
              <a:gd name="T80" fmla="*/ 3394 w 4914"/>
              <a:gd name="T81" fmla="*/ 847 h 1227"/>
              <a:gd name="T82" fmla="*/ 3477 w 4914"/>
              <a:gd name="T83" fmla="*/ 868 h 1227"/>
              <a:gd name="T84" fmla="*/ 3560 w 4914"/>
              <a:gd name="T85" fmla="*/ 889 h 1227"/>
              <a:gd name="T86" fmla="*/ 3644 w 4914"/>
              <a:gd name="T87" fmla="*/ 910 h 1227"/>
              <a:gd name="T88" fmla="*/ 3727 w 4914"/>
              <a:gd name="T89" fmla="*/ 931 h 1227"/>
              <a:gd name="T90" fmla="*/ 3810 w 4914"/>
              <a:gd name="T91" fmla="*/ 951 h 1227"/>
              <a:gd name="T92" fmla="*/ 3894 w 4914"/>
              <a:gd name="T93" fmla="*/ 972 h 1227"/>
              <a:gd name="T94" fmla="*/ 3977 w 4914"/>
              <a:gd name="T95" fmla="*/ 993 h 1227"/>
              <a:gd name="T96" fmla="*/ 4060 w 4914"/>
              <a:gd name="T97" fmla="*/ 1014 h 1227"/>
              <a:gd name="T98" fmla="*/ 4144 w 4914"/>
              <a:gd name="T99" fmla="*/ 1034 h 1227"/>
              <a:gd name="T100" fmla="*/ 4227 w 4914"/>
              <a:gd name="T101" fmla="*/ 1055 h 1227"/>
              <a:gd name="T102" fmla="*/ 4310 w 4914"/>
              <a:gd name="T103" fmla="*/ 1076 h 1227"/>
              <a:gd name="T104" fmla="*/ 4393 w 4914"/>
              <a:gd name="T105" fmla="*/ 1097 h 1227"/>
              <a:gd name="T106" fmla="*/ 4477 w 4914"/>
              <a:gd name="T107" fmla="*/ 1118 h 1227"/>
              <a:gd name="T108" fmla="*/ 4560 w 4914"/>
              <a:gd name="T109" fmla="*/ 1138 h 1227"/>
              <a:gd name="T110" fmla="*/ 4643 w 4914"/>
              <a:gd name="T111" fmla="*/ 1159 h 1227"/>
              <a:gd name="T112" fmla="*/ 4727 w 4914"/>
              <a:gd name="T113" fmla="*/ 1180 h 1227"/>
              <a:gd name="T114" fmla="*/ 4810 w 4914"/>
              <a:gd name="T115" fmla="*/ 1201 h 1227"/>
              <a:gd name="T116" fmla="*/ 4893 w 4914"/>
              <a:gd name="T117" fmla="*/ 1222 h 12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4914" h="1227">
                <a:moveTo>
                  <a:pt x="0" y="0"/>
                </a:moveTo>
                <a:lnTo>
                  <a:pt x="20" y="5"/>
                </a:lnTo>
                <a:lnTo>
                  <a:pt x="41" y="10"/>
                </a:lnTo>
                <a:lnTo>
                  <a:pt x="62" y="16"/>
                </a:lnTo>
                <a:lnTo>
                  <a:pt x="83" y="21"/>
                </a:lnTo>
                <a:lnTo>
                  <a:pt x="104" y="26"/>
                </a:lnTo>
                <a:lnTo>
                  <a:pt x="124" y="31"/>
                </a:lnTo>
                <a:lnTo>
                  <a:pt x="145" y="36"/>
                </a:lnTo>
                <a:lnTo>
                  <a:pt x="166" y="42"/>
                </a:lnTo>
                <a:lnTo>
                  <a:pt x="187" y="47"/>
                </a:lnTo>
                <a:lnTo>
                  <a:pt x="208" y="52"/>
                </a:lnTo>
                <a:lnTo>
                  <a:pt x="229" y="57"/>
                </a:lnTo>
                <a:lnTo>
                  <a:pt x="249" y="62"/>
                </a:lnTo>
                <a:lnTo>
                  <a:pt x="270" y="68"/>
                </a:lnTo>
                <a:lnTo>
                  <a:pt x="291" y="73"/>
                </a:lnTo>
                <a:lnTo>
                  <a:pt x="312" y="78"/>
                </a:lnTo>
                <a:lnTo>
                  <a:pt x="333" y="83"/>
                </a:lnTo>
                <a:lnTo>
                  <a:pt x="354" y="88"/>
                </a:lnTo>
                <a:lnTo>
                  <a:pt x="374" y="94"/>
                </a:lnTo>
                <a:lnTo>
                  <a:pt x="395" y="99"/>
                </a:lnTo>
                <a:lnTo>
                  <a:pt x="416" y="104"/>
                </a:lnTo>
                <a:lnTo>
                  <a:pt x="437" y="109"/>
                </a:lnTo>
                <a:lnTo>
                  <a:pt x="458" y="114"/>
                </a:lnTo>
                <a:lnTo>
                  <a:pt x="478" y="120"/>
                </a:lnTo>
                <a:lnTo>
                  <a:pt x="499" y="125"/>
                </a:lnTo>
                <a:lnTo>
                  <a:pt x="520" y="130"/>
                </a:lnTo>
                <a:lnTo>
                  <a:pt x="541" y="135"/>
                </a:lnTo>
                <a:lnTo>
                  <a:pt x="562" y="140"/>
                </a:lnTo>
                <a:lnTo>
                  <a:pt x="583" y="146"/>
                </a:lnTo>
                <a:lnTo>
                  <a:pt x="603" y="151"/>
                </a:lnTo>
                <a:lnTo>
                  <a:pt x="624" y="156"/>
                </a:lnTo>
                <a:lnTo>
                  <a:pt x="645" y="161"/>
                </a:lnTo>
                <a:lnTo>
                  <a:pt x="666" y="166"/>
                </a:lnTo>
                <a:lnTo>
                  <a:pt x="687" y="172"/>
                </a:lnTo>
                <a:lnTo>
                  <a:pt x="708" y="177"/>
                </a:lnTo>
                <a:lnTo>
                  <a:pt x="728" y="182"/>
                </a:lnTo>
                <a:lnTo>
                  <a:pt x="749" y="187"/>
                </a:lnTo>
                <a:lnTo>
                  <a:pt x="770" y="192"/>
                </a:lnTo>
                <a:lnTo>
                  <a:pt x="791" y="198"/>
                </a:lnTo>
                <a:lnTo>
                  <a:pt x="812" y="203"/>
                </a:lnTo>
                <a:lnTo>
                  <a:pt x="832" y="208"/>
                </a:lnTo>
                <a:lnTo>
                  <a:pt x="853" y="213"/>
                </a:lnTo>
                <a:lnTo>
                  <a:pt x="874" y="218"/>
                </a:lnTo>
                <a:lnTo>
                  <a:pt x="895" y="224"/>
                </a:lnTo>
                <a:lnTo>
                  <a:pt x="916" y="229"/>
                </a:lnTo>
                <a:lnTo>
                  <a:pt x="937" y="234"/>
                </a:lnTo>
                <a:lnTo>
                  <a:pt x="957" y="239"/>
                </a:lnTo>
                <a:lnTo>
                  <a:pt x="978" y="244"/>
                </a:lnTo>
                <a:lnTo>
                  <a:pt x="999" y="250"/>
                </a:lnTo>
                <a:lnTo>
                  <a:pt x="1020" y="255"/>
                </a:lnTo>
                <a:lnTo>
                  <a:pt x="1041" y="260"/>
                </a:lnTo>
                <a:lnTo>
                  <a:pt x="1062" y="265"/>
                </a:lnTo>
                <a:lnTo>
                  <a:pt x="1082" y="270"/>
                </a:lnTo>
                <a:lnTo>
                  <a:pt x="1103" y="276"/>
                </a:lnTo>
                <a:lnTo>
                  <a:pt x="1124" y="281"/>
                </a:lnTo>
                <a:lnTo>
                  <a:pt x="1145" y="286"/>
                </a:lnTo>
                <a:lnTo>
                  <a:pt x="1166" y="291"/>
                </a:lnTo>
                <a:lnTo>
                  <a:pt x="1186" y="296"/>
                </a:lnTo>
                <a:lnTo>
                  <a:pt x="1207" y="302"/>
                </a:lnTo>
                <a:lnTo>
                  <a:pt x="1228" y="307"/>
                </a:lnTo>
                <a:lnTo>
                  <a:pt x="1249" y="312"/>
                </a:lnTo>
                <a:lnTo>
                  <a:pt x="1270" y="317"/>
                </a:lnTo>
                <a:lnTo>
                  <a:pt x="1291" y="322"/>
                </a:lnTo>
                <a:lnTo>
                  <a:pt x="1311" y="328"/>
                </a:lnTo>
                <a:lnTo>
                  <a:pt x="1332" y="333"/>
                </a:lnTo>
                <a:lnTo>
                  <a:pt x="1353" y="338"/>
                </a:lnTo>
                <a:lnTo>
                  <a:pt x="1374" y="343"/>
                </a:lnTo>
                <a:lnTo>
                  <a:pt x="1395" y="348"/>
                </a:lnTo>
                <a:lnTo>
                  <a:pt x="1416" y="354"/>
                </a:lnTo>
                <a:lnTo>
                  <a:pt x="1436" y="359"/>
                </a:lnTo>
                <a:lnTo>
                  <a:pt x="1457" y="364"/>
                </a:lnTo>
                <a:lnTo>
                  <a:pt x="1478" y="369"/>
                </a:lnTo>
                <a:lnTo>
                  <a:pt x="1499" y="374"/>
                </a:lnTo>
                <a:lnTo>
                  <a:pt x="1520" y="380"/>
                </a:lnTo>
                <a:lnTo>
                  <a:pt x="1541" y="385"/>
                </a:lnTo>
                <a:lnTo>
                  <a:pt x="1561" y="390"/>
                </a:lnTo>
                <a:lnTo>
                  <a:pt x="1582" y="395"/>
                </a:lnTo>
                <a:lnTo>
                  <a:pt x="1603" y="400"/>
                </a:lnTo>
                <a:lnTo>
                  <a:pt x="1624" y="406"/>
                </a:lnTo>
                <a:lnTo>
                  <a:pt x="1645" y="411"/>
                </a:lnTo>
                <a:lnTo>
                  <a:pt x="1665" y="416"/>
                </a:lnTo>
                <a:lnTo>
                  <a:pt x="1686" y="421"/>
                </a:lnTo>
                <a:lnTo>
                  <a:pt x="1707" y="426"/>
                </a:lnTo>
                <a:lnTo>
                  <a:pt x="1728" y="431"/>
                </a:lnTo>
                <a:lnTo>
                  <a:pt x="1749" y="437"/>
                </a:lnTo>
                <a:lnTo>
                  <a:pt x="1770" y="442"/>
                </a:lnTo>
                <a:lnTo>
                  <a:pt x="1790" y="447"/>
                </a:lnTo>
                <a:lnTo>
                  <a:pt x="1811" y="452"/>
                </a:lnTo>
                <a:lnTo>
                  <a:pt x="1832" y="457"/>
                </a:lnTo>
                <a:lnTo>
                  <a:pt x="1853" y="463"/>
                </a:lnTo>
                <a:lnTo>
                  <a:pt x="1874" y="468"/>
                </a:lnTo>
                <a:lnTo>
                  <a:pt x="1895" y="473"/>
                </a:lnTo>
                <a:lnTo>
                  <a:pt x="1915" y="478"/>
                </a:lnTo>
                <a:lnTo>
                  <a:pt x="1936" y="483"/>
                </a:lnTo>
                <a:lnTo>
                  <a:pt x="1957" y="489"/>
                </a:lnTo>
                <a:lnTo>
                  <a:pt x="1978" y="494"/>
                </a:lnTo>
                <a:lnTo>
                  <a:pt x="1999" y="499"/>
                </a:lnTo>
                <a:lnTo>
                  <a:pt x="2019" y="504"/>
                </a:lnTo>
                <a:lnTo>
                  <a:pt x="2040" y="509"/>
                </a:lnTo>
                <a:lnTo>
                  <a:pt x="2061" y="515"/>
                </a:lnTo>
                <a:lnTo>
                  <a:pt x="2082" y="520"/>
                </a:lnTo>
                <a:lnTo>
                  <a:pt x="2103" y="525"/>
                </a:lnTo>
                <a:lnTo>
                  <a:pt x="2124" y="530"/>
                </a:lnTo>
                <a:lnTo>
                  <a:pt x="2144" y="535"/>
                </a:lnTo>
                <a:lnTo>
                  <a:pt x="2165" y="541"/>
                </a:lnTo>
                <a:lnTo>
                  <a:pt x="2186" y="546"/>
                </a:lnTo>
                <a:lnTo>
                  <a:pt x="2207" y="551"/>
                </a:lnTo>
                <a:lnTo>
                  <a:pt x="2228" y="556"/>
                </a:lnTo>
                <a:lnTo>
                  <a:pt x="2249" y="561"/>
                </a:lnTo>
                <a:lnTo>
                  <a:pt x="2269" y="567"/>
                </a:lnTo>
                <a:lnTo>
                  <a:pt x="2290" y="572"/>
                </a:lnTo>
                <a:lnTo>
                  <a:pt x="2311" y="577"/>
                </a:lnTo>
                <a:lnTo>
                  <a:pt x="2332" y="582"/>
                </a:lnTo>
                <a:lnTo>
                  <a:pt x="2353" y="587"/>
                </a:lnTo>
                <a:lnTo>
                  <a:pt x="2373" y="593"/>
                </a:lnTo>
                <a:lnTo>
                  <a:pt x="2394" y="598"/>
                </a:lnTo>
                <a:lnTo>
                  <a:pt x="2415" y="603"/>
                </a:lnTo>
                <a:lnTo>
                  <a:pt x="2436" y="608"/>
                </a:lnTo>
                <a:lnTo>
                  <a:pt x="2457" y="613"/>
                </a:lnTo>
                <a:lnTo>
                  <a:pt x="2478" y="619"/>
                </a:lnTo>
                <a:lnTo>
                  <a:pt x="2498" y="624"/>
                </a:lnTo>
                <a:lnTo>
                  <a:pt x="2519" y="629"/>
                </a:lnTo>
                <a:lnTo>
                  <a:pt x="2540" y="634"/>
                </a:lnTo>
                <a:lnTo>
                  <a:pt x="2561" y="639"/>
                </a:lnTo>
                <a:lnTo>
                  <a:pt x="2582" y="645"/>
                </a:lnTo>
                <a:lnTo>
                  <a:pt x="2603" y="650"/>
                </a:lnTo>
                <a:lnTo>
                  <a:pt x="2623" y="655"/>
                </a:lnTo>
                <a:lnTo>
                  <a:pt x="2644" y="660"/>
                </a:lnTo>
                <a:lnTo>
                  <a:pt x="2665" y="665"/>
                </a:lnTo>
                <a:lnTo>
                  <a:pt x="2686" y="671"/>
                </a:lnTo>
                <a:lnTo>
                  <a:pt x="2707" y="676"/>
                </a:lnTo>
                <a:lnTo>
                  <a:pt x="2728" y="681"/>
                </a:lnTo>
                <a:lnTo>
                  <a:pt x="2748" y="686"/>
                </a:lnTo>
                <a:lnTo>
                  <a:pt x="2769" y="691"/>
                </a:lnTo>
                <a:lnTo>
                  <a:pt x="2790" y="697"/>
                </a:lnTo>
                <a:lnTo>
                  <a:pt x="2811" y="702"/>
                </a:lnTo>
                <a:lnTo>
                  <a:pt x="2832" y="707"/>
                </a:lnTo>
                <a:lnTo>
                  <a:pt x="2852" y="712"/>
                </a:lnTo>
                <a:lnTo>
                  <a:pt x="2873" y="717"/>
                </a:lnTo>
                <a:lnTo>
                  <a:pt x="2894" y="723"/>
                </a:lnTo>
                <a:lnTo>
                  <a:pt x="2915" y="728"/>
                </a:lnTo>
                <a:lnTo>
                  <a:pt x="2936" y="733"/>
                </a:lnTo>
                <a:lnTo>
                  <a:pt x="2957" y="738"/>
                </a:lnTo>
                <a:lnTo>
                  <a:pt x="2977" y="743"/>
                </a:lnTo>
                <a:lnTo>
                  <a:pt x="2998" y="749"/>
                </a:lnTo>
                <a:lnTo>
                  <a:pt x="3019" y="754"/>
                </a:lnTo>
                <a:lnTo>
                  <a:pt x="3040" y="759"/>
                </a:lnTo>
                <a:lnTo>
                  <a:pt x="3061" y="764"/>
                </a:lnTo>
                <a:lnTo>
                  <a:pt x="3082" y="769"/>
                </a:lnTo>
                <a:lnTo>
                  <a:pt x="3102" y="775"/>
                </a:lnTo>
                <a:lnTo>
                  <a:pt x="3123" y="780"/>
                </a:lnTo>
                <a:lnTo>
                  <a:pt x="3144" y="785"/>
                </a:lnTo>
                <a:lnTo>
                  <a:pt x="3165" y="790"/>
                </a:lnTo>
                <a:lnTo>
                  <a:pt x="3186" y="795"/>
                </a:lnTo>
                <a:lnTo>
                  <a:pt x="3206" y="801"/>
                </a:lnTo>
                <a:lnTo>
                  <a:pt x="3227" y="806"/>
                </a:lnTo>
                <a:lnTo>
                  <a:pt x="3248" y="811"/>
                </a:lnTo>
                <a:lnTo>
                  <a:pt x="3269" y="816"/>
                </a:lnTo>
                <a:lnTo>
                  <a:pt x="3290" y="821"/>
                </a:lnTo>
                <a:lnTo>
                  <a:pt x="3311" y="827"/>
                </a:lnTo>
                <a:lnTo>
                  <a:pt x="3331" y="832"/>
                </a:lnTo>
                <a:lnTo>
                  <a:pt x="3352" y="837"/>
                </a:lnTo>
                <a:lnTo>
                  <a:pt x="3373" y="842"/>
                </a:lnTo>
                <a:lnTo>
                  <a:pt x="3394" y="847"/>
                </a:lnTo>
                <a:lnTo>
                  <a:pt x="3415" y="853"/>
                </a:lnTo>
                <a:lnTo>
                  <a:pt x="3436" y="858"/>
                </a:lnTo>
                <a:lnTo>
                  <a:pt x="3456" y="863"/>
                </a:lnTo>
                <a:lnTo>
                  <a:pt x="3477" y="868"/>
                </a:lnTo>
                <a:lnTo>
                  <a:pt x="3498" y="873"/>
                </a:lnTo>
                <a:lnTo>
                  <a:pt x="3519" y="879"/>
                </a:lnTo>
                <a:lnTo>
                  <a:pt x="3540" y="884"/>
                </a:lnTo>
                <a:lnTo>
                  <a:pt x="3560" y="889"/>
                </a:lnTo>
                <a:lnTo>
                  <a:pt x="3581" y="894"/>
                </a:lnTo>
                <a:lnTo>
                  <a:pt x="3602" y="899"/>
                </a:lnTo>
                <a:lnTo>
                  <a:pt x="3623" y="905"/>
                </a:lnTo>
                <a:lnTo>
                  <a:pt x="3644" y="910"/>
                </a:lnTo>
                <a:lnTo>
                  <a:pt x="3665" y="915"/>
                </a:lnTo>
                <a:lnTo>
                  <a:pt x="3685" y="920"/>
                </a:lnTo>
                <a:lnTo>
                  <a:pt x="3706" y="925"/>
                </a:lnTo>
                <a:lnTo>
                  <a:pt x="3727" y="931"/>
                </a:lnTo>
                <a:lnTo>
                  <a:pt x="3748" y="936"/>
                </a:lnTo>
                <a:lnTo>
                  <a:pt x="3769" y="941"/>
                </a:lnTo>
                <a:lnTo>
                  <a:pt x="3790" y="946"/>
                </a:lnTo>
                <a:lnTo>
                  <a:pt x="3810" y="951"/>
                </a:lnTo>
                <a:lnTo>
                  <a:pt x="3831" y="956"/>
                </a:lnTo>
                <a:lnTo>
                  <a:pt x="3852" y="962"/>
                </a:lnTo>
                <a:lnTo>
                  <a:pt x="3873" y="967"/>
                </a:lnTo>
                <a:lnTo>
                  <a:pt x="3894" y="972"/>
                </a:lnTo>
                <a:lnTo>
                  <a:pt x="3915" y="977"/>
                </a:lnTo>
                <a:lnTo>
                  <a:pt x="3935" y="982"/>
                </a:lnTo>
                <a:lnTo>
                  <a:pt x="3956" y="988"/>
                </a:lnTo>
                <a:lnTo>
                  <a:pt x="3977" y="993"/>
                </a:lnTo>
                <a:lnTo>
                  <a:pt x="3998" y="998"/>
                </a:lnTo>
                <a:lnTo>
                  <a:pt x="4019" y="1003"/>
                </a:lnTo>
                <a:lnTo>
                  <a:pt x="4039" y="1008"/>
                </a:lnTo>
                <a:lnTo>
                  <a:pt x="4060" y="1014"/>
                </a:lnTo>
                <a:lnTo>
                  <a:pt x="4081" y="1019"/>
                </a:lnTo>
                <a:lnTo>
                  <a:pt x="4102" y="1024"/>
                </a:lnTo>
                <a:lnTo>
                  <a:pt x="4123" y="1029"/>
                </a:lnTo>
                <a:lnTo>
                  <a:pt x="4144" y="1034"/>
                </a:lnTo>
                <a:lnTo>
                  <a:pt x="4164" y="1040"/>
                </a:lnTo>
                <a:lnTo>
                  <a:pt x="4185" y="1045"/>
                </a:lnTo>
                <a:lnTo>
                  <a:pt x="4206" y="1050"/>
                </a:lnTo>
                <a:lnTo>
                  <a:pt x="4227" y="1055"/>
                </a:lnTo>
                <a:lnTo>
                  <a:pt x="4248" y="1060"/>
                </a:lnTo>
                <a:lnTo>
                  <a:pt x="4269" y="1066"/>
                </a:lnTo>
                <a:lnTo>
                  <a:pt x="4289" y="1071"/>
                </a:lnTo>
                <a:lnTo>
                  <a:pt x="4310" y="1076"/>
                </a:lnTo>
                <a:lnTo>
                  <a:pt x="4331" y="1081"/>
                </a:lnTo>
                <a:lnTo>
                  <a:pt x="4352" y="1086"/>
                </a:lnTo>
                <a:lnTo>
                  <a:pt x="4373" y="1092"/>
                </a:lnTo>
                <a:lnTo>
                  <a:pt x="4393" y="1097"/>
                </a:lnTo>
                <a:lnTo>
                  <a:pt x="4414" y="1102"/>
                </a:lnTo>
                <a:lnTo>
                  <a:pt x="4435" y="1107"/>
                </a:lnTo>
                <a:lnTo>
                  <a:pt x="4456" y="1112"/>
                </a:lnTo>
                <a:lnTo>
                  <a:pt x="4477" y="1118"/>
                </a:lnTo>
                <a:lnTo>
                  <a:pt x="4498" y="1123"/>
                </a:lnTo>
                <a:lnTo>
                  <a:pt x="4518" y="1128"/>
                </a:lnTo>
                <a:lnTo>
                  <a:pt x="4539" y="1133"/>
                </a:lnTo>
                <a:lnTo>
                  <a:pt x="4560" y="1138"/>
                </a:lnTo>
                <a:lnTo>
                  <a:pt x="4581" y="1144"/>
                </a:lnTo>
                <a:lnTo>
                  <a:pt x="4602" y="1149"/>
                </a:lnTo>
                <a:lnTo>
                  <a:pt x="4623" y="1154"/>
                </a:lnTo>
                <a:lnTo>
                  <a:pt x="4643" y="1159"/>
                </a:lnTo>
                <a:lnTo>
                  <a:pt x="4664" y="1164"/>
                </a:lnTo>
                <a:lnTo>
                  <a:pt x="4685" y="1170"/>
                </a:lnTo>
                <a:lnTo>
                  <a:pt x="4706" y="1175"/>
                </a:lnTo>
                <a:lnTo>
                  <a:pt x="4727" y="1180"/>
                </a:lnTo>
                <a:lnTo>
                  <a:pt x="4747" y="1185"/>
                </a:lnTo>
                <a:lnTo>
                  <a:pt x="4768" y="1190"/>
                </a:lnTo>
                <a:lnTo>
                  <a:pt x="4789" y="1196"/>
                </a:lnTo>
                <a:lnTo>
                  <a:pt x="4810" y="1201"/>
                </a:lnTo>
                <a:lnTo>
                  <a:pt x="4831" y="1206"/>
                </a:lnTo>
                <a:lnTo>
                  <a:pt x="4852" y="1211"/>
                </a:lnTo>
                <a:lnTo>
                  <a:pt x="4872" y="1216"/>
                </a:lnTo>
                <a:lnTo>
                  <a:pt x="4893" y="1222"/>
                </a:lnTo>
                <a:lnTo>
                  <a:pt x="4914" y="1227"/>
                </a:lnTo>
              </a:path>
            </a:pathLst>
          </a:cu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12" name="Line 45"/>
          <p:cNvSpPr>
            <a:spLocks noChangeShapeType="1"/>
          </p:cNvSpPr>
          <p:nvPr/>
        </p:nvSpPr>
        <p:spPr bwMode="auto">
          <a:xfrm flipV="1">
            <a:off x="6891338" y="4417963"/>
            <a:ext cx="6350" cy="1587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13" name="Freeform 46"/>
          <p:cNvSpPr>
            <a:spLocks/>
          </p:cNvSpPr>
          <p:nvPr/>
        </p:nvSpPr>
        <p:spPr bwMode="auto">
          <a:xfrm>
            <a:off x="6491288" y="4189363"/>
            <a:ext cx="60325" cy="52387"/>
          </a:xfrm>
          <a:custGeom>
            <a:avLst/>
            <a:gdLst>
              <a:gd name="T0" fmla="*/ 19 w 38"/>
              <a:gd name="T1" fmla="*/ 0 h 33"/>
              <a:gd name="T2" fmla="*/ 38 w 38"/>
              <a:gd name="T3" fmla="*/ 33 h 33"/>
              <a:gd name="T4" fmla="*/ 0 w 38"/>
              <a:gd name="T5" fmla="*/ 33 h 33"/>
              <a:gd name="T6" fmla="*/ 19 w 38"/>
              <a:gd name="T7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8" h="33">
                <a:moveTo>
                  <a:pt x="19" y="0"/>
                </a:moveTo>
                <a:lnTo>
                  <a:pt x="38" y="33"/>
                </a:lnTo>
                <a:lnTo>
                  <a:pt x="0" y="33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14" name="Freeform 47"/>
          <p:cNvSpPr>
            <a:spLocks/>
          </p:cNvSpPr>
          <p:nvPr/>
        </p:nvSpPr>
        <p:spPr bwMode="auto">
          <a:xfrm>
            <a:off x="5635625" y="4405263"/>
            <a:ext cx="60325" cy="52387"/>
          </a:xfrm>
          <a:custGeom>
            <a:avLst/>
            <a:gdLst>
              <a:gd name="T0" fmla="*/ 19 w 38"/>
              <a:gd name="T1" fmla="*/ 0 h 33"/>
              <a:gd name="T2" fmla="*/ 38 w 38"/>
              <a:gd name="T3" fmla="*/ 33 h 33"/>
              <a:gd name="T4" fmla="*/ 0 w 38"/>
              <a:gd name="T5" fmla="*/ 33 h 33"/>
              <a:gd name="T6" fmla="*/ 19 w 38"/>
              <a:gd name="T7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8" h="33">
                <a:moveTo>
                  <a:pt x="19" y="0"/>
                </a:moveTo>
                <a:lnTo>
                  <a:pt x="38" y="33"/>
                </a:lnTo>
                <a:lnTo>
                  <a:pt x="0" y="33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15" name="Freeform 48"/>
          <p:cNvSpPr>
            <a:spLocks/>
          </p:cNvSpPr>
          <p:nvPr/>
        </p:nvSpPr>
        <p:spPr bwMode="auto">
          <a:xfrm>
            <a:off x="4994275" y="4730701"/>
            <a:ext cx="60325" cy="52387"/>
          </a:xfrm>
          <a:custGeom>
            <a:avLst/>
            <a:gdLst>
              <a:gd name="T0" fmla="*/ 19 w 38"/>
              <a:gd name="T1" fmla="*/ 0 h 33"/>
              <a:gd name="T2" fmla="*/ 38 w 38"/>
              <a:gd name="T3" fmla="*/ 33 h 33"/>
              <a:gd name="T4" fmla="*/ 0 w 38"/>
              <a:gd name="T5" fmla="*/ 33 h 33"/>
              <a:gd name="T6" fmla="*/ 19 w 38"/>
              <a:gd name="T7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8" h="33">
                <a:moveTo>
                  <a:pt x="19" y="0"/>
                </a:moveTo>
                <a:lnTo>
                  <a:pt x="38" y="33"/>
                </a:lnTo>
                <a:lnTo>
                  <a:pt x="0" y="33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16" name="Freeform 49"/>
          <p:cNvSpPr>
            <a:spLocks/>
          </p:cNvSpPr>
          <p:nvPr/>
        </p:nvSpPr>
        <p:spPr bwMode="auto">
          <a:xfrm>
            <a:off x="4244975" y="4962476"/>
            <a:ext cx="60325" cy="53975"/>
          </a:xfrm>
          <a:custGeom>
            <a:avLst/>
            <a:gdLst>
              <a:gd name="T0" fmla="*/ 19 w 38"/>
              <a:gd name="T1" fmla="*/ 0 h 34"/>
              <a:gd name="T2" fmla="*/ 38 w 38"/>
              <a:gd name="T3" fmla="*/ 34 h 34"/>
              <a:gd name="T4" fmla="*/ 0 w 38"/>
              <a:gd name="T5" fmla="*/ 34 h 34"/>
              <a:gd name="T6" fmla="*/ 19 w 38"/>
              <a:gd name="T7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8" h="34">
                <a:moveTo>
                  <a:pt x="19" y="0"/>
                </a:moveTo>
                <a:lnTo>
                  <a:pt x="38" y="34"/>
                </a:lnTo>
                <a:lnTo>
                  <a:pt x="0" y="34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17" name="Freeform 50"/>
          <p:cNvSpPr>
            <a:spLocks/>
          </p:cNvSpPr>
          <p:nvPr/>
        </p:nvSpPr>
        <p:spPr bwMode="auto">
          <a:xfrm>
            <a:off x="3871913" y="5033913"/>
            <a:ext cx="60325" cy="52387"/>
          </a:xfrm>
          <a:custGeom>
            <a:avLst/>
            <a:gdLst>
              <a:gd name="T0" fmla="*/ 19 w 38"/>
              <a:gd name="T1" fmla="*/ 0 h 33"/>
              <a:gd name="T2" fmla="*/ 38 w 38"/>
              <a:gd name="T3" fmla="*/ 33 h 33"/>
              <a:gd name="T4" fmla="*/ 0 w 38"/>
              <a:gd name="T5" fmla="*/ 33 h 33"/>
              <a:gd name="T6" fmla="*/ 19 w 38"/>
              <a:gd name="T7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8" h="33">
                <a:moveTo>
                  <a:pt x="19" y="0"/>
                </a:moveTo>
                <a:lnTo>
                  <a:pt x="38" y="33"/>
                </a:lnTo>
                <a:lnTo>
                  <a:pt x="0" y="33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18" name="Freeform 51"/>
          <p:cNvSpPr>
            <a:spLocks/>
          </p:cNvSpPr>
          <p:nvPr/>
        </p:nvSpPr>
        <p:spPr bwMode="auto">
          <a:xfrm flipV="1">
            <a:off x="2403475" y="4083001"/>
            <a:ext cx="4487862" cy="1525587"/>
          </a:xfrm>
          <a:custGeom>
            <a:avLst/>
            <a:gdLst>
              <a:gd name="T0" fmla="*/ 62 w 4914"/>
              <a:gd name="T1" fmla="*/ 21 h 1665"/>
              <a:gd name="T2" fmla="*/ 145 w 4914"/>
              <a:gd name="T3" fmla="*/ 49 h 1665"/>
              <a:gd name="T4" fmla="*/ 229 w 4914"/>
              <a:gd name="T5" fmla="*/ 78 h 1665"/>
              <a:gd name="T6" fmla="*/ 312 w 4914"/>
              <a:gd name="T7" fmla="*/ 106 h 1665"/>
              <a:gd name="T8" fmla="*/ 395 w 4914"/>
              <a:gd name="T9" fmla="*/ 134 h 1665"/>
              <a:gd name="T10" fmla="*/ 478 w 4914"/>
              <a:gd name="T11" fmla="*/ 162 h 1665"/>
              <a:gd name="T12" fmla="*/ 562 w 4914"/>
              <a:gd name="T13" fmla="*/ 190 h 1665"/>
              <a:gd name="T14" fmla="*/ 645 w 4914"/>
              <a:gd name="T15" fmla="*/ 219 h 1665"/>
              <a:gd name="T16" fmla="*/ 728 w 4914"/>
              <a:gd name="T17" fmla="*/ 247 h 1665"/>
              <a:gd name="T18" fmla="*/ 812 w 4914"/>
              <a:gd name="T19" fmla="*/ 275 h 1665"/>
              <a:gd name="T20" fmla="*/ 895 w 4914"/>
              <a:gd name="T21" fmla="*/ 303 h 1665"/>
              <a:gd name="T22" fmla="*/ 978 w 4914"/>
              <a:gd name="T23" fmla="*/ 332 h 1665"/>
              <a:gd name="T24" fmla="*/ 1062 w 4914"/>
              <a:gd name="T25" fmla="*/ 360 h 1665"/>
              <a:gd name="T26" fmla="*/ 1145 w 4914"/>
              <a:gd name="T27" fmla="*/ 388 h 1665"/>
              <a:gd name="T28" fmla="*/ 1228 w 4914"/>
              <a:gd name="T29" fmla="*/ 416 h 1665"/>
              <a:gd name="T30" fmla="*/ 1311 w 4914"/>
              <a:gd name="T31" fmla="*/ 444 h 1665"/>
              <a:gd name="T32" fmla="*/ 1395 w 4914"/>
              <a:gd name="T33" fmla="*/ 473 h 1665"/>
              <a:gd name="T34" fmla="*/ 1478 w 4914"/>
              <a:gd name="T35" fmla="*/ 501 h 1665"/>
              <a:gd name="T36" fmla="*/ 1561 w 4914"/>
              <a:gd name="T37" fmla="*/ 529 h 1665"/>
              <a:gd name="T38" fmla="*/ 1645 w 4914"/>
              <a:gd name="T39" fmla="*/ 557 h 1665"/>
              <a:gd name="T40" fmla="*/ 1728 w 4914"/>
              <a:gd name="T41" fmla="*/ 586 h 1665"/>
              <a:gd name="T42" fmla="*/ 1811 w 4914"/>
              <a:gd name="T43" fmla="*/ 614 h 1665"/>
              <a:gd name="T44" fmla="*/ 1895 w 4914"/>
              <a:gd name="T45" fmla="*/ 642 h 1665"/>
              <a:gd name="T46" fmla="*/ 1978 w 4914"/>
              <a:gd name="T47" fmla="*/ 670 h 1665"/>
              <a:gd name="T48" fmla="*/ 2061 w 4914"/>
              <a:gd name="T49" fmla="*/ 698 h 1665"/>
              <a:gd name="T50" fmla="*/ 2144 w 4914"/>
              <a:gd name="T51" fmla="*/ 727 h 1665"/>
              <a:gd name="T52" fmla="*/ 2228 w 4914"/>
              <a:gd name="T53" fmla="*/ 755 h 1665"/>
              <a:gd name="T54" fmla="*/ 2311 w 4914"/>
              <a:gd name="T55" fmla="*/ 783 h 1665"/>
              <a:gd name="T56" fmla="*/ 2394 w 4914"/>
              <a:gd name="T57" fmla="*/ 811 h 1665"/>
              <a:gd name="T58" fmla="*/ 2478 w 4914"/>
              <a:gd name="T59" fmla="*/ 840 h 1665"/>
              <a:gd name="T60" fmla="*/ 2561 w 4914"/>
              <a:gd name="T61" fmla="*/ 868 h 1665"/>
              <a:gd name="T62" fmla="*/ 2644 w 4914"/>
              <a:gd name="T63" fmla="*/ 896 h 1665"/>
              <a:gd name="T64" fmla="*/ 2728 w 4914"/>
              <a:gd name="T65" fmla="*/ 924 h 1665"/>
              <a:gd name="T66" fmla="*/ 2811 w 4914"/>
              <a:gd name="T67" fmla="*/ 952 h 1665"/>
              <a:gd name="T68" fmla="*/ 2894 w 4914"/>
              <a:gd name="T69" fmla="*/ 981 h 1665"/>
              <a:gd name="T70" fmla="*/ 2977 w 4914"/>
              <a:gd name="T71" fmla="*/ 1009 h 1665"/>
              <a:gd name="T72" fmla="*/ 3061 w 4914"/>
              <a:gd name="T73" fmla="*/ 1037 h 1665"/>
              <a:gd name="T74" fmla="*/ 3144 w 4914"/>
              <a:gd name="T75" fmla="*/ 1065 h 1665"/>
              <a:gd name="T76" fmla="*/ 3227 w 4914"/>
              <a:gd name="T77" fmla="*/ 1093 h 1665"/>
              <a:gd name="T78" fmla="*/ 3311 w 4914"/>
              <a:gd name="T79" fmla="*/ 1122 h 1665"/>
              <a:gd name="T80" fmla="*/ 3394 w 4914"/>
              <a:gd name="T81" fmla="*/ 1150 h 1665"/>
              <a:gd name="T82" fmla="*/ 3477 w 4914"/>
              <a:gd name="T83" fmla="*/ 1178 h 1665"/>
              <a:gd name="T84" fmla="*/ 3560 w 4914"/>
              <a:gd name="T85" fmla="*/ 1206 h 1665"/>
              <a:gd name="T86" fmla="*/ 3644 w 4914"/>
              <a:gd name="T87" fmla="*/ 1235 h 1665"/>
              <a:gd name="T88" fmla="*/ 3727 w 4914"/>
              <a:gd name="T89" fmla="*/ 1263 h 1665"/>
              <a:gd name="T90" fmla="*/ 3810 w 4914"/>
              <a:gd name="T91" fmla="*/ 1291 h 1665"/>
              <a:gd name="T92" fmla="*/ 3894 w 4914"/>
              <a:gd name="T93" fmla="*/ 1319 h 1665"/>
              <a:gd name="T94" fmla="*/ 3977 w 4914"/>
              <a:gd name="T95" fmla="*/ 1347 h 1665"/>
              <a:gd name="T96" fmla="*/ 4060 w 4914"/>
              <a:gd name="T97" fmla="*/ 1376 h 1665"/>
              <a:gd name="T98" fmla="*/ 4144 w 4914"/>
              <a:gd name="T99" fmla="*/ 1404 h 1665"/>
              <a:gd name="T100" fmla="*/ 4227 w 4914"/>
              <a:gd name="T101" fmla="*/ 1432 h 1665"/>
              <a:gd name="T102" fmla="*/ 4310 w 4914"/>
              <a:gd name="T103" fmla="*/ 1460 h 1665"/>
              <a:gd name="T104" fmla="*/ 4393 w 4914"/>
              <a:gd name="T105" fmla="*/ 1489 h 1665"/>
              <a:gd name="T106" fmla="*/ 4477 w 4914"/>
              <a:gd name="T107" fmla="*/ 1517 h 1665"/>
              <a:gd name="T108" fmla="*/ 4560 w 4914"/>
              <a:gd name="T109" fmla="*/ 1545 h 1665"/>
              <a:gd name="T110" fmla="*/ 4643 w 4914"/>
              <a:gd name="T111" fmla="*/ 1573 h 1665"/>
              <a:gd name="T112" fmla="*/ 4727 w 4914"/>
              <a:gd name="T113" fmla="*/ 1601 h 1665"/>
              <a:gd name="T114" fmla="*/ 4810 w 4914"/>
              <a:gd name="T115" fmla="*/ 1630 h 1665"/>
              <a:gd name="T116" fmla="*/ 4893 w 4914"/>
              <a:gd name="T117" fmla="*/ 1658 h 16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4914" h="1665">
                <a:moveTo>
                  <a:pt x="0" y="0"/>
                </a:moveTo>
                <a:lnTo>
                  <a:pt x="20" y="7"/>
                </a:lnTo>
                <a:lnTo>
                  <a:pt x="41" y="14"/>
                </a:lnTo>
                <a:lnTo>
                  <a:pt x="62" y="21"/>
                </a:lnTo>
                <a:lnTo>
                  <a:pt x="83" y="28"/>
                </a:lnTo>
                <a:lnTo>
                  <a:pt x="104" y="35"/>
                </a:lnTo>
                <a:lnTo>
                  <a:pt x="124" y="42"/>
                </a:lnTo>
                <a:lnTo>
                  <a:pt x="145" y="49"/>
                </a:lnTo>
                <a:lnTo>
                  <a:pt x="166" y="56"/>
                </a:lnTo>
                <a:lnTo>
                  <a:pt x="187" y="63"/>
                </a:lnTo>
                <a:lnTo>
                  <a:pt x="208" y="71"/>
                </a:lnTo>
                <a:lnTo>
                  <a:pt x="229" y="78"/>
                </a:lnTo>
                <a:lnTo>
                  <a:pt x="249" y="85"/>
                </a:lnTo>
                <a:lnTo>
                  <a:pt x="270" y="92"/>
                </a:lnTo>
                <a:lnTo>
                  <a:pt x="291" y="99"/>
                </a:lnTo>
                <a:lnTo>
                  <a:pt x="312" y="106"/>
                </a:lnTo>
                <a:lnTo>
                  <a:pt x="333" y="113"/>
                </a:lnTo>
                <a:lnTo>
                  <a:pt x="354" y="120"/>
                </a:lnTo>
                <a:lnTo>
                  <a:pt x="374" y="127"/>
                </a:lnTo>
                <a:lnTo>
                  <a:pt x="395" y="134"/>
                </a:lnTo>
                <a:lnTo>
                  <a:pt x="416" y="141"/>
                </a:lnTo>
                <a:lnTo>
                  <a:pt x="437" y="148"/>
                </a:lnTo>
                <a:lnTo>
                  <a:pt x="458" y="155"/>
                </a:lnTo>
                <a:lnTo>
                  <a:pt x="478" y="162"/>
                </a:lnTo>
                <a:lnTo>
                  <a:pt x="499" y="169"/>
                </a:lnTo>
                <a:lnTo>
                  <a:pt x="520" y="176"/>
                </a:lnTo>
                <a:lnTo>
                  <a:pt x="541" y="183"/>
                </a:lnTo>
                <a:lnTo>
                  <a:pt x="562" y="190"/>
                </a:lnTo>
                <a:lnTo>
                  <a:pt x="583" y="198"/>
                </a:lnTo>
                <a:lnTo>
                  <a:pt x="603" y="205"/>
                </a:lnTo>
                <a:lnTo>
                  <a:pt x="624" y="212"/>
                </a:lnTo>
                <a:lnTo>
                  <a:pt x="645" y="219"/>
                </a:lnTo>
                <a:lnTo>
                  <a:pt x="666" y="226"/>
                </a:lnTo>
                <a:lnTo>
                  <a:pt x="687" y="233"/>
                </a:lnTo>
                <a:lnTo>
                  <a:pt x="708" y="240"/>
                </a:lnTo>
                <a:lnTo>
                  <a:pt x="728" y="247"/>
                </a:lnTo>
                <a:lnTo>
                  <a:pt x="749" y="254"/>
                </a:lnTo>
                <a:lnTo>
                  <a:pt x="770" y="261"/>
                </a:lnTo>
                <a:lnTo>
                  <a:pt x="791" y="268"/>
                </a:lnTo>
                <a:lnTo>
                  <a:pt x="812" y="275"/>
                </a:lnTo>
                <a:lnTo>
                  <a:pt x="832" y="282"/>
                </a:lnTo>
                <a:lnTo>
                  <a:pt x="853" y="289"/>
                </a:lnTo>
                <a:lnTo>
                  <a:pt x="874" y="296"/>
                </a:lnTo>
                <a:lnTo>
                  <a:pt x="895" y="303"/>
                </a:lnTo>
                <a:lnTo>
                  <a:pt x="916" y="310"/>
                </a:lnTo>
                <a:lnTo>
                  <a:pt x="937" y="317"/>
                </a:lnTo>
                <a:lnTo>
                  <a:pt x="957" y="325"/>
                </a:lnTo>
                <a:lnTo>
                  <a:pt x="978" y="332"/>
                </a:lnTo>
                <a:lnTo>
                  <a:pt x="999" y="339"/>
                </a:lnTo>
                <a:lnTo>
                  <a:pt x="1020" y="346"/>
                </a:lnTo>
                <a:lnTo>
                  <a:pt x="1041" y="353"/>
                </a:lnTo>
                <a:lnTo>
                  <a:pt x="1062" y="360"/>
                </a:lnTo>
                <a:lnTo>
                  <a:pt x="1082" y="367"/>
                </a:lnTo>
                <a:lnTo>
                  <a:pt x="1103" y="374"/>
                </a:lnTo>
                <a:lnTo>
                  <a:pt x="1124" y="381"/>
                </a:lnTo>
                <a:lnTo>
                  <a:pt x="1145" y="388"/>
                </a:lnTo>
                <a:lnTo>
                  <a:pt x="1166" y="395"/>
                </a:lnTo>
                <a:lnTo>
                  <a:pt x="1186" y="402"/>
                </a:lnTo>
                <a:lnTo>
                  <a:pt x="1207" y="409"/>
                </a:lnTo>
                <a:lnTo>
                  <a:pt x="1228" y="416"/>
                </a:lnTo>
                <a:lnTo>
                  <a:pt x="1249" y="423"/>
                </a:lnTo>
                <a:lnTo>
                  <a:pt x="1270" y="430"/>
                </a:lnTo>
                <a:lnTo>
                  <a:pt x="1291" y="437"/>
                </a:lnTo>
                <a:lnTo>
                  <a:pt x="1311" y="444"/>
                </a:lnTo>
                <a:lnTo>
                  <a:pt x="1332" y="451"/>
                </a:lnTo>
                <a:lnTo>
                  <a:pt x="1353" y="459"/>
                </a:lnTo>
                <a:lnTo>
                  <a:pt x="1374" y="466"/>
                </a:lnTo>
                <a:lnTo>
                  <a:pt x="1395" y="473"/>
                </a:lnTo>
                <a:lnTo>
                  <a:pt x="1416" y="480"/>
                </a:lnTo>
                <a:lnTo>
                  <a:pt x="1436" y="487"/>
                </a:lnTo>
                <a:lnTo>
                  <a:pt x="1457" y="494"/>
                </a:lnTo>
                <a:lnTo>
                  <a:pt x="1478" y="501"/>
                </a:lnTo>
                <a:lnTo>
                  <a:pt x="1499" y="508"/>
                </a:lnTo>
                <a:lnTo>
                  <a:pt x="1520" y="515"/>
                </a:lnTo>
                <a:lnTo>
                  <a:pt x="1541" y="522"/>
                </a:lnTo>
                <a:lnTo>
                  <a:pt x="1561" y="529"/>
                </a:lnTo>
                <a:lnTo>
                  <a:pt x="1582" y="536"/>
                </a:lnTo>
                <a:lnTo>
                  <a:pt x="1603" y="543"/>
                </a:lnTo>
                <a:lnTo>
                  <a:pt x="1624" y="550"/>
                </a:lnTo>
                <a:lnTo>
                  <a:pt x="1645" y="557"/>
                </a:lnTo>
                <a:lnTo>
                  <a:pt x="1665" y="564"/>
                </a:lnTo>
                <a:lnTo>
                  <a:pt x="1686" y="571"/>
                </a:lnTo>
                <a:lnTo>
                  <a:pt x="1707" y="578"/>
                </a:lnTo>
                <a:lnTo>
                  <a:pt x="1728" y="586"/>
                </a:lnTo>
                <a:lnTo>
                  <a:pt x="1749" y="593"/>
                </a:lnTo>
                <a:lnTo>
                  <a:pt x="1770" y="600"/>
                </a:lnTo>
                <a:lnTo>
                  <a:pt x="1790" y="607"/>
                </a:lnTo>
                <a:lnTo>
                  <a:pt x="1811" y="614"/>
                </a:lnTo>
                <a:lnTo>
                  <a:pt x="1832" y="621"/>
                </a:lnTo>
                <a:lnTo>
                  <a:pt x="1853" y="628"/>
                </a:lnTo>
                <a:lnTo>
                  <a:pt x="1874" y="635"/>
                </a:lnTo>
                <a:lnTo>
                  <a:pt x="1895" y="642"/>
                </a:lnTo>
                <a:lnTo>
                  <a:pt x="1915" y="649"/>
                </a:lnTo>
                <a:lnTo>
                  <a:pt x="1936" y="656"/>
                </a:lnTo>
                <a:lnTo>
                  <a:pt x="1957" y="663"/>
                </a:lnTo>
                <a:lnTo>
                  <a:pt x="1978" y="670"/>
                </a:lnTo>
                <a:lnTo>
                  <a:pt x="1999" y="677"/>
                </a:lnTo>
                <a:lnTo>
                  <a:pt x="2019" y="684"/>
                </a:lnTo>
                <a:lnTo>
                  <a:pt x="2040" y="691"/>
                </a:lnTo>
                <a:lnTo>
                  <a:pt x="2061" y="698"/>
                </a:lnTo>
                <a:lnTo>
                  <a:pt x="2082" y="705"/>
                </a:lnTo>
                <a:lnTo>
                  <a:pt x="2103" y="713"/>
                </a:lnTo>
                <a:lnTo>
                  <a:pt x="2124" y="720"/>
                </a:lnTo>
                <a:lnTo>
                  <a:pt x="2144" y="727"/>
                </a:lnTo>
                <a:lnTo>
                  <a:pt x="2165" y="734"/>
                </a:lnTo>
                <a:lnTo>
                  <a:pt x="2186" y="741"/>
                </a:lnTo>
                <a:lnTo>
                  <a:pt x="2207" y="748"/>
                </a:lnTo>
                <a:lnTo>
                  <a:pt x="2228" y="755"/>
                </a:lnTo>
                <a:lnTo>
                  <a:pt x="2249" y="762"/>
                </a:lnTo>
                <a:lnTo>
                  <a:pt x="2269" y="769"/>
                </a:lnTo>
                <a:lnTo>
                  <a:pt x="2290" y="776"/>
                </a:lnTo>
                <a:lnTo>
                  <a:pt x="2311" y="783"/>
                </a:lnTo>
                <a:lnTo>
                  <a:pt x="2332" y="790"/>
                </a:lnTo>
                <a:lnTo>
                  <a:pt x="2353" y="797"/>
                </a:lnTo>
                <a:lnTo>
                  <a:pt x="2373" y="804"/>
                </a:lnTo>
                <a:lnTo>
                  <a:pt x="2394" y="811"/>
                </a:lnTo>
                <a:lnTo>
                  <a:pt x="2415" y="818"/>
                </a:lnTo>
                <a:lnTo>
                  <a:pt x="2436" y="825"/>
                </a:lnTo>
                <a:lnTo>
                  <a:pt x="2457" y="832"/>
                </a:lnTo>
                <a:lnTo>
                  <a:pt x="2478" y="840"/>
                </a:lnTo>
                <a:lnTo>
                  <a:pt x="2498" y="847"/>
                </a:lnTo>
                <a:lnTo>
                  <a:pt x="2519" y="854"/>
                </a:lnTo>
                <a:lnTo>
                  <a:pt x="2540" y="861"/>
                </a:lnTo>
                <a:lnTo>
                  <a:pt x="2561" y="868"/>
                </a:lnTo>
                <a:lnTo>
                  <a:pt x="2582" y="875"/>
                </a:lnTo>
                <a:lnTo>
                  <a:pt x="2603" y="882"/>
                </a:lnTo>
                <a:lnTo>
                  <a:pt x="2623" y="889"/>
                </a:lnTo>
                <a:lnTo>
                  <a:pt x="2644" y="896"/>
                </a:lnTo>
                <a:lnTo>
                  <a:pt x="2665" y="903"/>
                </a:lnTo>
                <a:lnTo>
                  <a:pt x="2686" y="910"/>
                </a:lnTo>
                <a:lnTo>
                  <a:pt x="2707" y="917"/>
                </a:lnTo>
                <a:lnTo>
                  <a:pt x="2728" y="924"/>
                </a:lnTo>
                <a:lnTo>
                  <a:pt x="2748" y="931"/>
                </a:lnTo>
                <a:lnTo>
                  <a:pt x="2769" y="938"/>
                </a:lnTo>
                <a:lnTo>
                  <a:pt x="2790" y="945"/>
                </a:lnTo>
                <a:lnTo>
                  <a:pt x="2811" y="952"/>
                </a:lnTo>
                <a:lnTo>
                  <a:pt x="2832" y="959"/>
                </a:lnTo>
                <a:lnTo>
                  <a:pt x="2852" y="966"/>
                </a:lnTo>
                <a:lnTo>
                  <a:pt x="2873" y="974"/>
                </a:lnTo>
                <a:lnTo>
                  <a:pt x="2894" y="981"/>
                </a:lnTo>
                <a:lnTo>
                  <a:pt x="2915" y="988"/>
                </a:lnTo>
                <a:lnTo>
                  <a:pt x="2936" y="995"/>
                </a:lnTo>
                <a:lnTo>
                  <a:pt x="2957" y="1002"/>
                </a:lnTo>
                <a:lnTo>
                  <a:pt x="2977" y="1009"/>
                </a:lnTo>
                <a:lnTo>
                  <a:pt x="2998" y="1016"/>
                </a:lnTo>
                <a:lnTo>
                  <a:pt x="3019" y="1023"/>
                </a:lnTo>
                <a:lnTo>
                  <a:pt x="3040" y="1030"/>
                </a:lnTo>
                <a:lnTo>
                  <a:pt x="3061" y="1037"/>
                </a:lnTo>
                <a:lnTo>
                  <a:pt x="3082" y="1044"/>
                </a:lnTo>
                <a:lnTo>
                  <a:pt x="3102" y="1051"/>
                </a:lnTo>
                <a:lnTo>
                  <a:pt x="3123" y="1058"/>
                </a:lnTo>
                <a:lnTo>
                  <a:pt x="3144" y="1065"/>
                </a:lnTo>
                <a:lnTo>
                  <a:pt x="3165" y="1072"/>
                </a:lnTo>
                <a:lnTo>
                  <a:pt x="3186" y="1079"/>
                </a:lnTo>
                <a:lnTo>
                  <a:pt x="3206" y="1086"/>
                </a:lnTo>
                <a:lnTo>
                  <a:pt x="3227" y="1093"/>
                </a:lnTo>
                <a:lnTo>
                  <a:pt x="3248" y="1101"/>
                </a:lnTo>
                <a:lnTo>
                  <a:pt x="3269" y="1108"/>
                </a:lnTo>
                <a:lnTo>
                  <a:pt x="3290" y="1115"/>
                </a:lnTo>
                <a:lnTo>
                  <a:pt x="3311" y="1122"/>
                </a:lnTo>
                <a:lnTo>
                  <a:pt x="3331" y="1129"/>
                </a:lnTo>
                <a:lnTo>
                  <a:pt x="3352" y="1136"/>
                </a:lnTo>
                <a:lnTo>
                  <a:pt x="3373" y="1143"/>
                </a:lnTo>
                <a:lnTo>
                  <a:pt x="3394" y="1150"/>
                </a:lnTo>
                <a:lnTo>
                  <a:pt x="3415" y="1157"/>
                </a:lnTo>
                <a:lnTo>
                  <a:pt x="3436" y="1164"/>
                </a:lnTo>
                <a:lnTo>
                  <a:pt x="3456" y="1171"/>
                </a:lnTo>
                <a:lnTo>
                  <a:pt x="3477" y="1178"/>
                </a:lnTo>
                <a:lnTo>
                  <a:pt x="3498" y="1185"/>
                </a:lnTo>
                <a:lnTo>
                  <a:pt x="3519" y="1192"/>
                </a:lnTo>
                <a:lnTo>
                  <a:pt x="3540" y="1199"/>
                </a:lnTo>
                <a:lnTo>
                  <a:pt x="3560" y="1206"/>
                </a:lnTo>
                <a:lnTo>
                  <a:pt x="3581" y="1213"/>
                </a:lnTo>
                <a:lnTo>
                  <a:pt x="3602" y="1220"/>
                </a:lnTo>
                <a:lnTo>
                  <a:pt x="3623" y="1228"/>
                </a:lnTo>
                <a:lnTo>
                  <a:pt x="3644" y="1235"/>
                </a:lnTo>
                <a:lnTo>
                  <a:pt x="3665" y="1242"/>
                </a:lnTo>
                <a:lnTo>
                  <a:pt x="3685" y="1249"/>
                </a:lnTo>
                <a:lnTo>
                  <a:pt x="3706" y="1256"/>
                </a:lnTo>
                <a:lnTo>
                  <a:pt x="3727" y="1263"/>
                </a:lnTo>
                <a:lnTo>
                  <a:pt x="3748" y="1270"/>
                </a:lnTo>
                <a:lnTo>
                  <a:pt x="3769" y="1277"/>
                </a:lnTo>
                <a:lnTo>
                  <a:pt x="3790" y="1284"/>
                </a:lnTo>
                <a:lnTo>
                  <a:pt x="3810" y="1291"/>
                </a:lnTo>
                <a:lnTo>
                  <a:pt x="3831" y="1298"/>
                </a:lnTo>
                <a:lnTo>
                  <a:pt x="3852" y="1305"/>
                </a:lnTo>
                <a:lnTo>
                  <a:pt x="3873" y="1312"/>
                </a:lnTo>
                <a:lnTo>
                  <a:pt x="3894" y="1319"/>
                </a:lnTo>
                <a:lnTo>
                  <a:pt x="3915" y="1326"/>
                </a:lnTo>
                <a:lnTo>
                  <a:pt x="3935" y="1333"/>
                </a:lnTo>
                <a:lnTo>
                  <a:pt x="3956" y="1340"/>
                </a:lnTo>
                <a:lnTo>
                  <a:pt x="3977" y="1347"/>
                </a:lnTo>
                <a:lnTo>
                  <a:pt x="3998" y="1354"/>
                </a:lnTo>
                <a:lnTo>
                  <a:pt x="4019" y="1362"/>
                </a:lnTo>
                <a:lnTo>
                  <a:pt x="4039" y="1369"/>
                </a:lnTo>
                <a:lnTo>
                  <a:pt x="4060" y="1376"/>
                </a:lnTo>
                <a:lnTo>
                  <a:pt x="4081" y="1383"/>
                </a:lnTo>
                <a:lnTo>
                  <a:pt x="4102" y="1390"/>
                </a:lnTo>
                <a:lnTo>
                  <a:pt x="4123" y="1397"/>
                </a:lnTo>
                <a:lnTo>
                  <a:pt x="4144" y="1404"/>
                </a:lnTo>
                <a:lnTo>
                  <a:pt x="4164" y="1411"/>
                </a:lnTo>
                <a:lnTo>
                  <a:pt x="4185" y="1418"/>
                </a:lnTo>
                <a:lnTo>
                  <a:pt x="4206" y="1425"/>
                </a:lnTo>
                <a:lnTo>
                  <a:pt x="4227" y="1432"/>
                </a:lnTo>
                <a:lnTo>
                  <a:pt x="4248" y="1439"/>
                </a:lnTo>
                <a:lnTo>
                  <a:pt x="4269" y="1446"/>
                </a:lnTo>
                <a:lnTo>
                  <a:pt x="4289" y="1453"/>
                </a:lnTo>
                <a:lnTo>
                  <a:pt x="4310" y="1460"/>
                </a:lnTo>
                <a:lnTo>
                  <a:pt x="4331" y="1467"/>
                </a:lnTo>
                <a:lnTo>
                  <a:pt x="4352" y="1474"/>
                </a:lnTo>
                <a:lnTo>
                  <a:pt x="4373" y="1481"/>
                </a:lnTo>
                <a:lnTo>
                  <a:pt x="4393" y="1489"/>
                </a:lnTo>
                <a:lnTo>
                  <a:pt x="4414" y="1496"/>
                </a:lnTo>
                <a:lnTo>
                  <a:pt x="4435" y="1503"/>
                </a:lnTo>
                <a:lnTo>
                  <a:pt x="4456" y="1510"/>
                </a:lnTo>
                <a:lnTo>
                  <a:pt x="4477" y="1517"/>
                </a:lnTo>
                <a:lnTo>
                  <a:pt x="4498" y="1524"/>
                </a:lnTo>
                <a:lnTo>
                  <a:pt x="4518" y="1531"/>
                </a:lnTo>
                <a:lnTo>
                  <a:pt x="4539" y="1538"/>
                </a:lnTo>
                <a:lnTo>
                  <a:pt x="4560" y="1545"/>
                </a:lnTo>
                <a:lnTo>
                  <a:pt x="4581" y="1552"/>
                </a:lnTo>
                <a:lnTo>
                  <a:pt x="4602" y="1559"/>
                </a:lnTo>
                <a:lnTo>
                  <a:pt x="4623" y="1566"/>
                </a:lnTo>
                <a:lnTo>
                  <a:pt x="4643" y="1573"/>
                </a:lnTo>
                <a:lnTo>
                  <a:pt x="4664" y="1580"/>
                </a:lnTo>
                <a:lnTo>
                  <a:pt x="4685" y="1587"/>
                </a:lnTo>
                <a:lnTo>
                  <a:pt x="4706" y="1594"/>
                </a:lnTo>
                <a:lnTo>
                  <a:pt x="4727" y="1601"/>
                </a:lnTo>
                <a:lnTo>
                  <a:pt x="4747" y="1608"/>
                </a:lnTo>
                <a:lnTo>
                  <a:pt x="4768" y="1616"/>
                </a:lnTo>
                <a:lnTo>
                  <a:pt x="4789" y="1623"/>
                </a:lnTo>
                <a:lnTo>
                  <a:pt x="4810" y="1630"/>
                </a:lnTo>
                <a:lnTo>
                  <a:pt x="4831" y="1637"/>
                </a:lnTo>
                <a:lnTo>
                  <a:pt x="4852" y="1644"/>
                </a:lnTo>
                <a:lnTo>
                  <a:pt x="4872" y="1651"/>
                </a:lnTo>
                <a:lnTo>
                  <a:pt x="4893" y="1658"/>
                </a:lnTo>
                <a:lnTo>
                  <a:pt x="4914" y="1665"/>
                </a:lnTo>
              </a:path>
            </a:pathLst>
          </a:cu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19" name="Line 52"/>
          <p:cNvSpPr>
            <a:spLocks noChangeShapeType="1"/>
          </p:cNvSpPr>
          <p:nvPr/>
        </p:nvSpPr>
        <p:spPr bwMode="auto">
          <a:xfrm flipV="1">
            <a:off x="6891338" y="4081413"/>
            <a:ext cx="6350" cy="1587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20" name="Oval 53"/>
          <p:cNvSpPr>
            <a:spLocks noChangeArrowheads="1"/>
          </p:cNvSpPr>
          <p:nvPr/>
        </p:nvSpPr>
        <p:spPr bwMode="auto">
          <a:xfrm>
            <a:off x="6491288" y="3297188"/>
            <a:ext cx="60325" cy="58737"/>
          </a:xfrm>
          <a:prstGeom prst="ellipse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21" name="Oval 54"/>
          <p:cNvSpPr>
            <a:spLocks noChangeArrowheads="1"/>
          </p:cNvSpPr>
          <p:nvPr/>
        </p:nvSpPr>
        <p:spPr bwMode="auto">
          <a:xfrm>
            <a:off x="5635625" y="3330526"/>
            <a:ext cx="60325" cy="60325"/>
          </a:xfrm>
          <a:prstGeom prst="ellipse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22" name="Oval 55"/>
          <p:cNvSpPr>
            <a:spLocks noChangeArrowheads="1"/>
          </p:cNvSpPr>
          <p:nvPr/>
        </p:nvSpPr>
        <p:spPr bwMode="auto">
          <a:xfrm>
            <a:off x="4994275" y="4105226"/>
            <a:ext cx="58737" cy="60325"/>
          </a:xfrm>
          <a:prstGeom prst="ellipse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23" name="Oval 56"/>
          <p:cNvSpPr>
            <a:spLocks noChangeArrowheads="1"/>
          </p:cNvSpPr>
          <p:nvPr/>
        </p:nvSpPr>
        <p:spPr bwMode="auto">
          <a:xfrm>
            <a:off x="4494213" y="4454476"/>
            <a:ext cx="60325" cy="60325"/>
          </a:xfrm>
          <a:prstGeom prst="ellipse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24" name="Oval 57"/>
          <p:cNvSpPr>
            <a:spLocks noChangeArrowheads="1"/>
          </p:cNvSpPr>
          <p:nvPr/>
        </p:nvSpPr>
        <p:spPr bwMode="auto">
          <a:xfrm>
            <a:off x="4244975" y="4622751"/>
            <a:ext cx="60325" cy="60325"/>
          </a:xfrm>
          <a:prstGeom prst="ellipse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25" name="Line 58"/>
          <p:cNvSpPr>
            <a:spLocks noChangeShapeType="1"/>
          </p:cNvSpPr>
          <p:nvPr/>
        </p:nvSpPr>
        <p:spPr bwMode="auto">
          <a:xfrm flipV="1">
            <a:off x="2624138" y="5660976"/>
            <a:ext cx="7937" cy="4762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26" name="Freeform 59"/>
          <p:cNvSpPr>
            <a:spLocks/>
          </p:cNvSpPr>
          <p:nvPr/>
        </p:nvSpPr>
        <p:spPr bwMode="auto">
          <a:xfrm flipV="1">
            <a:off x="2632075" y="2898726"/>
            <a:ext cx="4259262" cy="2762250"/>
          </a:xfrm>
          <a:custGeom>
            <a:avLst/>
            <a:gdLst>
              <a:gd name="T0" fmla="*/ 63 w 4665"/>
              <a:gd name="T1" fmla="*/ 41 h 3015"/>
              <a:gd name="T2" fmla="*/ 146 w 4665"/>
              <a:gd name="T3" fmla="*/ 95 h 3015"/>
              <a:gd name="T4" fmla="*/ 229 w 4665"/>
              <a:gd name="T5" fmla="*/ 149 h 3015"/>
              <a:gd name="T6" fmla="*/ 313 w 4665"/>
              <a:gd name="T7" fmla="*/ 202 h 3015"/>
              <a:gd name="T8" fmla="*/ 396 w 4665"/>
              <a:gd name="T9" fmla="*/ 256 h 3015"/>
              <a:gd name="T10" fmla="*/ 479 w 4665"/>
              <a:gd name="T11" fmla="*/ 310 h 3015"/>
              <a:gd name="T12" fmla="*/ 563 w 4665"/>
              <a:gd name="T13" fmla="*/ 364 h 3015"/>
              <a:gd name="T14" fmla="*/ 646 w 4665"/>
              <a:gd name="T15" fmla="*/ 418 h 3015"/>
              <a:gd name="T16" fmla="*/ 729 w 4665"/>
              <a:gd name="T17" fmla="*/ 471 h 3015"/>
              <a:gd name="T18" fmla="*/ 813 w 4665"/>
              <a:gd name="T19" fmla="*/ 525 h 3015"/>
              <a:gd name="T20" fmla="*/ 896 w 4665"/>
              <a:gd name="T21" fmla="*/ 579 h 3015"/>
              <a:gd name="T22" fmla="*/ 979 w 4665"/>
              <a:gd name="T23" fmla="*/ 633 h 3015"/>
              <a:gd name="T24" fmla="*/ 1062 w 4665"/>
              <a:gd name="T25" fmla="*/ 687 h 3015"/>
              <a:gd name="T26" fmla="*/ 1146 w 4665"/>
              <a:gd name="T27" fmla="*/ 741 h 3015"/>
              <a:gd name="T28" fmla="*/ 1229 w 4665"/>
              <a:gd name="T29" fmla="*/ 794 h 3015"/>
              <a:gd name="T30" fmla="*/ 1312 w 4665"/>
              <a:gd name="T31" fmla="*/ 848 h 3015"/>
              <a:gd name="T32" fmla="*/ 1396 w 4665"/>
              <a:gd name="T33" fmla="*/ 902 h 3015"/>
              <a:gd name="T34" fmla="*/ 1479 w 4665"/>
              <a:gd name="T35" fmla="*/ 956 h 3015"/>
              <a:gd name="T36" fmla="*/ 1562 w 4665"/>
              <a:gd name="T37" fmla="*/ 1010 h 3015"/>
              <a:gd name="T38" fmla="*/ 1646 w 4665"/>
              <a:gd name="T39" fmla="*/ 1063 h 3015"/>
              <a:gd name="T40" fmla="*/ 1729 w 4665"/>
              <a:gd name="T41" fmla="*/ 1117 h 3015"/>
              <a:gd name="T42" fmla="*/ 1812 w 4665"/>
              <a:gd name="T43" fmla="*/ 1171 h 3015"/>
              <a:gd name="T44" fmla="*/ 1895 w 4665"/>
              <a:gd name="T45" fmla="*/ 1225 h 3015"/>
              <a:gd name="T46" fmla="*/ 1979 w 4665"/>
              <a:gd name="T47" fmla="*/ 1279 h 3015"/>
              <a:gd name="T48" fmla="*/ 2062 w 4665"/>
              <a:gd name="T49" fmla="*/ 1333 h 3015"/>
              <a:gd name="T50" fmla="*/ 2145 w 4665"/>
              <a:gd name="T51" fmla="*/ 1386 h 3015"/>
              <a:gd name="T52" fmla="*/ 2229 w 4665"/>
              <a:gd name="T53" fmla="*/ 1440 h 3015"/>
              <a:gd name="T54" fmla="*/ 2312 w 4665"/>
              <a:gd name="T55" fmla="*/ 1494 h 3015"/>
              <a:gd name="T56" fmla="*/ 2395 w 4665"/>
              <a:gd name="T57" fmla="*/ 1548 h 3015"/>
              <a:gd name="T58" fmla="*/ 2479 w 4665"/>
              <a:gd name="T59" fmla="*/ 1602 h 3015"/>
              <a:gd name="T60" fmla="*/ 2562 w 4665"/>
              <a:gd name="T61" fmla="*/ 1656 h 3015"/>
              <a:gd name="T62" fmla="*/ 2645 w 4665"/>
              <a:gd name="T63" fmla="*/ 1709 h 3015"/>
              <a:gd name="T64" fmla="*/ 2728 w 4665"/>
              <a:gd name="T65" fmla="*/ 1763 h 3015"/>
              <a:gd name="T66" fmla="*/ 2812 w 4665"/>
              <a:gd name="T67" fmla="*/ 1817 h 3015"/>
              <a:gd name="T68" fmla="*/ 2895 w 4665"/>
              <a:gd name="T69" fmla="*/ 1871 h 3015"/>
              <a:gd name="T70" fmla="*/ 2978 w 4665"/>
              <a:gd name="T71" fmla="*/ 1925 h 3015"/>
              <a:gd name="T72" fmla="*/ 3062 w 4665"/>
              <a:gd name="T73" fmla="*/ 1978 h 3015"/>
              <a:gd name="T74" fmla="*/ 3145 w 4665"/>
              <a:gd name="T75" fmla="*/ 2032 h 3015"/>
              <a:gd name="T76" fmla="*/ 3228 w 4665"/>
              <a:gd name="T77" fmla="*/ 2086 h 3015"/>
              <a:gd name="T78" fmla="*/ 3311 w 4665"/>
              <a:gd name="T79" fmla="*/ 2140 h 3015"/>
              <a:gd name="T80" fmla="*/ 3395 w 4665"/>
              <a:gd name="T81" fmla="*/ 2194 h 3015"/>
              <a:gd name="T82" fmla="*/ 3478 w 4665"/>
              <a:gd name="T83" fmla="*/ 2248 h 3015"/>
              <a:gd name="T84" fmla="*/ 3561 w 4665"/>
              <a:gd name="T85" fmla="*/ 2301 h 3015"/>
              <a:gd name="T86" fmla="*/ 3645 w 4665"/>
              <a:gd name="T87" fmla="*/ 2355 h 3015"/>
              <a:gd name="T88" fmla="*/ 3728 w 4665"/>
              <a:gd name="T89" fmla="*/ 2409 h 3015"/>
              <a:gd name="T90" fmla="*/ 3811 w 4665"/>
              <a:gd name="T91" fmla="*/ 2463 h 3015"/>
              <a:gd name="T92" fmla="*/ 3895 w 4665"/>
              <a:gd name="T93" fmla="*/ 2517 h 3015"/>
              <a:gd name="T94" fmla="*/ 3978 w 4665"/>
              <a:gd name="T95" fmla="*/ 2570 h 3015"/>
              <a:gd name="T96" fmla="*/ 4061 w 4665"/>
              <a:gd name="T97" fmla="*/ 2624 h 3015"/>
              <a:gd name="T98" fmla="*/ 4144 w 4665"/>
              <a:gd name="T99" fmla="*/ 2678 h 3015"/>
              <a:gd name="T100" fmla="*/ 4228 w 4665"/>
              <a:gd name="T101" fmla="*/ 2732 h 3015"/>
              <a:gd name="T102" fmla="*/ 4311 w 4665"/>
              <a:gd name="T103" fmla="*/ 2786 h 3015"/>
              <a:gd name="T104" fmla="*/ 4394 w 4665"/>
              <a:gd name="T105" fmla="*/ 2840 h 3015"/>
              <a:gd name="T106" fmla="*/ 4478 w 4665"/>
              <a:gd name="T107" fmla="*/ 2893 h 3015"/>
              <a:gd name="T108" fmla="*/ 4561 w 4665"/>
              <a:gd name="T109" fmla="*/ 2947 h 3015"/>
              <a:gd name="T110" fmla="*/ 4644 w 4665"/>
              <a:gd name="T111" fmla="*/ 3001 h 30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4665" h="3015">
                <a:moveTo>
                  <a:pt x="0" y="0"/>
                </a:moveTo>
                <a:lnTo>
                  <a:pt x="21" y="14"/>
                </a:lnTo>
                <a:lnTo>
                  <a:pt x="42" y="27"/>
                </a:lnTo>
                <a:lnTo>
                  <a:pt x="63" y="41"/>
                </a:lnTo>
                <a:lnTo>
                  <a:pt x="84" y="54"/>
                </a:lnTo>
                <a:lnTo>
                  <a:pt x="105" y="68"/>
                </a:lnTo>
                <a:lnTo>
                  <a:pt x="125" y="81"/>
                </a:lnTo>
                <a:lnTo>
                  <a:pt x="146" y="95"/>
                </a:lnTo>
                <a:lnTo>
                  <a:pt x="167" y="108"/>
                </a:lnTo>
                <a:lnTo>
                  <a:pt x="188" y="122"/>
                </a:lnTo>
                <a:lnTo>
                  <a:pt x="209" y="135"/>
                </a:lnTo>
                <a:lnTo>
                  <a:pt x="229" y="149"/>
                </a:lnTo>
                <a:lnTo>
                  <a:pt x="250" y="162"/>
                </a:lnTo>
                <a:lnTo>
                  <a:pt x="271" y="175"/>
                </a:lnTo>
                <a:lnTo>
                  <a:pt x="292" y="189"/>
                </a:lnTo>
                <a:lnTo>
                  <a:pt x="313" y="202"/>
                </a:lnTo>
                <a:lnTo>
                  <a:pt x="334" y="216"/>
                </a:lnTo>
                <a:lnTo>
                  <a:pt x="354" y="229"/>
                </a:lnTo>
                <a:lnTo>
                  <a:pt x="375" y="243"/>
                </a:lnTo>
                <a:lnTo>
                  <a:pt x="396" y="256"/>
                </a:lnTo>
                <a:lnTo>
                  <a:pt x="417" y="270"/>
                </a:lnTo>
                <a:lnTo>
                  <a:pt x="438" y="283"/>
                </a:lnTo>
                <a:lnTo>
                  <a:pt x="459" y="297"/>
                </a:lnTo>
                <a:lnTo>
                  <a:pt x="479" y="310"/>
                </a:lnTo>
                <a:lnTo>
                  <a:pt x="500" y="323"/>
                </a:lnTo>
                <a:lnTo>
                  <a:pt x="521" y="337"/>
                </a:lnTo>
                <a:lnTo>
                  <a:pt x="542" y="350"/>
                </a:lnTo>
                <a:lnTo>
                  <a:pt x="563" y="364"/>
                </a:lnTo>
                <a:lnTo>
                  <a:pt x="583" y="377"/>
                </a:lnTo>
                <a:lnTo>
                  <a:pt x="604" y="391"/>
                </a:lnTo>
                <a:lnTo>
                  <a:pt x="625" y="404"/>
                </a:lnTo>
                <a:lnTo>
                  <a:pt x="646" y="418"/>
                </a:lnTo>
                <a:lnTo>
                  <a:pt x="667" y="431"/>
                </a:lnTo>
                <a:lnTo>
                  <a:pt x="688" y="445"/>
                </a:lnTo>
                <a:lnTo>
                  <a:pt x="708" y="458"/>
                </a:lnTo>
                <a:lnTo>
                  <a:pt x="729" y="471"/>
                </a:lnTo>
                <a:lnTo>
                  <a:pt x="750" y="485"/>
                </a:lnTo>
                <a:lnTo>
                  <a:pt x="771" y="498"/>
                </a:lnTo>
                <a:lnTo>
                  <a:pt x="792" y="512"/>
                </a:lnTo>
                <a:lnTo>
                  <a:pt x="813" y="525"/>
                </a:lnTo>
                <a:lnTo>
                  <a:pt x="833" y="539"/>
                </a:lnTo>
                <a:lnTo>
                  <a:pt x="854" y="552"/>
                </a:lnTo>
                <a:lnTo>
                  <a:pt x="875" y="566"/>
                </a:lnTo>
                <a:lnTo>
                  <a:pt x="896" y="579"/>
                </a:lnTo>
                <a:lnTo>
                  <a:pt x="917" y="593"/>
                </a:lnTo>
                <a:lnTo>
                  <a:pt x="937" y="606"/>
                </a:lnTo>
                <a:lnTo>
                  <a:pt x="958" y="619"/>
                </a:lnTo>
                <a:lnTo>
                  <a:pt x="979" y="633"/>
                </a:lnTo>
                <a:lnTo>
                  <a:pt x="1000" y="646"/>
                </a:lnTo>
                <a:lnTo>
                  <a:pt x="1021" y="660"/>
                </a:lnTo>
                <a:lnTo>
                  <a:pt x="1042" y="673"/>
                </a:lnTo>
                <a:lnTo>
                  <a:pt x="1062" y="687"/>
                </a:lnTo>
                <a:lnTo>
                  <a:pt x="1083" y="700"/>
                </a:lnTo>
                <a:lnTo>
                  <a:pt x="1104" y="714"/>
                </a:lnTo>
                <a:lnTo>
                  <a:pt x="1125" y="727"/>
                </a:lnTo>
                <a:lnTo>
                  <a:pt x="1146" y="741"/>
                </a:lnTo>
                <a:lnTo>
                  <a:pt x="1167" y="754"/>
                </a:lnTo>
                <a:lnTo>
                  <a:pt x="1187" y="767"/>
                </a:lnTo>
                <a:lnTo>
                  <a:pt x="1208" y="781"/>
                </a:lnTo>
                <a:lnTo>
                  <a:pt x="1229" y="794"/>
                </a:lnTo>
                <a:lnTo>
                  <a:pt x="1250" y="808"/>
                </a:lnTo>
                <a:lnTo>
                  <a:pt x="1271" y="821"/>
                </a:lnTo>
                <a:lnTo>
                  <a:pt x="1292" y="835"/>
                </a:lnTo>
                <a:lnTo>
                  <a:pt x="1312" y="848"/>
                </a:lnTo>
                <a:lnTo>
                  <a:pt x="1333" y="862"/>
                </a:lnTo>
                <a:lnTo>
                  <a:pt x="1354" y="875"/>
                </a:lnTo>
                <a:lnTo>
                  <a:pt x="1375" y="889"/>
                </a:lnTo>
                <a:lnTo>
                  <a:pt x="1396" y="902"/>
                </a:lnTo>
                <a:lnTo>
                  <a:pt x="1416" y="915"/>
                </a:lnTo>
                <a:lnTo>
                  <a:pt x="1437" y="929"/>
                </a:lnTo>
                <a:lnTo>
                  <a:pt x="1458" y="942"/>
                </a:lnTo>
                <a:lnTo>
                  <a:pt x="1479" y="956"/>
                </a:lnTo>
                <a:lnTo>
                  <a:pt x="1500" y="969"/>
                </a:lnTo>
                <a:lnTo>
                  <a:pt x="1521" y="983"/>
                </a:lnTo>
                <a:lnTo>
                  <a:pt x="1541" y="996"/>
                </a:lnTo>
                <a:lnTo>
                  <a:pt x="1562" y="1010"/>
                </a:lnTo>
                <a:lnTo>
                  <a:pt x="1583" y="1023"/>
                </a:lnTo>
                <a:lnTo>
                  <a:pt x="1604" y="1037"/>
                </a:lnTo>
                <a:lnTo>
                  <a:pt x="1625" y="1050"/>
                </a:lnTo>
                <a:lnTo>
                  <a:pt x="1646" y="1063"/>
                </a:lnTo>
                <a:lnTo>
                  <a:pt x="1666" y="1077"/>
                </a:lnTo>
                <a:lnTo>
                  <a:pt x="1687" y="1090"/>
                </a:lnTo>
                <a:lnTo>
                  <a:pt x="1708" y="1104"/>
                </a:lnTo>
                <a:lnTo>
                  <a:pt x="1729" y="1117"/>
                </a:lnTo>
                <a:lnTo>
                  <a:pt x="1750" y="1131"/>
                </a:lnTo>
                <a:lnTo>
                  <a:pt x="1770" y="1144"/>
                </a:lnTo>
                <a:lnTo>
                  <a:pt x="1791" y="1158"/>
                </a:lnTo>
                <a:lnTo>
                  <a:pt x="1812" y="1171"/>
                </a:lnTo>
                <a:lnTo>
                  <a:pt x="1833" y="1185"/>
                </a:lnTo>
                <a:lnTo>
                  <a:pt x="1854" y="1198"/>
                </a:lnTo>
                <a:lnTo>
                  <a:pt x="1875" y="1211"/>
                </a:lnTo>
                <a:lnTo>
                  <a:pt x="1895" y="1225"/>
                </a:lnTo>
                <a:lnTo>
                  <a:pt x="1916" y="1238"/>
                </a:lnTo>
                <a:lnTo>
                  <a:pt x="1937" y="1252"/>
                </a:lnTo>
                <a:lnTo>
                  <a:pt x="1958" y="1265"/>
                </a:lnTo>
                <a:lnTo>
                  <a:pt x="1979" y="1279"/>
                </a:lnTo>
                <a:lnTo>
                  <a:pt x="2000" y="1292"/>
                </a:lnTo>
                <a:lnTo>
                  <a:pt x="2020" y="1306"/>
                </a:lnTo>
                <a:lnTo>
                  <a:pt x="2041" y="1319"/>
                </a:lnTo>
                <a:lnTo>
                  <a:pt x="2062" y="1333"/>
                </a:lnTo>
                <a:lnTo>
                  <a:pt x="2083" y="1346"/>
                </a:lnTo>
                <a:lnTo>
                  <a:pt x="2104" y="1359"/>
                </a:lnTo>
                <a:lnTo>
                  <a:pt x="2124" y="1373"/>
                </a:lnTo>
                <a:lnTo>
                  <a:pt x="2145" y="1386"/>
                </a:lnTo>
                <a:lnTo>
                  <a:pt x="2166" y="1400"/>
                </a:lnTo>
                <a:lnTo>
                  <a:pt x="2187" y="1413"/>
                </a:lnTo>
                <a:lnTo>
                  <a:pt x="2208" y="1427"/>
                </a:lnTo>
                <a:lnTo>
                  <a:pt x="2229" y="1440"/>
                </a:lnTo>
                <a:lnTo>
                  <a:pt x="2249" y="1454"/>
                </a:lnTo>
                <a:lnTo>
                  <a:pt x="2270" y="1467"/>
                </a:lnTo>
                <a:lnTo>
                  <a:pt x="2291" y="1481"/>
                </a:lnTo>
                <a:lnTo>
                  <a:pt x="2312" y="1494"/>
                </a:lnTo>
                <a:lnTo>
                  <a:pt x="2333" y="1508"/>
                </a:lnTo>
                <a:lnTo>
                  <a:pt x="2354" y="1521"/>
                </a:lnTo>
                <a:lnTo>
                  <a:pt x="2374" y="1534"/>
                </a:lnTo>
                <a:lnTo>
                  <a:pt x="2395" y="1548"/>
                </a:lnTo>
                <a:lnTo>
                  <a:pt x="2416" y="1561"/>
                </a:lnTo>
                <a:lnTo>
                  <a:pt x="2437" y="1575"/>
                </a:lnTo>
                <a:lnTo>
                  <a:pt x="2458" y="1588"/>
                </a:lnTo>
                <a:lnTo>
                  <a:pt x="2479" y="1602"/>
                </a:lnTo>
                <a:lnTo>
                  <a:pt x="2499" y="1615"/>
                </a:lnTo>
                <a:lnTo>
                  <a:pt x="2520" y="1629"/>
                </a:lnTo>
                <a:lnTo>
                  <a:pt x="2541" y="1642"/>
                </a:lnTo>
                <a:lnTo>
                  <a:pt x="2562" y="1656"/>
                </a:lnTo>
                <a:lnTo>
                  <a:pt x="2583" y="1669"/>
                </a:lnTo>
                <a:lnTo>
                  <a:pt x="2603" y="1682"/>
                </a:lnTo>
                <a:lnTo>
                  <a:pt x="2624" y="1696"/>
                </a:lnTo>
                <a:lnTo>
                  <a:pt x="2645" y="1709"/>
                </a:lnTo>
                <a:lnTo>
                  <a:pt x="2666" y="1723"/>
                </a:lnTo>
                <a:lnTo>
                  <a:pt x="2687" y="1736"/>
                </a:lnTo>
                <a:lnTo>
                  <a:pt x="2708" y="1750"/>
                </a:lnTo>
                <a:lnTo>
                  <a:pt x="2728" y="1763"/>
                </a:lnTo>
                <a:lnTo>
                  <a:pt x="2749" y="1777"/>
                </a:lnTo>
                <a:lnTo>
                  <a:pt x="2770" y="1790"/>
                </a:lnTo>
                <a:lnTo>
                  <a:pt x="2791" y="1804"/>
                </a:lnTo>
                <a:lnTo>
                  <a:pt x="2812" y="1817"/>
                </a:lnTo>
                <a:lnTo>
                  <a:pt x="2833" y="1830"/>
                </a:lnTo>
                <a:lnTo>
                  <a:pt x="2853" y="1844"/>
                </a:lnTo>
                <a:lnTo>
                  <a:pt x="2874" y="1857"/>
                </a:lnTo>
                <a:lnTo>
                  <a:pt x="2895" y="1871"/>
                </a:lnTo>
                <a:lnTo>
                  <a:pt x="2916" y="1884"/>
                </a:lnTo>
                <a:lnTo>
                  <a:pt x="2937" y="1898"/>
                </a:lnTo>
                <a:lnTo>
                  <a:pt x="2957" y="1911"/>
                </a:lnTo>
                <a:lnTo>
                  <a:pt x="2978" y="1925"/>
                </a:lnTo>
                <a:lnTo>
                  <a:pt x="2999" y="1938"/>
                </a:lnTo>
                <a:lnTo>
                  <a:pt x="3020" y="1952"/>
                </a:lnTo>
                <a:lnTo>
                  <a:pt x="3041" y="1965"/>
                </a:lnTo>
                <a:lnTo>
                  <a:pt x="3062" y="1978"/>
                </a:lnTo>
                <a:lnTo>
                  <a:pt x="3082" y="1992"/>
                </a:lnTo>
                <a:lnTo>
                  <a:pt x="3103" y="2005"/>
                </a:lnTo>
                <a:lnTo>
                  <a:pt x="3124" y="2019"/>
                </a:lnTo>
                <a:lnTo>
                  <a:pt x="3145" y="2032"/>
                </a:lnTo>
                <a:lnTo>
                  <a:pt x="3166" y="2046"/>
                </a:lnTo>
                <a:lnTo>
                  <a:pt x="3187" y="2059"/>
                </a:lnTo>
                <a:lnTo>
                  <a:pt x="3207" y="2073"/>
                </a:lnTo>
                <a:lnTo>
                  <a:pt x="3228" y="2086"/>
                </a:lnTo>
                <a:lnTo>
                  <a:pt x="3249" y="2100"/>
                </a:lnTo>
                <a:lnTo>
                  <a:pt x="3270" y="2113"/>
                </a:lnTo>
                <a:lnTo>
                  <a:pt x="3291" y="2126"/>
                </a:lnTo>
                <a:lnTo>
                  <a:pt x="3311" y="2140"/>
                </a:lnTo>
                <a:lnTo>
                  <a:pt x="3332" y="2153"/>
                </a:lnTo>
                <a:lnTo>
                  <a:pt x="3353" y="2167"/>
                </a:lnTo>
                <a:lnTo>
                  <a:pt x="3374" y="2180"/>
                </a:lnTo>
                <a:lnTo>
                  <a:pt x="3395" y="2194"/>
                </a:lnTo>
                <a:lnTo>
                  <a:pt x="3416" y="2207"/>
                </a:lnTo>
                <a:lnTo>
                  <a:pt x="3436" y="2221"/>
                </a:lnTo>
                <a:lnTo>
                  <a:pt x="3457" y="2234"/>
                </a:lnTo>
                <a:lnTo>
                  <a:pt x="3478" y="2248"/>
                </a:lnTo>
                <a:lnTo>
                  <a:pt x="3499" y="2261"/>
                </a:lnTo>
                <a:lnTo>
                  <a:pt x="3520" y="2274"/>
                </a:lnTo>
                <a:lnTo>
                  <a:pt x="3541" y="2288"/>
                </a:lnTo>
                <a:lnTo>
                  <a:pt x="3561" y="2301"/>
                </a:lnTo>
                <a:lnTo>
                  <a:pt x="3582" y="2315"/>
                </a:lnTo>
                <a:lnTo>
                  <a:pt x="3603" y="2328"/>
                </a:lnTo>
                <a:lnTo>
                  <a:pt x="3624" y="2342"/>
                </a:lnTo>
                <a:lnTo>
                  <a:pt x="3645" y="2355"/>
                </a:lnTo>
                <a:lnTo>
                  <a:pt x="3666" y="2369"/>
                </a:lnTo>
                <a:lnTo>
                  <a:pt x="3686" y="2382"/>
                </a:lnTo>
                <a:lnTo>
                  <a:pt x="3707" y="2396"/>
                </a:lnTo>
                <a:lnTo>
                  <a:pt x="3728" y="2409"/>
                </a:lnTo>
                <a:lnTo>
                  <a:pt x="3749" y="2422"/>
                </a:lnTo>
                <a:lnTo>
                  <a:pt x="3770" y="2436"/>
                </a:lnTo>
                <a:lnTo>
                  <a:pt x="3790" y="2449"/>
                </a:lnTo>
                <a:lnTo>
                  <a:pt x="3811" y="2463"/>
                </a:lnTo>
                <a:lnTo>
                  <a:pt x="3832" y="2476"/>
                </a:lnTo>
                <a:lnTo>
                  <a:pt x="3853" y="2490"/>
                </a:lnTo>
                <a:lnTo>
                  <a:pt x="3874" y="2503"/>
                </a:lnTo>
                <a:lnTo>
                  <a:pt x="3895" y="2517"/>
                </a:lnTo>
                <a:lnTo>
                  <a:pt x="3915" y="2530"/>
                </a:lnTo>
                <a:lnTo>
                  <a:pt x="3936" y="2544"/>
                </a:lnTo>
                <a:lnTo>
                  <a:pt x="3957" y="2557"/>
                </a:lnTo>
                <a:lnTo>
                  <a:pt x="3978" y="2570"/>
                </a:lnTo>
                <a:lnTo>
                  <a:pt x="3999" y="2584"/>
                </a:lnTo>
                <a:lnTo>
                  <a:pt x="4020" y="2597"/>
                </a:lnTo>
                <a:lnTo>
                  <a:pt x="4040" y="2611"/>
                </a:lnTo>
                <a:lnTo>
                  <a:pt x="4061" y="2624"/>
                </a:lnTo>
                <a:lnTo>
                  <a:pt x="4082" y="2638"/>
                </a:lnTo>
                <a:lnTo>
                  <a:pt x="4103" y="2651"/>
                </a:lnTo>
                <a:lnTo>
                  <a:pt x="4124" y="2665"/>
                </a:lnTo>
                <a:lnTo>
                  <a:pt x="4144" y="2678"/>
                </a:lnTo>
                <a:lnTo>
                  <a:pt x="4165" y="2692"/>
                </a:lnTo>
                <a:lnTo>
                  <a:pt x="4186" y="2705"/>
                </a:lnTo>
                <a:lnTo>
                  <a:pt x="4207" y="2719"/>
                </a:lnTo>
                <a:lnTo>
                  <a:pt x="4228" y="2732"/>
                </a:lnTo>
                <a:lnTo>
                  <a:pt x="4249" y="2745"/>
                </a:lnTo>
                <a:lnTo>
                  <a:pt x="4269" y="2759"/>
                </a:lnTo>
                <a:lnTo>
                  <a:pt x="4290" y="2772"/>
                </a:lnTo>
                <a:lnTo>
                  <a:pt x="4311" y="2786"/>
                </a:lnTo>
                <a:lnTo>
                  <a:pt x="4332" y="2799"/>
                </a:lnTo>
                <a:lnTo>
                  <a:pt x="4353" y="2813"/>
                </a:lnTo>
                <a:lnTo>
                  <a:pt x="4374" y="2826"/>
                </a:lnTo>
                <a:lnTo>
                  <a:pt x="4394" y="2840"/>
                </a:lnTo>
                <a:lnTo>
                  <a:pt x="4415" y="2853"/>
                </a:lnTo>
                <a:lnTo>
                  <a:pt x="4436" y="2867"/>
                </a:lnTo>
                <a:lnTo>
                  <a:pt x="4457" y="2880"/>
                </a:lnTo>
                <a:lnTo>
                  <a:pt x="4478" y="2893"/>
                </a:lnTo>
                <a:lnTo>
                  <a:pt x="4498" y="2907"/>
                </a:lnTo>
                <a:lnTo>
                  <a:pt x="4519" y="2920"/>
                </a:lnTo>
                <a:lnTo>
                  <a:pt x="4540" y="2934"/>
                </a:lnTo>
                <a:lnTo>
                  <a:pt x="4561" y="2947"/>
                </a:lnTo>
                <a:lnTo>
                  <a:pt x="4582" y="2961"/>
                </a:lnTo>
                <a:lnTo>
                  <a:pt x="4603" y="2974"/>
                </a:lnTo>
                <a:lnTo>
                  <a:pt x="4623" y="2988"/>
                </a:lnTo>
                <a:lnTo>
                  <a:pt x="4644" y="3001"/>
                </a:lnTo>
                <a:lnTo>
                  <a:pt x="4665" y="3015"/>
                </a:lnTo>
              </a:path>
            </a:pathLst>
          </a:cu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27" name="Line 60"/>
          <p:cNvSpPr>
            <a:spLocks noChangeShapeType="1"/>
          </p:cNvSpPr>
          <p:nvPr/>
        </p:nvSpPr>
        <p:spPr bwMode="auto">
          <a:xfrm flipV="1">
            <a:off x="6891338" y="2895551"/>
            <a:ext cx="6350" cy="3175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28" name="Rectangle 61"/>
          <p:cNvSpPr>
            <a:spLocks noChangeArrowheads="1"/>
          </p:cNvSpPr>
          <p:nvPr/>
        </p:nvSpPr>
        <p:spPr bwMode="auto">
          <a:xfrm>
            <a:off x="6496050" y="2468513"/>
            <a:ext cx="50800" cy="52387"/>
          </a:xfrm>
          <a:prstGeom prst="rect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29" name="Rectangle 62"/>
          <p:cNvSpPr>
            <a:spLocks noChangeArrowheads="1"/>
          </p:cNvSpPr>
          <p:nvPr/>
        </p:nvSpPr>
        <p:spPr bwMode="auto">
          <a:xfrm>
            <a:off x="5640388" y="2966988"/>
            <a:ext cx="52387" cy="50800"/>
          </a:xfrm>
          <a:prstGeom prst="rect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30" name="Rectangle 63"/>
          <p:cNvSpPr>
            <a:spLocks noChangeArrowheads="1"/>
          </p:cNvSpPr>
          <p:nvPr/>
        </p:nvSpPr>
        <p:spPr bwMode="auto">
          <a:xfrm>
            <a:off x="4999038" y="3575001"/>
            <a:ext cx="50800" cy="52387"/>
          </a:xfrm>
          <a:prstGeom prst="rect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31" name="Rectangle 64"/>
          <p:cNvSpPr>
            <a:spLocks noChangeArrowheads="1"/>
          </p:cNvSpPr>
          <p:nvPr/>
        </p:nvSpPr>
        <p:spPr bwMode="auto">
          <a:xfrm>
            <a:off x="4498975" y="4036963"/>
            <a:ext cx="52387" cy="50800"/>
          </a:xfrm>
          <a:prstGeom prst="rect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32" name="Rectangle 65"/>
          <p:cNvSpPr>
            <a:spLocks noChangeArrowheads="1"/>
          </p:cNvSpPr>
          <p:nvPr/>
        </p:nvSpPr>
        <p:spPr bwMode="auto">
          <a:xfrm>
            <a:off x="4249738" y="4483051"/>
            <a:ext cx="52387" cy="50800"/>
          </a:xfrm>
          <a:prstGeom prst="rect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33" name="Line 66"/>
          <p:cNvSpPr>
            <a:spLocks noChangeShapeType="1"/>
          </p:cNvSpPr>
          <p:nvPr/>
        </p:nvSpPr>
        <p:spPr bwMode="auto">
          <a:xfrm flipV="1">
            <a:off x="2767013" y="5649863"/>
            <a:ext cx="17462" cy="15875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34" name="Freeform 67"/>
          <p:cNvSpPr>
            <a:spLocks/>
          </p:cNvSpPr>
          <p:nvPr/>
        </p:nvSpPr>
        <p:spPr bwMode="auto">
          <a:xfrm flipV="1">
            <a:off x="2784475" y="2420888"/>
            <a:ext cx="3687762" cy="3228975"/>
          </a:xfrm>
          <a:custGeom>
            <a:avLst/>
            <a:gdLst>
              <a:gd name="T0" fmla="*/ 62 w 4040"/>
              <a:gd name="T1" fmla="*/ 54 h 3526"/>
              <a:gd name="T2" fmla="*/ 146 w 4040"/>
              <a:gd name="T3" fmla="*/ 127 h 3526"/>
              <a:gd name="T4" fmla="*/ 229 w 4040"/>
              <a:gd name="T5" fmla="*/ 200 h 3526"/>
              <a:gd name="T6" fmla="*/ 312 w 4040"/>
              <a:gd name="T7" fmla="*/ 272 h 3526"/>
              <a:gd name="T8" fmla="*/ 396 w 4040"/>
              <a:gd name="T9" fmla="*/ 345 h 3526"/>
              <a:gd name="T10" fmla="*/ 479 w 4040"/>
              <a:gd name="T11" fmla="*/ 418 h 3526"/>
              <a:gd name="T12" fmla="*/ 562 w 4040"/>
              <a:gd name="T13" fmla="*/ 490 h 3526"/>
              <a:gd name="T14" fmla="*/ 646 w 4040"/>
              <a:gd name="T15" fmla="*/ 563 h 3526"/>
              <a:gd name="T16" fmla="*/ 729 w 4040"/>
              <a:gd name="T17" fmla="*/ 636 h 3526"/>
              <a:gd name="T18" fmla="*/ 812 w 4040"/>
              <a:gd name="T19" fmla="*/ 709 h 3526"/>
              <a:gd name="T20" fmla="*/ 895 w 4040"/>
              <a:gd name="T21" fmla="*/ 781 h 3526"/>
              <a:gd name="T22" fmla="*/ 979 w 4040"/>
              <a:gd name="T23" fmla="*/ 854 h 3526"/>
              <a:gd name="T24" fmla="*/ 1062 w 4040"/>
              <a:gd name="T25" fmla="*/ 927 h 3526"/>
              <a:gd name="T26" fmla="*/ 1145 w 4040"/>
              <a:gd name="T27" fmla="*/ 999 h 3526"/>
              <a:gd name="T28" fmla="*/ 1229 w 4040"/>
              <a:gd name="T29" fmla="*/ 1072 h 3526"/>
              <a:gd name="T30" fmla="*/ 1312 w 4040"/>
              <a:gd name="T31" fmla="*/ 1145 h 3526"/>
              <a:gd name="T32" fmla="*/ 1395 w 4040"/>
              <a:gd name="T33" fmla="*/ 1218 h 3526"/>
              <a:gd name="T34" fmla="*/ 1479 w 4040"/>
              <a:gd name="T35" fmla="*/ 1290 h 3526"/>
              <a:gd name="T36" fmla="*/ 1562 w 4040"/>
              <a:gd name="T37" fmla="*/ 1363 h 3526"/>
              <a:gd name="T38" fmla="*/ 1645 w 4040"/>
              <a:gd name="T39" fmla="*/ 1436 h 3526"/>
              <a:gd name="T40" fmla="*/ 1728 w 4040"/>
              <a:gd name="T41" fmla="*/ 1508 h 3526"/>
              <a:gd name="T42" fmla="*/ 1812 w 4040"/>
              <a:gd name="T43" fmla="*/ 1581 h 3526"/>
              <a:gd name="T44" fmla="*/ 1895 w 4040"/>
              <a:gd name="T45" fmla="*/ 1654 h 3526"/>
              <a:gd name="T46" fmla="*/ 1978 w 4040"/>
              <a:gd name="T47" fmla="*/ 1727 h 3526"/>
              <a:gd name="T48" fmla="*/ 2062 w 4040"/>
              <a:gd name="T49" fmla="*/ 1799 h 3526"/>
              <a:gd name="T50" fmla="*/ 2145 w 4040"/>
              <a:gd name="T51" fmla="*/ 1872 h 3526"/>
              <a:gd name="T52" fmla="*/ 2228 w 4040"/>
              <a:gd name="T53" fmla="*/ 1945 h 3526"/>
              <a:gd name="T54" fmla="*/ 2312 w 4040"/>
              <a:gd name="T55" fmla="*/ 2017 h 3526"/>
              <a:gd name="T56" fmla="*/ 2395 w 4040"/>
              <a:gd name="T57" fmla="*/ 2090 h 3526"/>
              <a:gd name="T58" fmla="*/ 2478 w 4040"/>
              <a:gd name="T59" fmla="*/ 2163 h 3526"/>
              <a:gd name="T60" fmla="*/ 2561 w 4040"/>
              <a:gd name="T61" fmla="*/ 2236 h 3526"/>
              <a:gd name="T62" fmla="*/ 2645 w 4040"/>
              <a:gd name="T63" fmla="*/ 2308 h 3526"/>
              <a:gd name="T64" fmla="*/ 2728 w 4040"/>
              <a:gd name="T65" fmla="*/ 2381 h 3526"/>
              <a:gd name="T66" fmla="*/ 2811 w 4040"/>
              <a:gd name="T67" fmla="*/ 2454 h 3526"/>
              <a:gd name="T68" fmla="*/ 2895 w 4040"/>
              <a:gd name="T69" fmla="*/ 2526 h 3526"/>
              <a:gd name="T70" fmla="*/ 2978 w 4040"/>
              <a:gd name="T71" fmla="*/ 2599 h 3526"/>
              <a:gd name="T72" fmla="*/ 3061 w 4040"/>
              <a:gd name="T73" fmla="*/ 2672 h 3526"/>
              <a:gd name="T74" fmla="*/ 3144 w 4040"/>
              <a:gd name="T75" fmla="*/ 2745 h 3526"/>
              <a:gd name="T76" fmla="*/ 3228 w 4040"/>
              <a:gd name="T77" fmla="*/ 2817 h 3526"/>
              <a:gd name="T78" fmla="*/ 3311 w 4040"/>
              <a:gd name="T79" fmla="*/ 2890 h 3526"/>
              <a:gd name="T80" fmla="*/ 3394 w 4040"/>
              <a:gd name="T81" fmla="*/ 2963 h 3526"/>
              <a:gd name="T82" fmla="*/ 3478 w 4040"/>
              <a:gd name="T83" fmla="*/ 3035 h 3526"/>
              <a:gd name="T84" fmla="*/ 3561 w 4040"/>
              <a:gd name="T85" fmla="*/ 3108 h 3526"/>
              <a:gd name="T86" fmla="*/ 3644 w 4040"/>
              <a:gd name="T87" fmla="*/ 3181 h 3526"/>
              <a:gd name="T88" fmla="*/ 3728 w 4040"/>
              <a:gd name="T89" fmla="*/ 3254 h 3526"/>
              <a:gd name="T90" fmla="*/ 3811 w 4040"/>
              <a:gd name="T91" fmla="*/ 3326 h 3526"/>
              <a:gd name="T92" fmla="*/ 3894 w 4040"/>
              <a:gd name="T93" fmla="*/ 3399 h 3526"/>
              <a:gd name="T94" fmla="*/ 3977 w 4040"/>
              <a:gd name="T95" fmla="*/ 3472 h 35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</a:cxnLst>
            <a:rect l="0" t="0" r="r" b="b"/>
            <a:pathLst>
              <a:path w="4040" h="3526">
                <a:moveTo>
                  <a:pt x="0" y="0"/>
                </a:moveTo>
                <a:lnTo>
                  <a:pt x="21" y="18"/>
                </a:lnTo>
                <a:lnTo>
                  <a:pt x="42" y="36"/>
                </a:lnTo>
                <a:lnTo>
                  <a:pt x="62" y="54"/>
                </a:lnTo>
                <a:lnTo>
                  <a:pt x="83" y="72"/>
                </a:lnTo>
                <a:lnTo>
                  <a:pt x="104" y="91"/>
                </a:lnTo>
                <a:lnTo>
                  <a:pt x="125" y="109"/>
                </a:lnTo>
                <a:lnTo>
                  <a:pt x="146" y="127"/>
                </a:lnTo>
                <a:lnTo>
                  <a:pt x="167" y="145"/>
                </a:lnTo>
                <a:lnTo>
                  <a:pt x="187" y="163"/>
                </a:lnTo>
                <a:lnTo>
                  <a:pt x="208" y="181"/>
                </a:lnTo>
                <a:lnTo>
                  <a:pt x="229" y="200"/>
                </a:lnTo>
                <a:lnTo>
                  <a:pt x="250" y="218"/>
                </a:lnTo>
                <a:lnTo>
                  <a:pt x="271" y="236"/>
                </a:lnTo>
                <a:lnTo>
                  <a:pt x="292" y="254"/>
                </a:lnTo>
                <a:lnTo>
                  <a:pt x="312" y="272"/>
                </a:lnTo>
                <a:lnTo>
                  <a:pt x="333" y="290"/>
                </a:lnTo>
                <a:lnTo>
                  <a:pt x="354" y="309"/>
                </a:lnTo>
                <a:lnTo>
                  <a:pt x="375" y="327"/>
                </a:lnTo>
                <a:lnTo>
                  <a:pt x="396" y="345"/>
                </a:lnTo>
                <a:lnTo>
                  <a:pt x="416" y="363"/>
                </a:lnTo>
                <a:lnTo>
                  <a:pt x="437" y="381"/>
                </a:lnTo>
                <a:lnTo>
                  <a:pt x="458" y="400"/>
                </a:lnTo>
                <a:lnTo>
                  <a:pt x="479" y="418"/>
                </a:lnTo>
                <a:lnTo>
                  <a:pt x="500" y="436"/>
                </a:lnTo>
                <a:lnTo>
                  <a:pt x="521" y="454"/>
                </a:lnTo>
                <a:lnTo>
                  <a:pt x="541" y="472"/>
                </a:lnTo>
                <a:lnTo>
                  <a:pt x="562" y="490"/>
                </a:lnTo>
                <a:lnTo>
                  <a:pt x="583" y="509"/>
                </a:lnTo>
                <a:lnTo>
                  <a:pt x="604" y="527"/>
                </a:lnTo>
                <a:lnTo>
                  <a:pt x="625" y="545"/>
                </a:lnTo>
                <a:lnTo>
                  <a:pt x="646" y="563"/>
                </a:lnTo>
                <a:lnTo>
                  <a:pt x="666" y="581"/>
                </a:lnTo>
                <a:lnTo>
                  <a:pt x="687" y="600"/>
                </a:lnTo>
                <a:lnTo>
                  <a:pt x="708" y="618"/>
                </a:lnTo>
                <a:lnTo>
                  <a:pt x="729" y="636"/>
                </a:lnTo>
                <a:lnTo>
                  <a:pt x="750" y="654"/>
                </a:lnTo>
                <a:lnTo>
                  <a:pt x="770" y="672"/>
                </a:lnTo>
                <a:lnTo>
                  <a:pt x="791" y="690"/>
                </a:lnTo>
                <a:lnTo>
                  <a:pt x="812" y="709"/>
                </a:lnTo>
                <a:lnTo>
                  <a:pt x="833" y="727"/>
                </a:lnTo>
                <a:lnTo>
                  <a:pt x="854" y="745"/>
                </a:lnTo>
                <a:lnTo>
                  <a:pt x="875" y="763"/>
                </a:lnTo>
                <a:lnTo>
                  <a:pt x="895" y="781"/>
                </a:lnTo>
                <a:lnTo>
                  <a:pt x="916" y="799"/>
                </a:lnTo>
                <a:lnTo>
                  <a:pt x="937" y="818"/>
                </a:lnTo>
                <a:lnTo>
                  <a:pt x="958" y="836"/>
                </a:lnTo>
                <a:lnTo>
                  <a:pt x="979" y="854"/>
                </a:lnTo>
                <a:lnTo>
                  <a:pt x="1000" y="872"/>
                </a:lnTo>
                <a:lnTo>
                  <a:pt x="1020" y="890"/>
                </a:lnTo>
                <a:lnTo>
                  <a:pt x="1041" y="909"/>
                </a:lnTo>
                <a:lnTo>
                  <a:pt x="1062" y="927"/>
                </a:lnTo>
                <a:lnTo>
                  <a:pt x="1083" y="945"/>
                </a:lnTo>
                <a:lnTo>
                  <a:pt x="1104" y="963"/>
                </a:lnTo>
                <a:lnTo>
                  <a:pt x="1125" y="981"/>
                </a:lnTo>
                <a:lnTo>
                  <a:pt x="1145" y="999"/>
                </a:lnTo>
                <a:lnTo>
                  <a:pt x="1166" y="1018"/>
                </a:lnTo>
                <a:lnTo>
                  <a:pt x="1187" y="1036"/>
                </a:lnTo>
                <a:lnTo>
                  <a:pt x="1208" y="1054"/>
                </a:lnTo>
                <a:lnTo>
                  <a:pt x="1229" y="1072"/>
                </a:lnTo>
                <a:lnTo>
                  <a:pt x="1249" y="1090"/>
                </a:lnTo>
                <a:lnTo>
                  <a:pt x="1270" y="1109"/>
                </a:lnTo>
                <a:lnTo>
                  <a:pt x="1291" y="1127"/>
                </a:lnTo>
                <a:lnTo>
                  <a:pt x="1312" y="1145"/>
                </a:lnTo>
                <a:lnTo>
                  <a:pt x="1333" y="1163"/>
                </a:lnTo>
                <a:lnTo>
                  <a:pt x="1354" y="1181"/>
                </a:lnTo>
                <a:lnTo>
                  <a:pt x="1374" y="1199"/>
                </a:lnTo>
                <a:lnTo>
                  <a:pt x="1395" y="1218"/>
                </a:lnTo>
                <a:lnTo>
                  <a:pt x="1416" y="1236"/>
                </a:lnTo>
                <a:lnTo>
                  <a:pt x="1437" y="1254"/>
                </a:lnTo>
                <a:lnTo>
                  <a:pt x="1458" y="1272"/>
                </a:lnTo>
                <a:lnTo>
                  <a:pt x="1479" y="1290"/>
                </a:lnTo>
                <a:lnTo>
                  <a:pt x="1499" y="1308"/>
                </a:lnTo>
                <a:lnTo>
                  <a:pt x="1520" y="1327"/>
                </a:lnTo>
                <a:lnTo>
                  <a:pt x="1541" y="1345"/>
                </a:lnTo>
                <a:lnTo>
                  <a:pt x="1562" y="1363"/>
                </a:lnTo>
                <a:lnTo>
                  <a:pt x="1583" y="1381"/>
                </a:lnTo>
                <a:lnTo>
                  <a:pt x="1603" y="1399"/>
                </a:lnTo>
                <a:lnTo>
                  <a:pt x="1624" y="1418"/>
                </a:lnTo>
                <a:lnTo>
                  <a:pt x="1645" y="1436"/>
                </a:lnTo>
                <a:lnTo>
                  <a:pt x="1666" y="1454"/>
                </a:lnTo>
                <a:lnTo>
                  <a:pt x="1687" y="1472"/>
                </a:lnTo>
                <a:lnTo>
                  <a:pt x="1708" y="1490"/>
                </a:lnTo>
                <a:lnTo>
                  <a:pt x="1728" y="1508"/>
                </a:lnTo>
                <a:lnTo>
                  <a:pt x="1749" y="1527"/>
                </a:lnTo>
                <a:lnTo>
                  <a:pt x="1770" y="1545"/>
                </a:lnTo>
                <a:lnTo>
                  <a:pt x="1791" y="1563"/>
                </a:lnTo>
                <a:lnTo>
                  <a:pt x="1812" y="1581"/>
                </a:lnTo>
                <a:lnTo>
                  <a:pt x="1833" y="1599"/>
                </a:lnTo>
                <a:lnTo>
                  <a:pt x="1853" y="1618"/>
                </a:lnTo>
                <a:lnTo>
                  <a:pt x="1874" y="1636"/>
                </a:lnTo>
                <a:lnTo>
                  <a:pt x="1895" y="1654"/>
                </a:lnTo>
                <a:lnTo>
                  <a:pt x="1916" y="1672"/>
                </a:lnTo>
                <a:lnTo>
                  <a:pt x="1937" y="1690"/>
                </a:lnTo>
                <a:lnTo>
                  <a:pt x="1957" y="1708"/>
                </a:lnTo>
                <a:lnTo>
                  <a:pt x="1978" y="1727"/>
                </a:lnTo>
                <a:lnTo>
                  <a:pt x="1999" y="1745"/>
                </a:lnTo>
                <a:lnTo>
                  <a:pt x="2020" y="1763"/>
                </a:lnTo>
                <a:lnTo>
                  <a:pt x="2041" y="1781"/>
                </a:lnTo>
                <a:lnTo>
                  <a:pt x="2062" y="1799"/>
                </a:lnTo>
                <a:lnTo>
                  <a:pt x="2082" y="1817"/>
                </a:lnTo>
                <a:lnTo>
                  <a:pt x="2103" y="1836"/>
                </a:lnTo>
                <a:lnTo>
                  <a:pt x="2124" y="1854"/>
                </a:lnTo>
                <a:lnTo>
                  <a:pt x="2145" y="1872"/>
                </a:lnTo>
                <a:lnTo>
                  <a:pt x="2166" y="1890"/>
                </a:lnTo>
                <a:lnTo>
                  <a:pt x="2187" y="1908"/>
                </a:lnTo>
                <a:lnTo>
                  <a:pt x="2207" y="1927"/>
                </a:lnTo>
                <a:lnTo>
                  <a:pt x="2228" y="1945"/>
                </a:lnTo>
                <a:lnTo>
                  <a:pt x="2249" y="1963"/>
                </a:lnTo>
                <a:lnTo>
                  <a:pt x="2270" y="1981"/>
                </a:lnTo>
                <a:lnTo>
                  <a:pt x="2291" y="1999"/>
                </a:lnTo>
                <a:lnTo>
                  <a:pt x="2312" y="2017"/>
                </a:lnTo>
                <a:lnTo>
                  <a:pt x="2332" y="2036"/>
                </a:lnTo>
                <a:lnTo>
                  <a:pt x="2353" y="2054"/>
                </a:lnTo>
                <a:lnTo>
                  <a:pt x="2374" y="2072"/>
                </a:lnTo>
                <a:lnTo>
                  <a:pt x="2395" y="2090"/>
                </a:lnTo>
                <a:lnTo>
                  <a:pt x="2416" y="2108"/>
                </a:lnTo>
                <a:lnTo>
                  <a:pt x="2436" y="2127"/>
                </a:lnTo>
                <a:lnTo>
                  <a:pt x="2457" y="2145"/>
                </a:lnTo>
                <a:lnTo>
                  <a:pt x="2478" y="2163"/>
                </a:lnTo>
                <a:lnTo>
                  <a:pt x="2499" y="2181"/>
                </a:lnTo>
                <a:lnTo>
                  <a:pt x="2520" y="2199"/>
                </a:lnTo>
                <a:lnTo>
                  <a:pt x="2541" y="2217"/>
                </a:lnTo>
                <a:lnTo>
                  <a:pt x="2561" y="2236"/>
                </a:lnTo>
                <a:lnTo>
                  <a:pt x="2582" y="2254"/>
                </a:lnTo>
                <a:lnTo>
                  <a:pt x="2603" y="2272"/>
                </a:lnTo>
                <a:lnTo>
                  <a:pt x="2624" y="2290"/>
                </a:lnTo>
                <a:lnTo>
                  <a:pt x="2645" y="2308"/>
                </a:lnTo>
                <a:lnTo>
                  <a:pt x="2666" y="2326"/>
                </a:lnTo>
                <a:lnTo>
                  <a:pt x="2686" y="2345"/>
                </a:lnTo>
                <a:lnTo>
                  <a:pt x="2707" y="2363"/>
                </a:lnTo>
                <a:lnTo>
                  <a:pt x="2728" y="2381"/>
                </a:lnTo>
                <a:lnTo>
                  <a:pt x="2749" y="2399"/>
                </a:lnTo>
                <a:lnTo>
                  <a:pt x="2770" y="2417"/>
                </a:lnTo>
                <a:lnTo>
                  <a:pt x="2790" y="2436"/>
                </a:lnTo>
                <a:lnTo>
                  <a:pt x="2811" y="2454"/>
                </a:lnTo>
                <a:lnTo>
                  <a:pt x="2832" y="2472"/>
                </a:lnTo>
                <a:lnTo>
                  <a:pt x="2853" y="2490"/>
                </a:lnTo>
                <a:lnTo>
                  <a:pt x="2874" y="2508"/>
                </a:lnTo>
                <a:lnTo>
                  <a:pt x="2895" y="2526"/>
                </a:lnTo>
                <a:lnTo>
                  <a:pt x="2915" y="2545"/>
                </a:lnTo>
                <a:lnTo>
                  <a:pt x="2936" y="2563"/>
                </a:lnTo>
                <a:lnTo>
                  <a:pt x="2957" y="2581"/>
                </a:lnTo>
                <a:lnTo>
                  <a:pt x="2978" y="2599"/>
                </a:lnTo>
                <a:lnTo>
                  <a:pt x="2999" y="2617"/>
                </a:lnTo>
                <a:lnTo>
                  <a:pt x="3020" y="2636"/>
                </a:lnTo>
                <a:lnTo>
                  <a:pt x="3040" y="2654"/>
                </a:lnTo>
                <a:lnTo>
                  <a:pt x="3061" y="2672"/>
                </a:lnTo>
                <a:lnTo>
                  <a:pt x="3082" y="2690"/>
                </a:lnTo>
                <a:lnTo>
                  <a:pt x="3103" y="2708"/>
                </a:lnTo>
                <a:lnTo>
                  <a:pt x="3124" y="2726"/>
                </a:lnTo>
                <a:lnTo>
                  <a:pt x="3144" y="2745"/>
                </a:lnTo>
                <a:lnTo>
                  <a:pt x="3165" y="2763"/>
                </a:lnTo>
                <a:lnTo>
                  <a:pt x="3186" y="2781"/>
                </a:lnTo>
                <a:lnTo>
                  <a:pt x="3207" y="2799"/>
                </a:lnTo>
                <a:lnTo>
                  <a:pt x="3228" y="2817"/>
                </a:lnTo>
                <a:lnTo>
                  <a:pt x="3249" y="2835"/>
                </a:lnTo>
                <a:lnTo>
                  <a:pt x="3269" y="2854"/>
                </a:lnTo>
                <a:lnTo>
                  <a:pt x="3290" y="2872"/>
                </a:lnTo>
                <a:lnTo>
                  <a:pt x="3311" y="2890"/>
                </a:lnTo>
                <a:lnTo>
                  <a:pt x="3332" y="2908"/>
                </a:lnTo>
                <a:lnTo>
                  <a:pt x="3353" y="2926"/>
                </a:lnTo>
                <a:lnTo>
                  <a:pt x="3374" y="2945"/>
                </a:lnTo>
                <a:lnTo>
                  <a:pt x="3394" y="2963"/>
                </a:lnTo>
                <a:lnTo>
                  <a:pt x="3415" y="2981"/>
                </a:lnTo>
                <a:lnTo>
                  <a:pt x="3436" y="2999"/>
                </a:lnTo>
                <a:lnTo>
                  <a:pt x="3457" y="3017"/>
                </a:lnTo>
                <a:lnTo>
                  <a:pt x="3478" y="3035"/>
                </a:lnTo>
                <a:lnTo>
                  <a:pt x="3499" y="3054"/>
                </a:lnTo>
                <a:lnTo>
                  <a:pt x="3519" y="3072"/>
                </a:lnTo>
                <a:lnTo>
                  <a:pt x="3540" y="3090"/>
                </a:lnTo>
                <a:lnTo>
                  <a:pt x="3561" y="3108"/>
                </a:lnTo>
                <a:lnTo>
                  <a:pt x="3582" y="3126"/>
                </a:lnTo>
                <a:lnTo>
                  <a:pt x="3603" y="3145"/>
                </a:lnTo>
                <a:lnTo>
                  <a:pt x="3623" y="3163"/>
                </a:lnTo>
                <a:lnTo>
                  <a:pt x="3644" y="3181"/>
                </a:lnTo>
                <a:lnTo>
                  <a:pt x="3665" y="3199"/>
                </a:lnTo>
                <a:lnTo>
                  <a:pt x="3686" y="3217"/>
                </a:lnTo>
                <a:lnTo>
                  <a:pt x="3707" y="3235"/>
                </a:lnTo>
                <a:lnTo>
                  <a:pt x="3728" y="3254"/>
                </a:lnTo>
                <a:lnTo>
                  <a:pt x="3748" y="3272"/>
                </a:lnTo>
                <a:lnTo>
                  <a:pt x="3769" y="3290"/>
                </a:lnTo>
                <a:lnTo>
                  <a:pt x="3790" y="3308"/>
                </a:lnTo>
                <a:lnTo>
                  <a:pt x="3811" y="3326"/>
                </a:lnTo>
                <a:lnTo>
                  <a:pt x="3832" y="3344"/>
                </a:lnTo>
                <a:lnTo>
                  <a:pt x="3853" y="3363"/>
                </a:lnTo>
                <a:lnTo>
                  <a:pt x="3873" y="3381"/>
                </a:lnTo>
                <a:lnTo>
                  <a:pt x="3894" y="3399"/>
                </a:lnTo>
                <a:lnTo>
                  <a:pt x="3915" y="3417"/>
                </a:lnTo>
                <a:lnTo>
                  <a:pt x="3936" y="3435"/>
                </a:lnTo>
                <a:lnTo>
                  <a:pt x="3957" y="3454"/>
                </a:lnTo>
                <a:lnTo>
                  <a:pt x="3977" y="3472"/>
                </a:lnTo>
                <a:lnTo>
                  <a:pt x="3998" y="3490"/>
                </a:lnTo>
                <a:lnTo>
                  <a:pt x="4019" y="3508"/>
                </a:lnTo>
                <a:lnTo>
                  <a:pt x="4040" y="3526"/>
                </a:lnTo>
              </a:path>
            </a:pathLst>
          </a:cu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4135" name="Line 68"/>
          <p:cNvSpPr>
            <a:spLocks noChangeShapeType="1"/>
          </p:cNvSpPr>
          <p:nvPr/>
        </p:nvSpPr>
        <p:spPr bwMode="auto">
          <a:xfrm>
            <a:off x="6472238" y="2420888"/>
            <a:ext cx="0" cy="0"/>
          </a:xfrm>
          <a:prstGeom prst="line">
            <a:avLst/>
          </a:prstGeom>
          <a:noFill/>
          <a:ln w="6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23" name="Rectangle 25"/>
          <p:cNvSpPr>
            <a:spLocks noChangeArrowheads="1"/>
          </p:cNvSpPr>
          <p:nvPr/>
        </p:nvSpPr>
        <p:spPr bwMode="auto">
          <a:xfrm rot="16200000">
            <a:off x="2491048" y="3784662"/>
            <a:ext cx="77810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/V(</a:t>
            </a:r>
            <a:r>
              <a:rPr lang="en-US" sz="1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U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/s)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Rectangle 67"/>
          <p:cNvSpPr>
            <a:spLocks noChangeArrowheads="1"/>
          </p:cNvSpPr>
          <p:nvPr/>
        </p:nvSpPr>
        <p:spPr bwMode="auto">
          <a:xfrm>
            <a:off x="1616075" y="3251151"/>
            <a:ext cx="40272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 µM 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Oval 68"/>
          <p:cNvSpPr>
            <a:spLocks noChangeArrowheads="1"/>
          </p:cNvSpPr>
          <p:nvPr/>
        </p:nvSpPr>
        <p:spPr bwMode="auto">
          <a:xfrm>
            <a:off x="1372393" y="3328711"/>
            <a:ext cx="58738" cy="60325"/>
          </a:xfrm>
          <a:prstGeom prst="ellipse">
            <a:avLst/>
          </a:pr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26" name="Rectangle 69"/>
          <p:cNvSpPr>
            <a:spLocks noChangeArrowheads="1"/>
          </p:cNvSpPr>
          <p:nvPr/>
        </p:nvSpPr>
        <p:spPr bwMode="auto">
          <a:xfrm>
            <a:off x="1616075" y="3481794"/>
            <a:ext cx="50257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 µM 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" name="Rectangle 70"/>
          <p:cNvSpPr>
            <a:spLocks noChangeArrowheads="1"/>
          </p:cNvSpPr>
          <p:nvPr/>
        </p:nvSpPr>
        <p:spPr bwMode="auto">
          <a:xfrm>
            <a:off x="1376362" y="3563322"/>
            <a:ext cx="50800" cy="52388"/>
          </a:xfrm>
          <a:prstGeom prst="rect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28" name="Rectangle 71"/>
          <p:cNvSpPr>
            <a:spLocks noChangeArrowheads="1"/>
          </p:cNvSpPr>
          <p:nvPr/>
        </p:nvSpPr>
        <p:spPr bwMode="auto">
          <a:xfrm>
            <a:off x="1616075" y="3721507"/>
            <a:ext cx="50257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 µM 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" name="Freeform 72"/>
          <p:cNvSpPr>
            <a:spLocks/>
          </p:cNvSpPr>
          <p:nvPr/>
        </p:nvSpPr>
        <p:spPr bwMode="auto">
          <a:xfrm>
            <a:off x="1371600" y="3803035"/>
            <a:ext cx="60325" cy="52388"/>
          </a:xfrm>
          <a:custGeom>
            <a:avLst/>
            <a:gdLst>
              <a:gd name="T0" fmla="*/ 19 w 38"/>
              <a:gd name="T1" fmla="*/ 0 h 33"/>
              <a:gd name="T2" fmla="*/ 38 w 38"/>
              <a:gd name="T3" fmla="*/ 33 h 33"/>
              <a:gd name="T4" fmla="*/ 0 w 38"/>
              <a:gd name="T5" fmla="*/ 33 h 33"/>
              <a:gd name="T6" fmla="*/ 19 w 38"/>
              <a:gd name="T7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8" h="33">
                <a:moveTo>
                  <a:pt x="19" y="0"/>
                </a:moveTo>
                <a:lnTo>
                  <a:pt x="38" y="33"/>
                </a:lnTo>
                <a:lnTo>
                  <a:pt x="0" y="33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130" name="Rectangle 73"/>
          <p:cNvSpPr>
            <a:spLocks noChangeArrowheads="1"/>
          </p:cNvSpPr>
          <p:nvPr/>
        </p:nvSpPr>
        <p:spPr bwMode="auto">
          <a:xfrm>
            <a:off x="1616075" y="3950107"/>
            <a:ext cx="50257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0 µM </a:t>
            </a:r>
            <a:endParaRPr kumimoji="0" 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Oval 74"/>
          <p:cNvSpPr>
            <a:spLocks noChangeArrowheads="1"/>
          </p:cNvSpPr>
          <p:nvPr/>
        </p:nvSpPr>
        <p:spPr bwMode="auto">
          <a:xfrm>
            <a:off x="1372393" y="4028460"/>
            <a:ext cx="58738" cy="58738"/>
          </a:xfrm>
          <a:prstGeom prst="ellipse">
            <a:avLst/>
          </a:prstGeom>
          <a:solidFill>
            <a:srgbClr val="FFFFFF"/>
          </a:solidFill>
          <a:ln w="6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73" name="Rectangle 72"/>
          <p:cNvSpPr/>
          <p:nvPr/>
        </p:nvSpPr>
        <p:spPr>
          <a:xfrm>
            <a:off x="323528" y="378529"/>
            <a:ext cx="8640960" cy="17543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/>
              <a:t>Supplementary</a:t>
            </a:r>
            <a:r>
              <a:rPr lang="fr-FR" b="1" dirty="0"/>
              <a:t> Figure </a:t>
            </a:r>
            <a:r>
              <a:rPr lang="fr-FR" b="1" dirty="0" smtClean="0"/>
              <a:t>1B. </a:t>
            </a:r>
            <a:r>
              <a:rPr lang="en-US" dirty="0" smtClean="0"/>
              <a:t>Double </a:t>
            </a:r>
            <a:r>
              <a:rPr lang="en-US" dirty="0"/>
              <a:t>reciprocal plot of the initial reaction velocities measured at different concentrations of </a:t>
            </a:r>
            <a:r>
              <a:rPr lang="en-US" dirty="0" smtClean="0"/>
              <a:t>GTP </a:t>
            </a:r>
            <a:r>
              <a:rPr lang="en-US" dirty="0"/>
              <a:t>in the presence of 0, 5, 10, 20 and 30 µM of </a:t>
            </a:r>
            <a:r>
              <a:rPr lang="en-US" dirty="0" err="1"/>
              <a:t>quercetagetin</a:t>
            </a:r>
            <a:r>
              <a:rPr lang="en-US" dirty="0"/>
              <a:t> and a fixed concentration of </a:t>
            </a:r>
            <a:r>
              <a:rPr lang="en-US" dirty="0" smtClean="0"/>
              <a:t>poly(C) RNA template. </a:t>
            </a:r>
            <a:r>
              <a:rPr lang="en-US" dirty="0"/>
              <a:t>Crossing of the lines with the X-axis indicates non-competitive inhibition. The graphical </a:t>
            </a:r>
            <a:r>
              <a:rPr lang="en-US" dirty="0" smtClean="0"/>
              <a:t>representation shows one </a:t>
            </a:r>
            <a:r>
              <a:rPr lang="en-US" dirty="0"/>
              <a:t>experiment performed in quadruplicate. The data are presented as </a:t>
            </a:r>
            <a:r>
              <a:rPr lang="en-US" dirty="0" err="1"/>
              <a:t>mean±SD</a:t>
            </a:r>
            <a:r>
              <a:rPr lang="en-US" dirty="0"/>
              <a:t>.</a:t>
            </a:r>
            <a:r>
              <a:rPr lang="fr-FR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8322333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5"/>
          <p:cNvGrpSpPr>
            <a:grpSpLocks noChangeAspect="1"/>
          </p:cNvGrpSpPr>
          <p:nvPr/>
        </p:nvGrpSpPr>
        <p:grpSpPr bwMode="auto">
          <a:xfrm>
            <a:off x="1790701" y="1906041"/>
            <a:ext cx="5562600" cy="4259263"/>
            <a:chOff x="1128" y="820"/>
            <a:chExt cx="3504" cy="2683"/>
          </a:xfrm>
        </p:grpSpPr>
        <p:sp>
          <p:nvSpPr>
            <p:cNvPr id="6" name="AutoShape 4"/>
            <p:cNvSpPr>
              <a:spLocks noChangeAspect="1" noChangeArrowheads="1" noTextEdit="1"/>
            </p:cNvSpPr>
            <p:nvPr/>
          </p:nvSpPr>
          <p:spPr bwMode="auto">
            <a:xfrm>
              <a:off x="1128" y="820"/>
              <a:ext cx="3504" cy="26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" name="Rectangle 6"/>
            <p:cNvSpPr>
              <a:spLocks noChangeArrowheads="1"/>
            </p:cNvSpPr>
            <p:nvPr/>
          </p:nvSpPr>
          <p:spPr bwMode="auto">
            <a:xfrm>
              <a:off x="1128" y="820"/>
              <a:ext cx="3504" cy="268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Rectangle 7"/>
            <p:cNvSpPr>
              <a:spLocks noChangeArrowheads="1"/>
            </p:cNvSpPr>
            <p:nvPr/>
          </p:nvSpPr>
          <p:spPr bwMode="auto">
            <a:xfrm>
              <a:off x="1622" y="1131"/>
              <a:ext cx="2842" cy="2041"/>
            </a:xfrm>
            <a:prstGeom prst="rect">
              <a:avLst/>
            </a:prstGeom>
            <a:solidFill>
              <a:srgbClr val="FFFFFF"/>
            </a:solidFill>
            <a:ln w="1588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Rectangle 8"/>
            <p:cNvSpPr>
              <a:spLocks noChangeArrowheads="1"/>
            </p:cNvSpPr>
            <p:nvPr/>
          </p:nvSpPr>
          <p:spPr bwMode="auto">
            <a:xfrm>
              <a:off x="2739" y="3371"/>
              <a:ext cx="123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oly A concentration  (µg/ml)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Line 9"/>
            <p:cNvSpPr>
              <a:spLocks noChangeShapeType="1"/>
            </p:cNvSpPr>
            <p:nvPr/>
          </p:nvSpPr>
          <p:spPr bwMode="auto">
            <a:xfrm>
              <a:off x="1622" y="3172"/>
              <a:ext cx="2842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Rectangle 10"/>
            <p:cNvSpPr>
              <a:spLocks noChangeArrowheads="1"/>
            </p:cNvSpPr>
            <p:nvPr/>
          </p:nvSpPr>
          <p:spPr bwMode="auto">
            <a:xfrm>
              <a:off x="1988" y="3210"/>
              <a:ext cx="71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Rectangle 11"/>
            <p:cNvSpPr>
              <a:spLocks noChangeArrowheads="1"/>
            </p:cNvSpPr>
            <p:nvPr/>
          </p:nvSpPr>
          <p:spPr bwMode="auto">
            <a:xfrm>
              <a:off x="2504" y="3210"/>
              <a:ext cx="71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Rectangle 12"/>
            <p:cNvSpPr>
              <a:spLocks noChangeArrowheads="1"/>
            </p:cNvSpPr>
            <p:nvPr/>
          </p:nvSpPr>
          <p:spPr bwMode="auto">
            <a:xfrm>
              <a:off x="3021" y="3210"/>
              <a:ext cx="71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Rectangle 13"/>
            <p:cNvSpPr>
              <a:spLocks noChangeArrowheads="1"/>
            </p:cNvSpPr>
            <p:nvPr/>
          </p:nvSpPr>
          <p:spPr bwMode="auto">
            <a:xfrm>
              <a:off x="3538" y="3210"/>
              <a:ext cx="71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Rectangle 14"/>
            <p:cNvSpPr>
              <a:spLocks noChangeArrowheads="1"/>
            </p:cNvSpPr>
            <p:nvPr/>
          </p:nvSpPr>
          <p:spPr bwMode="auto">
            <a:xfrm>
              <a:off x="4054" y="3210"/>
              <a:ext cx="71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16"/>
            <p:cNvSpPr>
              <a:spLocks noChangeArrowheads="1"/>
            </p:cNvSpPr>
            <p:nvPr/>
          </p:nvSpPr>
          <p:spPr bwMode="auto">
            <a:xfrm rot="16200000">
              <a:off x="829" y="2184"/>
              <a:ext cx="758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luorescence (AU)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Line 17"/>
            <p:cNvSpPr>
              <a:spLocks noChangeShapeType="1"/>
            </p:cNvSpPr>
            <p:nvPr/>
          </p:nvSpPr>
          <p:spPr bwMode="auto">
            <a:xfrm flipV="1">
              <a:off x="1622" y="1131"/>
              <a:ext cx="0" cy="204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Line 18"/>
            <p:cNvSpPr>
              <a:spLocks noChangeShapeType="1"/>
            </p:cNvSpPr>
            <p:nvPr/>
          </p:nvSpPr>
          <p:spPr bwMode="auto">
            <a:xfrm>
              <a:off x="1593" y="3172"/>
              <a:ext cx="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Line 19"/>
            <p:cNvSpPr>
              <a:spLocks noChangeShapeType="1"/>
            </p:cNvSpPr>
            <p:nvPr/>
          </p:nvSpPr>
          <p:spPr bwMode="auto">
            <a:xfrm>
              <a:off x="1593" y="2967"/>
              <a:ext cx="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Line 20"/>
            <p:cNvSpPr>
              <a:spLocks noChangeShapeType="1"/>
            </p:cNvSpPr>
            <p:nvPr/>
          </p:nvSpPr>
          <p:spPr bwMode="auto">
            <a:xfrm>
              <a:off x="1593" y="2763"/>
              <a:ext cx="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Line 21"/>
            <p:cNvSpPr>
              <a:spLocks noChangeShapeType="1"/>
            </p:cNvSpPr>
            <p:nvPr/>
          </p:nvSpPr>
          <p:spPr bwMode="auto">
            <a:xfrm>
              <a:off x="1593" y="2560"/>
              <a:ext cx="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Line 22"/>
            <p:cNvSpPr>
              <a:spLocks noChangeShapeType="1"/>
            </p:cNvSpPr>
            <p:nvPr/>
          </p:nvSpPr>
          <p:spPr bwMode="auto">
            <a:xfrm>
              <a:off x="1593" y="2355"/>
              <a:ext cx="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Line 23"/>
            <p:cNvSpPr>
              <a:spLocks noChangeShapeType="1"/>
            </p:cNvSpPr>
            <p:nvPr/>
          </p:nvSpPr>
          <p:spPr bwMode="auto">
            <a:xfrm>
              <a:off x="1593" y="2151"/>
              <a:ext cx="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Line 24"/>
            <p:cNvSpPr>
              <a:spLocks noChangeShapeType="1"/>
            </p:cNvSpPr>
            <p:nvPr/>
          </p:nvSpPr>
          <p:spPr bwMode="auto">
            <a:xfrm>
              <a:off x="1593" y="1947"/>
              <a:ext cx="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Line 25"/>
            <p:cNvSpPr>
              <a:spLocks noChangeShapeType="1"/>
            </p:cNvSpPr>
            <p:nvPr/>
          </p:nvSpPr>
          <p:spPr bwMode="auto">
            <a:xfrm>
              <a:off x="1593" y="1743"/>
              <a:ext cx="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Line 26"/>
            <p:cNvSpPr>
              <a:spLocks noChangeShapeType="1"/>
            </p:cNvSpPr>
            <p:nvPr/>
          </p:nvSpPr>
          <p:spPr bwMode="auto">
            <a:xfrm>
              <a:off x="1593" y="1539"/>
              <a:ext cx="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Line 27"/>
            <p:cNvSpPr>
              <a:spLocks noChangeShapeType="1"/>
            </p:cNvSpPr>
            <p:nvPr/>
          </p:nvSpPr>
          <p:spPr bwMode="auto">
            <a:xfrm>
              <a:off x="1593" y="1335"/>
              <a:ext cx="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Line 28"/>
            <p:cNvSpPr>
              <a:spLocks noChangeShapeType="1"/>
            </p:cNvSpPr>
            <p:nvPr/>
          </p:nvSpPr>
          <p:spPr bwMode="auto">
            <a:xfrm>
              <a:off x="1593" y="1131"/>
              <a:ext cx="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Rectangle 29"/>
            <p:cNvSpPr>
              <a:spLocks noChangeArrowheads="1"/>
            </p:cNvSpPr>
            <p:nvPr/>
          </p:nvSpPr>
          <p:spPr bwMode="auto">
            <a:xfrm>
              <a:off x="1509" y="3126"/>
              <a:ext cx="71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ectangle 30"/>
            <p:cNvSpPr>
              <a:spLocks noChangeArrowheads="1"/>
            </p:cNvSpPr>
            <p:nvPr/>
          </p:nvSpPr>
          <p:spPr bwMode="auto">
            <a:xfrm>
              <a:off x="1376" y="2922"/>
              <a:ext cx="192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4" name="Rectangle 31"/>
            <p:cNvSpPr>
              <a:spLocks noChangeArrowheads="1"/>
            </p:cNvSpPr>
            <p:nvPr/>
          </p:nvSpPr>
          <p:spPr bwMode="auto">
            <a:xfrm>
              <a:off x="1376" y="2718"/>
              <a:ext cx="192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5" name="Rectangle 32"/>
            <p:cNvSpPr>
              <a:spLocks noChangeArrowheads="1"/>
            </p:cNvSpPr>
            <p:nvPr/>
          </p:nvSpPr>
          <p:spPr bwMode="auto">
            <a:xfrm>
              <a:off x="1376" y="2514"/>
              <a:ext cx="192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7" name="Rectangle 33"/>
            <p:cNvSpPr>
              <a:spLocks noChangeArrowheads="1"/>
            </p:cNvSpPr>
            <p:nvPr/>
          </p:nvSpPr>
          <p:spPr bwMode="auto">
            <a:xfrm>
              <a:off x="1376" y="2310"/>
              <a:ext cx="192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0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8" name="Rectangle 34"/>
            <p:cNvSpPr>
              <a:spLocks noChangeArrowheads="1"/>
            </p:cNvSpPr>
            <p:nvPr/>
          </p:nvSpPr>
          <p:spPr bwMode="auto">
            <a:xfrm>
              <a:off x="1331" y="2106"/>
              <a:ext cx="231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0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9" name="Rectangle 35"/>
            <p:cNvSpPr>
              <a:spLocks noChangeArrowheads="1"/>
            </p:cNvSpPr>
            <p:nvPr/>
          </p:nvSpPr>
          <p:spPr bwMode="auto">
            <a:xfrm>
              <a:off x="1331" y="1902"/>
              <a:ext cx="231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0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0" name="Rectangle 36"/>
            <p:cNvSpPr>
              <a:spLocks noChangeArrowheads="1"/>
            </p:cNvSpPr>
            <p:nvPr/>
          </p:nvSpPr>
          <p:spPr bwMode="auto">
            <a:xfrm>
              <a:off x="1331" y="1697"/>
              <a:ext cx="231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40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1" name="Rectangle 37"/>
            <p:cNvSpPr>
              <a:spLocks noChangeArrowheads="1"/>
            </p:cNvSpPr>
            <p:nvPr/>
          </p:nvSpPr>
          <p:spPr bwMode="auto">
            <a:xfrm>
              <a:off x="1331" y="1493"/>
              <a:ext cx="231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60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2" name="Rectangle 38"/>
            <p:cNvSpPr>
              <a:spLocks noChangeArrowheads="1"/>
            </p:cNvSpPr>
            <p:nvPr/>
          </p:nvSpPr>
          <p:spPr bwMode="auto">
            <a:xfrm>
              <a:off x="1331" y="1289"/>
              <a:ext cx="231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80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3" name="Rectangle 39"/>
            <p:cNvSpPr>
              <a:spLocks noChangeArrowheads="1"/>
            </p:cNvSpPr>
            <p:nvPr/>
          </p:nvSpPr>
          <p:spPr bwMode="auto">
            <a:xfrm>
              <a:off x="1331" y="1085"/>
              <a:ext cx="231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5" name="Rectangle 41"/>
            <p:cNvSpPr>
              <a:spLocks noChangeArrowheads="1"/>
            </p:cNvSpPr>
            <p:nvPr/>
          </p:nvSpPr>
          <p:spPr bwMode="auto">
            <a:xfrm>
              <a:off x="1752" y="3104"/>
              <a:ext cx="127" cy="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6" name="Freeform 42"/>
            <p:cNvSpPr>
              <a:spLocks/>
            </p:cNvSpPr>
            <p:nvPr/>
          </p:nvSpPr>
          <p:spPr bwMode="auto">
            <a:xfrm flipV="1">
              <a:off x="1752" y="3104"/>
              <a:ext cx="127" cy="63"/>
            </a:xfrm>
            <a:custGeom>
              <a:avLst/>
              <a:gdLst>
                <a:gd name="T0" fmla="*/ 220 w 220"/>
                <a:gd name="T1" fmla="*/ 0 h 109"/>
                <a:gd name="T2" fmla="*/ 220 w 220"/>
                <a:gd name="T3" fmla="*/ 109 h 109"/>
                <a:gd name="T4" fmla="*/ 0 w 220"/>
                <a:gd name="T5" fmla="*/ 109 h 109"/>
                <a:gd name="T6" fmla="*/ 0 w 220"/>
                <a:gd name="T7" fmla="*/ 0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109">
                  <a:moveTo>
                    <a:pt x="220" y="0"/>
                  </a:moveTo>
                  <a:lnTo>
                    <a:pt x="220" y="109"/>
                  </a:lnTo>
                  <a:lnTo>
                    <a:pt x="0" y="109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7" name="Rectangle 43"/>
            <p:cNvSpPr>
              <a:spLocks noChangeArrowheads="1"/>
            </p:cNvSpPr>
            <p:nvPr/>
          </p:nvSpPr>
          <p:spPr bwMode="auto">
            <a:xfrm>
              <a:off x="2269" y="2974"/>
              <a:ext cx="127" cy="19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8" name="Freeform 44"/>
            <p:cNvSpPr>
              <a:spLocks/>
            </p:cNvSpPr>
            <p:nvPr/>
          </p:nvSpPr>
          <p:spPr bwMode="auto">
            <a:xfrm flipV="1">
              <a:off x="2269" y="2974"/>
              <a:ext cx="127" cy="193"/>
            </a:xfrm>
            <a:custGeom>
              <a:avLst/>
              <a:gdLst>
                <a:gd name="T0" fmla="*/ 220 w 220"/>
                <a:gd name="T1" fmla="*/ 0 h 334"/>
                <a:gd name="T2" fmla="*/ 220 w 220"/>
                <a:gd name="T3" fmla="*/ 334 h 334"/>
                <a:gd name="T4" fmla="*/ 0 w 220"/>
                <a:gd name="T5" fmla="*/ 334 h 334"/>
                <a:gd name="T6" fmla="*/ 0 w 220"/>
                <a:gd name="T7" fmla="*/ 0 h 3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334">
                  <a:moveTo>
                    <a:pt x="220" y="0"/>
                  </a:moveTo>
                  <a:lnTo>
                    <a:pt x="220" y="334"/>
                  </a:lnTo>
                  <a:lnTo>
                    <a:pt x="0" y="334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9" name="Rectangle 45"/>
            <p:cNvSpPr>
              <a:spLocks noChangeArrowheads="1"/>
            </p:cNvSpPr>
            <p:nvPr/>
          </p:nvSpPr>
          <p:spPr bwMode="auto">
            <a:xfrm>
              <a:off x="2786" y="2337"/>
              <a:ext cx="126" cy="83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0" name="Freeform 46"/>
            <p:cNvSpPr>
              <a:spLocks/>
            </p:cNvSpPr>
            <p:nvPr/>
          </p:nvSpPr>
          <p:spPr bwMode="auto">
            <a:xfrm flipV="1">
              <a:off x="2786" y="2337"/>
              <a:ext cx="126" cy="830"/>
            </a:xfrm>
            <a:custGeom>
              <a:avLst/>
              <a:gdLst>
                <a:gd name="T0" fmla="*/ 219 w 219"/>
                <a:gd name="T1" fmla="*/ 0 h 1440"/>
                <a:gd name="T2" fmla="*/ 219 w 219"/>
                <a:gd name="T3" fmla="*/ 1440 h 1440"/>
                <a:gd name="T4" fmla="*/ 0 w 219"/>
                <a:gd name="T5" fmla="*/ 1440 h 1440"/>
                <a:gd name="T6" fmla="*/ 0 w 219"/>
                <a:gd name="T7" fmla="*/ 0 h 14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9" h="1440">
                  <a:moveTo>
                    <a:pt x="219" y="0"/>
                  </a:moveTo>
                  <a:lnTo>
                    <a:pt x="219" y="1440"/>
                  </a:lnTo>
                  <a:lnTo>
                    <a:pt x="0" y="1440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1" name="Rectangle 47"/>
            <p:cNvSpPr>
              <a:spLocks noChangeArrowheads="1"/>
            </p:cNvSpPr>
            <p:nvPr/>
          </p:nvSpPr>
          <p:spPr bwMode="auto">
            <a:xfrm>
              <a:off x="3302" y="1714"/>
              <a:ext cx="127" cy="145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2" name="Freeform 48"/>
            <p:cNvSpPr>
              <a:spLocks/>
            </p:cNvSpPr>
            <p:nvPr/>
          </p:nvSpPr>
          <p:spPr bwMode="auto">
            <a:xfrm flipV="1">
              <a:off x="3302" y="1714"/>
              <a:ext cx="127" cy="1453"/>
            </a:xfrm>
            <a:custGeom>
              <a:avLst/>
              <a:gdLst>
                <a:gd name="T0" fmla="*/ 220 w 220"/>
                <a:gd name="T1" fmla="*/ 0 h 2521"/>
                <a:gd name="T2" fmla="*/ 220 w 220"/>
                <a:gd name="T3" fmla="*/ 2521 h 2521"/>
                <a:gd name="T4" fmla="*/ 0 w 220"/>
                <a:gd name="T5" fmla="*/ 2521 h 2521"/>
                <a:gd name="T6" fmla="*/ 0 w 220"/>
                <a:gd name="T7" fmla="*/ 0 h 25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2521">
                  <a:moveTo>
                    <a:pt x="220" y="0"/>
                  </a:moveTo>
                  <a:lnTo>
                    <a:pt x="220" y="2521"/>
                  </a:lnTo>
                  <a:lnTo>
                    <a:pt x="0" y="2521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3" name="Rectangle 49"/>
            <p:cNvSpPr>
              <a:spLocks noChangeArrowheads="1"/>
            </p:cNvSpPr>
            <p:nvPr/>
          </p:nvSpPr>
          <p:spPr bwMode="auto">
            <a:xfrm>
              <a:off x="3819" y="1407"/>
              <a:ext cx="127" cy="176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4" name="Freeform 50"/>
            <p:cNvSpPr>
              <a:spLocks/>
            </p:cNvSpPr>
            <p:nvPr/>
          </p:nvSpPr>
          <p:spPr bwMode="auto">
            <a:xfrm flipV="1">
              <a:off x="3819" y="1407"/>
              <a:ext cx="127" cy="1760"/>
            </a:xfrm>
            <a:custGeom>
              <a:avLst/>
              <a:gdLst>
                <a:gd name="T0" fmla="*/ 220 w 220"/>
                <a:gd name="T1" fmla="*/ 0 h 3054"/>
                <a:gd name="T2" fmla="*/ 220 w 220"/>
                <a:gd name="T3" fmla="*/ 3054 h 3054"/>
                <a:gd name="T4" fmla="*/ 0 w 220"/>
                <a:gd name="T5" fmla="*/ 3054 h 3054"/>
                <a:gd name="T6" fmla="*/ 0 w 220"/>
                <a:gd name="T7" fmla="*/ 0 h 30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3054">
                  <a:moveTo>
                    <a:pt x="220" y="0"/>
                  </a:moveTo>
                  <a:lnTo>
                    <a:pt x="220" y="3054"/>
                  </a:lnTo>
                  <a:lnTo>
                    <a:pt x="0" y="3054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5" name="Rectangle 51"/>
            <p:cNvSpPr>
              <a:spLocks noChangeArrowheads="1"/>
            </p:cNvSpPr>
            <p:nvPr/>
          </p:nvSpPr>
          <p:spPr bwMode="auto">
            <a:xfrm>
              <a:off x="1882" y="3034"/>
              <a:ext cx="127" cy="133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6" name="Freeform 52"/>
            <p:cNvSpPr>
              <a:spLocks/>
            </p:cNvSpPr>
            <p:nvPr/>
          </p:nvSpPr>
          <p:spPr bwMode="auto">
            <a:xfrm flipV="1">
              <a:off x="1882" y="3034"/>
              <a:ext cx="127" cy="133"/>
            </a:xfrm>
            <a:custGeom>
              <a:avLst/>
              <a:gdLst>
                <a:gd name="T0" fmla="*/ 220 w 220"/>
                <a:gd name="T1" fmla="*/ 0 h 231"/>
                <a:gd name="T2" fmla="*/ 220 w 220"/>
                <a:gd name="T3" fmla="*/ 231 h 231"/>
                <a:gd name="T4" fmla="*/ 0 w 220"/>
                <a:gd name="T5" fmla="*/ 231 h 231"/>
                <a:gd name="T6" fmla="*/ 0 w 220"/>
                <a:gd name="T7" fmla="*/ 0 h 2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231">
                  <a:moveTo>
                    <a:pt x="220" y="0"/>
                  </a:moveTo>
                  <a:lnTo>
                    <a:pt x="220" y="231"/>
                  </a:lnTo>
                  <a:lnTo>
                    <a:pt x="0" y="231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7" name="Rectangle 53"/>
            <p:cNvSpPr>
              <a:spLocks noChangeArrowheads="1"/>
            </p:cNvSpPr>
            <p:nvPr/>
          </p:nvSpPr>
          <p:spPr bwMode="auto">
            <a:xfrm>
              <a:off x="2398" y="2792"/>
              <a:ext cx="127" cy="375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8" name="Freeform 54"/>
            <p:cNvSpPr>
              <a:spLocks/>
            </p:cNvSpPr>
            <p:nvPr/>
          </p:nvSpPr>
          <p:spPr bwMode="auto">
            <a:xfrm flipV="1">
              <a:off x="2398" y="2792"/>
              <a:ext cx="127" cy="375"/>
            </a:xfrm>
            <a:custGeom>
              <a:avLst/>
              <a:gdLst>
                <a:gd name="T0" fmla="*/ 220 w 220"/>
                <a:gd name="T1" fmla="*/ 0 h 651"/>
                <a:gd name="T2" fmla="*/ 220 w 220"/>
                <a:gd name="T3" fmla="*/ 651 h 651"/>
                <a:gd name="T4" fmla="*/ 0 w 220"/>
                <a:gd name="T5" fmla="*/ 651 h 651"/>
                <a:gd name="T6" fmla="*/ 0 w 220"/>
                <a:gd name="T7" fmla="*/ 0 h 6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651">
                  <a:moveTo>
                    <a:pt x="220" y="0"/>
                  </a:moveTo>
                  <a:lnTo>
                    <a:pt x="220" y="651"/>
                  </a:lnTo>
                  <a:lnTo>
                    <a:pt x="0" y="651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9" name="Rectangle 55"/>
            <p:cNvSpPr>
              <a:spLocks noChangeArrowheads="1"/>
            </p:cNvSpPr>
            <p:nvPr/>
          </p:nvSpPr>
          <p:spPr bwMode="auto">
            <a:xfrm>
              <a:off x="2915" y="2179"/>
              <a:ext cx="127" cy="988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0" name="Freeform 56"/>
            <p:cNvSpPr>
              <a:spLocks/>
            </p:cNvSpPr>
            <p:nvPr/>
          </p:nvSpPr>
          <p:spPr bwMode="auto">
            <a:xfrm flipV="1">
              <a:off x="2915" y="2179"/>
              <a:ext cx="127" cy="988"/>
            </a:xfrm>
            <a:custGeom>
              <a:avLst/>
              <a:gdLst>
                <a:gd name="T0" fmla="*/ 220 w 220"/>
                <a:gd name="T1" fmla="*/ 0 h 1714"/>
                <a:gd name="T2" fmla="*/ 220 w 220"/>
                <a:gd name="T3" fmla="*/ 1714 h 1714"/>
                <a:gd name="T4" fmla="*/ 0 w 220"/>
                <a:gd name="T5" fmla="*/ 1714 h 1714"/>
                <a:gd name="T6" fmla="*/ 0 w 220"/>
                <a:gd name="T7" fmla="*/ 0 h 17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1714">
                  <a:moveTo>
                    <a:pt x="220" y="0"/>
                  </a:moveTo>
                  <a:lnTo>
                    <a:pt x="220" y="1714"/>
                  </a:lnTo>
                  <a:lnTo>
                    <a:pt x="0" y="1714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1" name="Rectangle 57"/>
            <p:cNvSpPr>
              <a:spLocks noChangeArrowheads="1"/>
            </p:cNvSpPr>
            <p:nvPr/>
          </p:nvSpPr>
          <p:spPr bwMode="auto">
            <a:xfrm>
              <a:off x="3432" y="1636"/>
              <a:ext cx="127" cy="1531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2" name="Freeform 58"/>
            <p:cNvSpPr>
              <a:spLocks/>
            </p:cNvSpPr>
            <p:nvPr/>
          </p:nvSpPr>
          <p:spPr bwMode="auto">
            <a:xfrm flipV="1">
              <a:off x="3432" y="1636"/>
              <a:ext cx="127" cy="1531"/>
            </a:xfrm>
            <a:custGeom>
              <a:avLst/>
              <a:gdLst>
                <a:gd name="T0" fmla="*/ 220 w 220"/>
                <a:gd name="T1" fmla="*/ 0 h 2658"/>
                <a:gd name="T2" fmla="*/ 220 w 220"/>
                <a:gd name="T3" fmla="*/ 2658 h 2658"/>
                <a:gd name="T4" fmla="*/ 0 w 220"/>
                <a:gd name="T5" fmla="*/ 2658 h 2658"/>
                <a:gd name="T6" fmla="*/ 0 w 220"/>
                <a:gd name="T7" fmla="*/ 0 h 26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2658">
                  <a:moveTo>
                    <a:pt x="220" y="0"/>
                  </a:moveTo>
                  <a:lnTo>
                    <a:pt x="220" y="2658"/>
                  </a:lnTo>
                  <a:lnTo>
                    <a:pt x="0" y="2658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3" name="Rectangle 59"/>
            <p:cNvSpPr>
              <a:spLocks noChangeArrowheads="1"/>
            </p:cNvSpPr>
            <p:nvPr/>
          </p:nvSpPr>
          <p:spPr bwMode="auto">
            <a:xfrm>
              <a:off x="3948" y="1495"/>
              <a:ext cx="127" cy="1672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4" name="Freeform 60"/>
            <p:cNvSpPr>
              <a:spLocks/>
            </p:cNvSpPr>
            <p:nvPr/>
          </p:nvSpPr>
          <p:spPr bwMode="auto">
            <a:xfrm flipV="1">
              <a:off x="3948" y="1495"/>
              <a:ext cx="127" cy="1672"/>
            </a:xfrm>
            <a:custGeom>
              <a:avLst/>
              <a:gdLst>
                <a:gd name="T0" fmla="*/ 220 w 220"/>
                <a:gd name="T1" fmla="*/ 0 h 2902"/>
                <a:gd name="T2" fmla="*/ 220 w 220"/>
                <a:gd name="T3" fmla="*/ 2902 h 2902"/>
                <a:gd name="T4" fmla="*/ 0 w 220"/>
                <a:gd name="T5" fmla="*/ 2902 h 2902"/>
                <a:gd name="T6" fmla="*/ 0 w 220"/>
                <a:gd name="T7" fmla="*/ 0 h 29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2902">
                  <a:moveTo>
                    <a:pt x="220" y="0"/>
                  </a:moveTo>
                  <a:lnTo>
                    <a:pt x="220" y="2902"/>
                  </a:lnTo>
                  <a:lnTo>
                    <a:pt x="0" y="2902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5" name="Rectangle 61"/>
            <p:cNvSpPr>
              <a:spLocks noChangeArrowheads="1"/>
            </p:cNvSpPr>
            <p:nvPr/>
          </p:nvSpPr>
          <p:spPr bwMode="auto">
            <a:xfrm>
              <a:off x="2010" y="3103"/>
              <a:ext cx="127" cy="64"/>
            </a:xfrm>
            <a:prstGeom prst="rect">
              <a:avLst/>
            </a:prstGeom>
            <a:solidFill>
              <a:srgbClr val="60606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6" name="Freeform 62"/>
            <p:cNvSpPr>
              <a:spLocks/>
            </p:cNvSpPr>
            <p:nvPr/>
          </p:nvSpPr>
          <p:spPr bwMode="auto">
            <a:xfrm flipV="1">
              <a:off x="2010" y="3103"/>
              <a:ext cx="127" cy="64"/>
            </a:xfrm>
            <a:custGeom>
              <a:avLst/>
              <a:gdLst>
                <a:gd name="T0" fmla="*/ 220 w 220"/>
                <a:gd name="T1" fmla="*/ 0 h 111"/>
                <a:gd name="T2" fmla="*/ 220 w 220"/>
                <a:gd name="T3" fmla="*/ 111 h 111"/>
                <a:gd name="T4" fmla="*/ 0 w 220"/>
                <a:gd name="T5" fmla="*/ 111 h 111"/>
                <a:gd name="T6" fmla="*/ 0 w 220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111">
                  <a:moveTo>
                    <a:pt x="220" y="0"/>
                  </a:moveTo>
                  <a:lnTo>
                    <a:pt x="220" y="111"/>
                  </a:lnTo>
                  <a:lnTo>
                    <a:pt x="0" y="111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7" name="Rectangle 63"/>
            <p:cNvSpPr>
              <a:spLocks noChangeArrowheads="1"/>
            </p:cNvSpPr>
            <p:nvPr/>
          </p:nvSpPr>
          <p:spPr bwMode="auto">
            <a:xfrm>
              <a:off x="2527" y="3106"/>
              <a:ext cx="127" cy="61"/>
            </a:xfrm>
            <a:prstGeom prst="rect">
              <a:avLst/>
            </a:prstGeom>
            <a:solidFill>
              <a:srgbClr val="60606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8" name="Freeform 64"/>
            <p:cNvSpPr>
              <a:spLocks/>
            </p:cNvSpPr>
            <p:nvPr/>
          </p:nvSpPr>
          <p:spPr bwMode="auto">
            <a:xfrm flipV="1">
              <a:off x="2527" y="3106"/>
              <a:ext cx="127" cy="61"/>
            </a:xfrm>
            <a:custGeom>
              <a:avLst/>
              <a:gdLst>
                <a:gd name="T0" fmla="*/ 220 w 220"/>
                <a:gd name="T1" fmla="*/ 0 h 106"/>
                <a:gd name="T2" fmla="*/ 220 w 220"/>
                <a:gd name="T3" fmla="*/ 106 h 106"/>
                <a:gd name="T4" fmla="*/ 0 w 220"/>
                <a:gd name="T5" fmla="*/ 106 h 106"/>
                <a:gd name="T6" fmla="*/ 0 w 220"/>
                <a:gd name="T7" fmla="*/ 0 h 1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106">
                  <a:moveTo>
                    <a:pt x="220" y="0"/>
                  </a:moveTo>
                  <a:lnTo>
                    <a:pt x="220" y="106"/>
                  </a:lnTo>
                  <a:lnTo>
                    <a:pt x="0" y="106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9" name="Rectangle 65"/>
            <p:cNvSpPr>
              <a:spLocks noChangeArrowheads="1"/>
            </p:cNvSpPr>
            <p:nvPr/>
          </p:nvSpPr>
          <p:spPr bwMode="auto">
            <a:xfrm>
              <a:off x="3044" y="3101"/>
              <a:ext cx="127" cy="66"/>
            </a:xfrm>
            <a:prstGeom prst="rect">
              <a:avLst/>
            </a:prstGeom>
            <a:solidFill>
              <a:srgbClr val="60606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0" name="Freeform 66"/>
            <p:cNvSpPr>
              <a:spLocks/>
            </p:cNvSpPr>
            <p:nvPr/>
          </p:nvSpPr>
          <p:spPr bwMode="auto">
            <a:xfrm flipV="1">
              <a:off x="3044" y="3101"/>
              <a:ext cx="127" cy="66"/>
            </a:xfrm>
            <a:custGeom>
              <a:avLst/>
              <a:gdLst>
                <a:gd name="T0" fmla="*/ 220 w 220"/>
                <a:gd name="T1" fmla="*/ 0 h 114"/>
                <a:gd name="T2" fmla="*/ 220 w 220"/>
                <a:gd name="T3" fmla="*/ 114 h 114"/>
                <a:gd name="T4" fmla="*/ 0 w 220"/>
                <a:gd name="T5" fmla="*/ 114 h 114"/>
                <a:gd name="T6" fmla="*/ 0 w 220"/>
                <a:gd name="T7" fmla="*/ 0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114">
                  <a:moveTo>
                    <a:pt x="220" y="0"/>
                  </a:moveTo>
                  <a:lnTo>
                    <a:pt x="220" y="114"/>
                  </a:lnTo>
                  <a:lnTo>
                    <a:pt x="0" y="114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1" name="Rectangle 67"/>
            <p:cNvSpPr>
              <a:spLocks noChangeArrowheads="1"/>
            </p:cNvSpPr>
            <p:nvPr/>
          </p:nvSpPr>
          <p:spPr bwMode="auto">
            <a:xfrm>
              <a:off x="3561" y="3106"/>
              <a:ext cx="127" cy="61"/>
            </a:xfrm>
            <a:prstGeom prst="rect">
              <a:avLst/>
            </a:prstGeom>
            <a:solidFill>
              <a:srgbClr val="60606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2" name="Freeform 68"/>
            <p:cNvSpPr>
              <a:spLocks/>
            </p:cNvSpPr>
            <p:nvPr/>
          </p:nvSpPr>
          <p:spPr bwMode="auto">
            <a:xfrm flipV="1">
              <a:off x="3561" y="3106"/>
              <a:ext cx="127" cy="61"/>
            </a:xfrm>
            <a:custGeom>
              <a:avLst/>
              <a:gdLst>
                <a:gd name="T0" fmla="*/ 220 w 220"/>
                <a:gd name="T1" fmla="*/ 0 h 106"/>
                <a:gd name="T2" fmla="*/ 220 w 220"/>
                <a:gd name="T3" fmla="*/ 106 h 106"/>
                <a:gd name="T4" fmla="*/ 0 w 220"/>
                <a:gd name="T5" fmla="*/ 106 h 106"/>
                <a:gd name="T6" fmla="*/ 0 w 220"/>
                <a:gd name="T7" fmla="*/ 0 h 1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106">
                  <a:moveTo>
                    <a:pt x="220" y="0"/>
                  </a:moveTo>
                  <a:lnTo>
                    <a:pt x="220" y="106"/>
                  </a:lnTo>
                  <a:lnTo>
                    <a:pt x="0" y="106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3" name="Rectangle 69"/>
            <p:cNvSpPr>
              <a:spLocks noChangeArrowheads="1"/>
            </p:cNvSpPr>
            <p:nvPr/>
          </p:nvSpPr>
          <p:spPr bwMode="auto">
            <a:xfrm>
              <a:off x="4077" y="3118"/>
              <a:ext cx="127" cy="49"/>
            </a:xfrm>
            <a:prstGeom prst="rect">
              <a:avLst/>
            </a:prstGeom>
            <a:solidFill>
              <a:srgbClr val="60606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4" name="Freeform 70"/>
            <p:cNvSpPr>
              <a:spLocks/>
            </p:cNvSpPr>
            <p:nvPr/>
          </p:nvSpPr>
          <p:spPr bwMode="auto">
            <a:xfrm flipV="1">
              <a:off x="4077" y="3118"/>
              <a:ext cx="127" cy="49"/>
            </a:xfrm>
            <a:custGeom>
              <a:avLst/>
              <a:gdLst>
                <a:gd name="T0" fmla="*/ 220 w 220"/>
                <a:gd name="T1" fmla="*/ 0 h 84"/>
                <a:gd name="T2" fmla="*/ 220 w 220"/>
                <a:gd name="T3" fmla="*/ 84 h 84"/>
                <a:gd name="T4" fmla="*/ 0 w 220"/>
                <a:gd name="T5" fmla="*/ 84 h 84"/>
                <a:gd name="T6" fmla="*/ 0 w 220"/>
                <a:gd name="T7" fmla="*/ 0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84">
                  <a:moveTo>
                    <a:pt x="220" y="0"/>
                  </a:moveTo>
                  <a:lnTo>
                    <a:pt x="220" y="84"/>
                  </a:lnTo>
                  <a:lnTo>
                    <a:pt x="0" y="84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5" name="Line 71"/>
            <p:cNvSpPr>
              <a:spLocks noChangeShapeType="1"/>
            </p:cNvSpPr>
            <p:nvPr/>
          </p:nvSpPr>
          <p:spPr bwMode="auto">
            <a:xfrm>
              <a:off x="1622" y="3172"/>
              <a:ext cx="284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7" name="Rectangle 73"/>
            <p:cNvSpPr>
              <a:spLocks noChangeArrowheads="1"/>
            </p:cNvSpPr>
            <p:nvPr/>
          </p:nvSpPr>
          <p:spPr bwMode="auto">
            <a:xfrm>
              <a:off x="1962" y="1320"/>
              <a:ext cx="256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oly U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8" name="Rectangle 74"/>
            <p:cNvSpPr>
              <a:spLocks noChangeArrowheads="1"/>
            </p:cNvSpPr>
            <p:nvPr/>
          </p:nvSpPr>
          <p:spPr bwMode="auto">
            <a:xfrm>
              <a:off x="1737" y="1337"/>
              <a:ext cx="180" cy="5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9" name="Rectangle 75"/>
            <p:cNvSpPr>
              <a:spLocks noChangeArrowheads="1"/>
            </p:cNvSpPr>
            <p:nvPr/>
          </p:nvSpPr>
          <p:spPr bwMode="auto">
            <a:xfrm>
              <a:off x="1740" y="1340"/>
              <a:ext cx="174" cy="51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0" name="Rectangle 76"/>
            <p:cNvSpPr>
              <a:spLocks noChangeArrowheads="1"/>
            </p:cNvSpPr>
            <p:nvPr/>
          </p:nvSpPr>
          <p:spPr bwMode="auto">
            <a:xfrm>
              <a:off x="1962" y="1428"/>
              <a:ext cx="11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oly U + 20 µM of </a:t>
              </a:r>
              <a:r>
                <a:rPr kumimoji="0" lang="en-US" altLang="en-US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quercetagetin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1" name="Rectangle 77"/>
            <p:cNvSpPr>
              <a:spLocks noChangeArrowheads="1"/>
            </p:cNvSpPr>
            <p:nvPr/>
          </p:nvSpPr>
          <p:spPr bwMode="auto">
            <a:xfrm>
              <a:off x="1737" y="1444"/>
              <a:ext cx="180" cy="58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2" name="Rectangle 78"/>
            <p:cNvSpPr>
              <a:spLocks noChangeArrowheads="1"/>
            </p:cNvSpPr>
            <p:nvPr/>
          </p:nvSpPr>
          <p:spPr bwMode="auto">
            <a:xfrm>
              <a:off x="1740" y="1447"/>
              <a:ext cx="174" cy="5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3" name="Rectangle 79"/>
            <p:cNvSpPr>
              <a:spLocks noChangeArrowheads="1"/>
            </p:cNvSpPr>
            <p:nvPr/>
          </p:nvSpPr>
          <p:spPr bwMode="auto">
            <a:xfrm>
              <a:off x="1962" y="1536"/>
              <a:ext cx="235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oly C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4" name="Rectangle 80"/>
            <p:cNvSpPr>
              <a:spLocks noChangeArrowheads="1"/>
            </p:cNvSpPr>
            <p:nvPr/>
          </p:nvSpPr>
          <p:spPr bwMode="auto">
            <a:xfrm>
              <a:off x="1737" y="1552"/>
              <a:ext cx="180" cy="58"/>
            </a:xfrm>
            <a:prstGeom prst="rect">
              <a:avLst/>
            </a:prstGeom>
            <a:solidFill>
              <a:srgbClr val="60606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77" name="Rectangle 76"/>
          <p:cNvSpPr/>
          <p:nvPr/>
        </p:nvSpPr>
        <p:spPr>
          <a:xfrm>
            <a:off x="323528" y="378529"/>
            <a:ext cx="864096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latin typeface="Arial"/>
                <a:cs typeface="Arial"/>
              </a:rPr>
              <a:t>Supplementary</a:t>
            </a:r>
            <a:r>
              <a:rPr lang="fr-FR" b="1" dirty="0">
                <a:latin typeface="Arial"/>
                <a:cs typeface="Arial"/>
              </a:rPr>
              <a:t> Figure </a:t>
            </a:r>
            <a:r>
              <a:rPr lang="fr-FR" b="1" dirty="0" smtClean="0">
                <a:latin typeface="Arial"/>
                <a:cs typeface="Arial"/>
              </a:rPr>
              <a:t>2</a:t>
            </a:r>
            <a:r>
              <a:rPr lang="fr-FR" b="1" dirty="0">
                <a:latin typeface="Arial"/>
                <a:cs typeface="Arial"/>
              </a:rPr>
              <a:t>.</a:t>
            </a:r>
            <a:r>
              <a:rPr lang="fr-FR" b="1" dirty="0" smtClean="0">
                <a:latin typeface="Arial"/>
                <a:cs typeface="Arial"/>
              </a:rPr>
              <a:t> </a:t>
            </a:r>
            <a:r>
              <a:rPr lang="en-US" dirty="0">
                <a:latin typeface="Arial"/>
                <a:cs typeface="Arial"/>
              </a:rPr>
              <a:t>RNA duplex fluorescence assay. P</a:t>
            </a:r>
            <a:r>
              <a:rPr lang="en-US" dirty="0" smtClean="0">
                <a:latin typeface="Arial"/>
                <a:cs typeface="Arial"/>
              </a:rPr>
              <a:t>oly(</a:t>
            </a:r>
            <a:r>
              <a:rPr lang="en-US" dirty="0">
                <a:latin typeface="Arial"/>
                <a:cs typeface="Arial"/>
              </a:rPr>
              <a:t>A</a:t>
            </a:r>
            <a:r>
              <a:rPr lang="en-US" dirty="0" smtClean="0">
                <a:latin typeface="Arial"/>
                <a:cs typeface="Arial"/>
              </a:rPr>
              <a:t>)</a:t>
            </a:r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RNA </a:t>
            </a:r>
            <a:r>
              <a:rPr lang="en-US" dirty="0">
                <a:latin typeface="Arial"/>
                <a:cs typeface="Arial"/>
              </a:rPr>
              <a:t>was mixed with the complementary </a:t>
            </a:r>
            <a:r>
              <a:rPr lang="en-US" dirty="0" smtClean="0">
                <a:latin typeface="Arial"/>
                <a:cs typeface="Arial"/>
              </a:rPr>
              <a:t>poly(</a:t>
            </a:r>
            <a:r>
              <a:rPr lang="en-US" dirty="0">
                <a:latin typeface="Arial"/>
                <a:cs typeface="Arial"/>
              </a:rPr>
              <a:t>U) RNA </a:t>
            </a:r>
            <a:r>
              <a:rPr lang="en-US" dirty="0" smtClean="0">
                <a:latin typeface="Arial"/>
                <a:cs typeface="Arial"/>
              </a:rPr>
              <a:t>in the absence </a:t>
            </a:r>
            <a:r>
              <a:rPr lang="en-US" dirty="0">
                <a:latin typeface="Arial"/>
                <a:cs typeface="Arial"/>
              </a:rPr>
              <a:t>or </a:t>
            </a:r>
            <a:r>
              <a:rPr lang="en-US" dirty="0" smtClean="0">
                <a:latin typeface="Arial"/>
                <a:cs typeface="Arial"/>
              </a:rPr>
              <a:t>presence </a:t>
            </a:r>
            <a:r>
              <a:rPr lang="en-US" dirty="0">
                <a:latin typeface="Arial"/>
                <a:cs typeface="Arial"/>
              </a:rPr>
              <a:t>of 20 µM of </a:t>
            </a:r>
            <a:r>
              <a:rPr lang="en-US" dirty="0" err="1" smtClean="0">
                <a:latin typeface="Arial"/>
                <a:cs typeface="Arial"/>
              </a:rPr>
              <a:t>quercetagetin</a:t>
            </a:r>
            <a:r>
              <a:rPr lang="en-US" dirty="0" smtClean="0">
                <a:latin typeface="Arial"/>
                <a:cs typeface="Arial"/>
              </a:rPr>
              <a:t>, </a:t>
            </a:r>
            <a:r>
              <a:rPr lang="en-US" dirty="0">
                <a:latin typeface="Arial"/>
                <a:cs typeface="Arial"/>
              </a:rPr>
              <a:t>and fluorescence of RNA duplexes </a:t>
            </a:r>
            <a:r>
              <a:rPr lang="en-US" dirty="0" smtClean="0">
                <a:latin typeface="Arial"/>
                <a:cs typeface="Arial"/>
              </a:rPr>
              <a:t>bound to </a:t>
            </a:r>
            <a:r>
              <a:rPr lang="en-US" dirty="0" err="1" smtClean="0">
                <a:latin typeface="Arial"/>
                <a:cs typeface="Arial"/>
              </a:rPr>
              <a:t>Sybr</a:t>
            </a:r>
            <a:r>
              <a:rPr lang="en-US" dirty="0" smtClean="0">
                <a:latin typeface="Arial"/>
                <a:cs typeface="Arial"/>
              </a:rPr>
              <a:t> green</a:t>
            </a:r>
            <a:r>
              <a:rPr lang="en-US" baseline="30000" dirty="0">
                <a:latin typeface="Arial"/>
                <a:cs typeface="Arial"/>
              </a:rPr>
              <a:t>®</a:t>
            </a:r>
            <a:r>
              <a:rPr lang="en-US" dirty="0" smtClean="0">
                <a:latin typeface="Arial"/>
                <a:cs typeface="Arial"/>
              </a:rPr>
              <a:t> I </a:t>
            </a:r>
            <a:r>
              <a:rPr lang="en-US" dirty="0">
                <a:latin typeface="Arial"/>
                <a:cs typeface="Arial"/>
              </a:rPr>
              <a:t>was monitored. P</a:t>
            </a:r>
            <a:r>
              <a:rPr lang="en-US" dirty="0" smtClean="0">
                <a:latin typeface="Arial"/>
                <a:cs typeface="Arial"/>
              </a:rPr>
              <a:t>oly</a:t>
            </a:r>
            <a:r>
              <a:rPr lang="en-US" dirty="0">
                <a:latin typeface="Arial"/>
                <a:cs typeface="Arial"/>
              </a:rPr>
              <a:t>(C) </a:t>
            </a:r>
            <a:r>
              <a:rPr lang="en-US" dirty="0" smtClean="0">
                <a:latin typeface="Arial"/>
                <a:cs typeface="Arial"/>
              </a:rPr>
              <a:t>RNA was </a:t>
            </a:r>
            <a:r>
              <a:rPr lang="en-US" dirty="0">
                <a:latin typeface="Arial"/>
                <a:cs typeface="Arial"/>
              </a:rPr>
              <a:t>used as </a:t>
            </a:r>
            <a:r>
              <a:rPr lang="en-US" dirty="0" smtClean="0">
                <a:latin typeface="Arial"/>
                <a:cs typeface="Arial"/>
              </a:rPr>
              <a:t>a negative </a:t>
            </a:r>
            <a:r>
              <a:rPr lang="en-US" dirty="0">
                <a:latin typeface="Arial"/>
                <a:cs typeface="Arial"/>
              </a:rPr>
              <a:t>control.</a:t>
            </a:r>
            <a:r>
              <a:rPr lang="fr-FR" dirty="0">
                <a:latin typeface="Arial"/>
                <a:cs typeface="Arial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078551592"/>
      </p:ext>
    </p:extLst>
  </p:cSld>
  <p:clrMapOvr>
    <a:masterClrMapping/>
  </p:clrMapOvr>
</p:sld>
</file>

<file path=ppt/theme/theme1.xml><?xml version="1.0" encoding="utf-8"?>
<a:theme xmlns:a="http://schemas.openxmlformats.org/drawingml/2006/main" name="Modèle par défaut">
  <a:themeElements>
    <a:clrScheme name="Modèle par défaut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Modèle par défaut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Modèle par défaut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</TotalTime>
  <Words>333</Words>
  <Application>Microsoft Macintosh PowerPoint</Application>
  <PresentationFormat>Présentation à l'écran (4:3)</PresentationFormat>
  <Paragraphs>58</Paragraphs>
  <Slides>3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4" baseType="lpstr">
      <vt:lpstr>Modèle par défaut</vt:lpstr>
      <vt:lpstr>Présentation PowerPoint</vt:lpstr>
      <vt:lpstr>Présentation PowerPoint</vt:lpstr>
      <vt:lpstr>Présentation PowerPoint</vt:lpstr>
    </vt:vector>
  </TitlesOfParts>
  <Company>INSER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bdelhakim Ahmed-belkacem</dc:creator>
  <cp:lastModifiedBy>Jean-Michel Pawlotsky</cp:lastModifiedBy>
  <cp:revision>21</cp:revision>
  <cp:lastPrinted>2013-11-15T08:46:55Z</cp:lastPrinted>
  <dcterms:created xsi:type="dcterms:W3CDTF">2013-11-11T16:34:40Z</dcterms:created>
  <dcterms:modified xsi:type="dcterms:W3CDTF">2014-06-06T18:44:45Z</dcterms:modified>
</cp:coreProperties>
</file>